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drawings/drawing6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5" autoAdjust="0"/>
    <p:restoredTop sz="94660"/>
  </p:normalViewPr>
  <p:slideViewPr>
    <p:cSldViewPr snapToGrid="0">
      <p:cViewPr varScale="1">
        <p:scale>
          <a:sx n="69" d="100"/>
          <a:sy n="69" d="100"/>
        </p:scale>
        <p:origin x="69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ilvi\OneDrive\Documenti\GREEN%20FLESH\PAPER%202019!!\PAPER%202019!!\T2%20METABOLITOS\T2_norm_minimo10(-1)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ilvi\OneDrive\Documenti\GREEN%20FLESH\PAPER%202019!!\PAPER%202019!!\T2%20METABOLITOS\T2_norm_minimo10(-1)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ilvi\OneDrive\Documenti\GREEN%20FLESH\PAPER%202019!!\PAPER%202019!!\T2%20METABOLITOS\T2_norm_minimo10(-1)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ilvi\OneDrive\Documenti\GREEN%20FLESH\PAPER%202019!!\PAPER%202019!!\T2%20METABOLITOS\T2_norm_minimo10(-1).xlsx" TargetMode="Externa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chartUserShapes" Target="../drawings/drawing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ilvi\OneDrive\Documenti\GREEN%20FLESH\PAPER%202019!!\PAPER%202019!!\T2%20METABOLITOS\T2_norm_minimo10(-1).xlsx" TargetMode="Externa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chartUserShapes" Target="../drawings/drawing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ilvi\OneDrive\Documenti\GREEN%20FLESH\PAPER%202019!!\PAPER%202019!!\T2%20METABOLITOS\T2_norm_minimo10(-1).xlsx" TargetMode="Externa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chartUserShapes" Target="../drawings/drawing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sz="3200" b="1" dirty="0"/>
              <a:t>MG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title>
    <c:autoTitleDeleted val="0"/>
    <c:plotArea>
      <c:layout>
        <c:manualLayout>
          <c:layoutTarget val="inner"/>
          <c:xMode val="edge"/>
          <c:yMode val="edge"/>
          <c:x val="4.8881806090390813E-2"/>
          <c:y val="0.17408876298394713"/>
          <c:w val="0.93580230469963299"/>
          <c:h val="0.6579583011092369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olo trasformati'!$B$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solo trasformati'!$A$3:$A$31</c:f>
              <c:strCache>
                <c:ptCount val="29"/>
                <c:pt idx="0">
                  <c:v>phytoene</c:v>
                </c:pt>
                <c:pt idx="1">
                  <c:v>phytofluene</c:v>
                </c:pt>
                <c:pt idx="2">
                  <c:v>z-carotene</c:v>
                </c:pt>
                <c:pt idx="3">
                  <c:v>lycopene</c:v>
                </c:pt>
                <c:pt idx="4">
                  <c:v>a-carotene</c:v>
                </c:pt>
                <c:pt idx="5">
                  <c:v>lutein</c:v>
                </c:pt>
                <c:pt idx="6">
                  <c:v>g-carotene</c:v>
                </c:pt>
                <c:pt idx="7">
                  <c:v>b-carotene</c:v>
                </c:pt>
                <c:pt idx="8">
                  <c:v>violaxanthin</c:v>
                </c:pt>
                <c:pt idx="9">
                  <c:v>neoxanthin</c:v>
                </c:pt>
                <c:pt idx="10">
                  <c:v>luteoxanthin</c:v>
                </c:pt>
                <c:pt idx="11">
                  <c:v>chlorophyll_a</c:v>
                </c:pt>
                <c:pt idx="12">
                  <c:v>chlorophyll_b</c:v>
                </c:pt>
                <c:pt idx="13">
                  <c:v>chlorophyllide_b</c:v>
                </c:pt>
                <c:pt idx="14">
                  <c:v>pheophorbide_a</c:v>
                </c:pt>
                <c:pt idx="15">
                  <c:v>pheophorbide_b</c:v>
                </c:pt>
                <c:pt idx="16">
                  <c:v>pheophytin_a</c:v>
                </c:pt>
                <c:pt idx="17">
                  <c:v>pheophytin_b</c:v>
                </c:pt>
                <c:pt idx="18">
                  <c:v>a-tocopherol</c:v>
                </c:pt>
                <c:pt idx="19">
                  <c:v>a-tocotrienol</c:v>
                </c:pt>
                <c:pt idx="20">
                  <c:v>g-tocopherol/b-tocopherol</c:v>
                </c:pt>
                <c:pt idx="21">
                  <c:v>b-tocotrienol/g-tocotrienol</c:v>
                </c:pt>
                <c:pt idx="22">
                  <c:v>d-tocopherol</c:v>
                </c:pt>
                <c:pt idx="23">
                  <c:v>a-tocopherol-quinone</c:v>
                </c:pt>
                <c:pt idx="24">
                  <c:v>phylloquinone</c:v>
                </c:pt>
                <c:pt idx="25">
                  <c:v>plastoquinol-9</c:v>
                </c:pt>
                <c:pt idx="26">
                  <c:v>plastoquinone</c:v>
                </c:pt>
                <c:pt idx="27">
                  <c:v>ubiquinone_9</c:v>
                </c:pt>
                <c:pt idx="28">
                  <c:v>ubiquinone-10</c:v>
                </c:pt>
              </c:strCache>
            </c:strRef>
          </c:cat>
          <c:val>
            <c:numRef>
              <c:f>'solo trasformati'!$B$3:$B$31</c:f>
              <c:numCache>
                <c:formatCode>General</c:formatCode>
                <c:ptCount val="2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99A-4036-9954-7E6A766CFA14}"/>
            </c:ext>
          </c:extLst>
        </c:ser>
        <c:ser>
          <c:idx val="1"/>
          <c:order val="1"/>
          <c:tx>
            <c:strRef>
              <c:f>'solo trasformati'!$C$2</c:f>
              <c:strCache>
                <c:ptCount val="1"/>
                <c:pt idx="0">
                  <c:v>2B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solo trasformati'!$A$3:$A$31</c:f>
              <c:strCache>
                <c:ptCount val="29"/>
                <c:pt idx="0">
                  <c:v>phytoene</c:v>
                </c:pt>
                <c:pt idx="1">
                  <c:v>phytofluene</c:v>
                </c:pt>
                <c:pt idx="2">
                  <c:v>z-carotene</c:v>
                </c:pt>
                <c:pt idx="3">
                  <c:v>lycopene</c:v>
                </c:pt>
                <c:pt idx="4">
                  <c:v>a-carotene</c:v>
                </c:pt>
                <c:pt idx="5">
                  <c:v>lutein</c:v>
                </c:pt>
                <c:pt idx="6">
                  <c:v>g-carotene</c:v>
                </c:pt>
                <c:pt idx="7">
                  <c:v>b-carotene</c:v>
                </c:pt>
                <c:pt idx="8">
                  <c:v>violaxanthin</c:v>
                </c:pt>
                <c:pt idx="9">
                  <c:v>neoxanthin</c:v>
                </c:pt>
                <c:pt idx="10">
                  <c:v>luteoxanthin</c:v>
                </c:pt>
                <c:pt idx="11">
                  <c:v>chlorophyll_a</c:v>
                </c:pt>
                <c:pt idx="12">
                  <c:v>chlorophyll_b</c:v>
                </c:pt>
                <c:pt idx="13">
                  <c:v>chlorophyllide_b</c:v>
                </c:pt>
                <c:pt idx="14">
                  <c:v>pheophorbide_a</c:v>
                </c:pt>
                <c:pt idx="15">
                  <c:v>pheophorbide_b</c:v>
                </c:pt>
                <c:pt idx="16">
                  <c:v>pheophytin_a</c:v>
                </c:pt>
                <c:pt idx="17">
                  <c:v>pheophytin_b</c:v>
                </c:pt>
                <c:pt idx="18">
                  <c:v>a-tocopherol</c:v>
                </c:pt>
                <c:pt idx="19">
                  <c:v>a-tocotrienol</c:v>
                </c:pt>
                <c:pt idx="20">
                  <c:v>g-tocopherol/b-tocopherol</c:v>
                </c:pt>
                <c:pt idx="21">
                  <c:v>b-tocotrienol/g-tocotrienol</c:v>
                </c:pt>
                <c:pt idx="22">
                  <c:v>d-tocopherol</c:v>
                </c:pt>
                <c:pt idx="23">
                  <c:v>a-tocopherol-quinone</c:v>
                </c:pt>
                <c:pt idx="24">
                  <c:v>phylloquinone</c:v>
                </c:pt>
                <c:pt idx="25">
                  <c:v>plastoquinol-9</c:v>
                </c:pt>
                <c:pt idx="26">
                  <c:v>plastoquinone</c:v>
                </c:pt>
                <c:pt idx="27">
                  <c:v>ubiquinone_9</c:v>
                </c:pt>
                <c:pt idx="28">
                  <c:v>ubiquinone-10</c:v>
                </c:pt>
              </c:strCache>
            </c:strRef>
          </c:cat>
          <c:val>
            <c:numRef>
              <c:f>'solo trasformati'!$C$3:$C$31</c:f>
              <c:numCache>
                <c:formatCode>General</c:formatCode>
                <c:ptCount val="2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0.225891767934836</c:v>
                </c:pt>
                <c:pt idx="4">
                  <c:v>-0.30771356720803705</c:v>
                </c:pt>
                <c:pt idx="5">
                  <c:v>-0.14585646961825385</c:v>
                </c:pt>
                <c:pt idx="6">
                  <c:v>7.0411156718356498</c:v>
                </c:pt>
                <c:pt idx="7">
                  <c:v>0.51257594914043203</c:v>
                </c:pt>
                <c:pt idx="8">
                  <c:v>0.34251819198974409</c:v>
                </c:pt>
                <c:pt idx="9">
                  <c:v>0.11869177800268697</c:v>
                </c:pt>
                <c:pt idx="10">
                  <c:v>-0.32502581967827371</c:v>
                </c:pt>
                <c:pt idx="11">
                  <c:v>0.33718436367553656</c:v>
                </c:pt>
                <c:pt idx="12">
                  <c:v>0.60477067284826691</c:v>
                </c:pt>
                <c:pt idx="13">
                  <c:v>-0.49680635669942791</c:v>
                </c:pt>
                <c:pt idx="14">
                  <c:v>0.38889966882016941</c:v>
                </c:pt>
                <c:pt idx="15">
                  <c:v>-2.473886566294874E-2</c:v>
                </c:pt>
                <c:pt idx="16">
                  <c:v>0.46680078195510066</c:v>
                </c:pt>
                <c:pt idx="17">
                  <c:v>-0.53763473840883724</c:v>
                </c:pt>
                <c:pt idx="18">
                  <c:v>0.22845056466341168</c:v>
                </c:pt>
                <c:pt idx="19">
                  <c:v>4.9978448462481555E-2</c:v>
                </c:pt>
                <c:pt idx="20">
                  <c:v>0.37712747961156073</c:v>
                </c:pt>
                <c:pt idx="21">
                  <c:v>0.37498823074814497</c:v>
                </c:pt>
                <c:pt idx="22">
                  <c:v>0.54951667906876256</c:v>
                </c:pt>
                <c:pt idx="23">
                  <c:v>0.51651139916017286</c:v>
                </c:pt>
                <c:pt idx="24">
                  <c:v>-0.33637120071194165</c:v>
                </c:pt>
                <c:pt idx="25">
                  <c:v>2.2480768270388123E-2</c:v>
                </c:pt>
                <c:pt idx="26">
                  <c:v>0.52093353881575066</c:v>
                </c:pt>
                <c:pt idx="27">
                  <c:v>-0.46562344536513539</c:v>
                </c:pt>
                <c:pt idx="28">
                  <c:v>0.341401093943595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99A-4036-9954-7E6A766CFA14}"/>
            </c:ext>
          </c:extLst>
        </c:ser>
        <c:ser>
          <c:idx val="2"/>
          <c:order val="2"/>
          <c:tx>
            <c:strRef>
              <c:f>'solo trasformati'!$D$2</c:f>
              <c:strCache>
                <c:ptCount val="1"/>
                <c:pt idx="0">
                  <c:v>12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solo trasformati'!$A$3:$A$31</c:f>
              <c:strCache>
                <c:ptCount val="29"/>
                <c:pt idx="0">
                  <c:v>phytoene</c:v>
                </c:pt>
                <c:pt idx="1">
                  <c:v>phytofluene</c:v>
                </c:pt>
                <c:pt idx="2">
                  <c:v>z-carotene</c:v>
                </c:pt>
                <c:pt idx="3">
                  <c:v>lycopene</c:v>
                </c:pt>
                <c:pt idx="4">
                  <c:v>a-carotene</c:v>
                </c:pt>
                <c:pt idx="5">
                  <c:v>lutein</c:v>
                </c:pt>
                <c:pt idx="6">
                  <c:v>g-carotene</c:v>
                </c:pt>
                <c:pt idx="7">
                  <c:v>b-carotene</c:v>
                </c:pt>
                <c:pt idx="8">
                  <c:v>violaxanthin</c:v>
                </c:pt>
                <c:pt idx="9">
                  <c:v>neoxanthin</c:v>
                </c:pt>
                <c:pt idx="10">
                  <c:v>luteoxanthin</c:v>
                </c:pt>
                <c:pt idx="11">
                  <c:v>chlorophyll_a</c:v>
                </c:pt>
                <c:pt idx="12">
                  <c:v>chlorophyll_b</c:v>
                </c:pt>
                <c:pt idx="13">
                  <c:v>chlorophyllide_b</c:v>
                </c:pt>
                <c:pt idx="14">
                  <c:v>pheophorbide_a</c:v>
                </c:pt>
                <c:pt idx="15">
                  <c:v>pheophorbide_b</c:v>
                </c:pt>
                <c:pt idx="16">
                  <c:v>pheophytin_a</c:v>
                </c:pt>
                <c:pt idx="17">
                  <c:v>pheophytin_b</c:v>
                </c:pt>
                <c:pt idx="18">
                  <c:v>a-tocopherol</c:v>
                </c:pt>
                <c:pt idx="19">
                  <c:v>a-tocotrienol</c:v>
                </c:pt>
                <c:pt idx="20">
                  <c:v>g-tocopherol/b-tocopherol</c:v>
                </c:pt>
                <c:pt idx="21">
                  <c:v>b-tocotrienol/g-tocotrienol</c:v>
                </c:pt>
                <c:pt idx="22">
                  <c:v>d-tocopherol</c:v>
                </c:pt>
                <c:pt idx="23">
                  <c:v>a-tocopherol-quinone</c:v>
                </c:pt>
                <c:pt idx="24">
                  <c:v>phylloquinone</c:v>
                </c:pt>
                <c:pt idx="25">
                  <c:v>plastoquinol-9</c:v>
                </c:pt>
                <c:pt idx="26">
                  <c:v>plastoquinone</c:v>
                </c:pt>
                <c:pt idx="27">
                  <c:v>ubiquinone_9</c:v>
                </c:pt>
                <c:pt idx="28">
                  <c:v>ubiquinone-10</c:v>
                </c:pt>
              </c:strCache>
            </c:strRef>
          </c:cat>
          <c:val>
            <c:numRef>
              <c:f>'solo trasformati'!$D$3:$D$31</c:f>
              <c:numCache>
                <c:formatCode>General</c:formatCode>
                <c:ptCount val="2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0.546789410494647</c:v>
                </c:pt>
                <c:pt idx="4">
                  <c:v>-0.46317969157472899</c:v>
                </c:pt>
                <c:pt idx="5">
                  <c:v>-0.18397625140816079</c:v>
                </c:pt>
                <c:pt idx="6">
                  <c:v>4.2142693767451522</c:v>
                </c:pt>
                <c:pt idx="7">
                  <c:v>0.4605720549741219</c:v>
                </c:pt>
                <c:pt idx="8">
                  <c:v>-0.38460661474985253</c:v>
                </c:pt>
                <c:pt idx="9">
                  <c:v>0.57202326867142939</c:v>
                </c:pt>
                <c:pt idx="10">
                  <c:v>-0.16847413107914574</c:v>
                </c:pt>
                <c:pt idx="11">
                  <c:v>0.25555290576341522</c:v>
                </c:pt>
                <c:pt idx="12">
                  <c:v>0.24182993935768612</c:v>
                </c:pt>
                <c:pt idx="13">
                  <c:v>-10.670113193801996</c:v>
                </c:pt>
                <c:pt idx="14">
                  <c:v>0.32665545798340628</c:v>
                </c:pt>
                <c:pt idx="15">
                  <c:v>0.35949998894064156</c:v>
                </c:pt>
                <c:pt idx="16">
                  <c:v>0.33172676919227101</c:v>
                </c:pt>
                <c:pt idx="17">
                  <c:v>0.10879497644981731</c:v>
                </c:pt>
                <c:pt idx="18">
                  <c:v>0.52288903450193314</c:v>
                </c:pt>
                <c:pt idx="19">
                  <c:v>-0.23301327256187837</c:v>
                </c:pt>
                <c:pt idx="20">
                  <c:v>0.67285843378693277</c:v>
                </c:pt>
                <c:pt idx="21">
                  <c:v>0.15686416636597331</c:v>
                </c:pt>
                <c:pt idx="22">
                  <c:v>0.3989215747048433</c:v>
                </c:pt>
                <c:pt idx="23">
                  <c:v>0.74463937922795853</c:v>
                </c:pt>
                <c:pt idx="24">
                  <c:v>-0.35182522219961193</c:v>
                </c:pt>
                <c:pt idx="25">
                  <c:v>2.6751798257071958E-2</c:v>
                </c:pt>
                <c:pt idx="26">
                  <c:v>0.56930241565520945</c:v>
                </c:pt>
                <c:pt idx="27">
                  <c:v>0.28830470859196194</c:v>
                </c:pt>
                <c:pt idx="28">
                  <c:v>0.46601101821059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99A-4036-9954-7E6A766CFA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9997376"/>
        <c:axId val="283883136"/>
      </c:barChart>
      <c:catAx>
        <c:axId val="3399973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600" b="1" dirty="0"/>
                  <a:t>Compound</a:t>
                </a:r>
                <a:endParaRPr lang="it-IT" b="1" dirty="0"/>
              </a:p>
            </c:rich>
          </c:tx>
          <c:layout>
            <c:manualLayout>
              <c:xMode val="edge"/>
              <c:yMode val="edge"/>
              <c:x val="0.45408545575346454"/>
              <c:y val="0.9364643165025650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283883136"/>
        <c:crosses val="autoZero"/>
        <c:auto val="1"/>
        <c:lblAlgn val="ctr"/>
        <c:lblOffset val="100"/>
        <c:noMultiLvlLbl val="0"/>
      </c:catAx>
      <c:valAx>
        <c:axId val="2838831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 noProof="0" dirty="0"/>
                  <a:t>Abundance</a:t>
                </a:r>
                <a:r>
                  <a:rPr lang="it-IT" sz="1600" b="1" baseline="0" dirty="0"/>
                  <a:t> relative to WT (log2)</a:t>
                </a:r>
                <a:endParaRPr lang="it-IT" sz="1600" b="1" dirty="0"/>
              </a:p>
            </c:rich>
          </c:tx>
          <c:layout>
            <c:manualLayout>
              <c:xMode val="edge"/>
              <c:yMode val="edge"/>
              <c:x val="0"/>
              <c:y val="0.2881835014261001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3399973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delete val="1"/>
      </c:legendEntry>
      <c:layout>
        <c:manualLayout>
          <c:xMode val="edge"/>
          <c:yMode val="edge"/>
          <c:x val="0.18127667470318351"/>
          <c:y val="0.92846408246445888"/>
          <c:w val="0.12312744780170624"/>
          <c:h val="5.056213971225580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sz="3200" b="1" dirty="0"/>
              <a:t>Br</a:t>
            </a:r>
            <a:endParaRPr lang="it-IT" b="1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olo trasformati'!$J$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solo trasformati'!$I$3:$I$31</c:f>
              <c:strCache>
                <c:ptCount val="29"/>
                <c:pt idx="0">
                  <c:v>phytoene</c:v>
                </c:pt>
                <c:pt idx="1">
                  <c:v>phytofluene</c:v>
                </c:pt>
                <c:pt idx="2">
                  <c:v>z-carotene</c:v>
                </c:pt>
                <c:pt idx="3">
                  <c:v>lycopene</c:v>
                </c:pt>
                <c:pt idx="4">
                  <c:v>a-carotene</c:v>
                </c:pt>
                <c:pt idx="5">
                  <c:v>lutein</c:v>
                </c:pt>
                <c:pt idx="6">
                  <c:v>g-carotene</c:v>
                </c:pt>
                <c:pt idx="7">
                  <c:v>b-carotene</c:v>
                </c:pt>
                <c:pt idx="8">
                  <c:v>violaxanthin</c:v>
                </c:pt>
                <c:pt idx="9">
                  <c:v>neoxanthin</c:v>
                </c:pt>
                <c:pt idx="10">
                  <c:v>luteoxanthin</c:v>
                </c:pt>
                <c:pt idx="11">
                  <c:v>chlorophyll_a</c:v>
                </c:pt>
                <c:pt idx="12">
                  <c:v>chlorophyll_b</c:v>
                </c:pt>
                <c:pt idx="13">
                  <c:v>chlorophyllide_b</c:v>
                </c:pt>
                <c:pt idx="14">
                  <c:v>pheophorbide_a</c:v>
                </c:pt>
                <c:pt idx="15">
                  <c:v>pheophorbide_b</c:v>
                </c:pt>
                <c:pt idx="16">
                  <c:v>pheophytin_a</c:v>
                </c:pt>
                <c:pt idx="17">
                  <c:v>pheophytin_b</c:v>
                </c:pt>
                <c:pt idx="18">
                  <c:v>a-tocopherol</c:v>
                </c:pt>
                <c:pt idx="19">
                  <c:v>a-tocotrienol</c:v>
                </c:pt>
                <c:pt idx="20">
                  <c:v>g-tocopherol/b-tocopherol</c:v>
                </c:pt>
                <c:pt idx="21">
                  <c:v>b-tocotrienol/g-tocotrienol</c:v>
                </c:pt>
                <c:pt idx="22">
                  <c:v>d-tocopherol</c:v>
                </c:pt>
                <c:pt idx="23">
                  <c:v>a-tocopherol-quinone</c:v>
                </c:pt>
                <c:pt idx="24">
                  <c:v>phylloquinone</c:v>
                </c:pt>
                <c:pt idx="25">
                  <c:v>plastoquinol-9</c:v>
                </c:pt>
                <c:pt idx="26">
                  <c:v>plastoquinone</c:v>
                </c:pt>
                <c:pt idx="27">
                  <c:v>ubiquinone_9</c:v>
                </c:pt>
                <c:pt idx="28">
                  <c:v>ubiquinone-10</c:v>
                </c:pt>
              </c:strCache>
            </c:strRef>
          </c:cat>
          <c:val>
            <c:numRef>
              <c:f>'solo trasformati'!$J$3:$J$31</c:f>
              <c:numCache>
                <c:formatCode>General</c:formatCode>
                <c:ptCount val="2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06A-476F-82AC-8CBD5B432E97}"/>
            </c:ext>
          </c:extLst>
        </c:ser>
        <c:ser>
          <c:idx val="1"/>
          <c:order val="1"/>
          <c:tx>
            <c:strRef>
              <c:f>'solo trasformati'!$K$2</c:f>
              <c:strCache>
                <c:ptCount val="1"/>
                <c:pt idx="0">
                  <c:v>2B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solo trasformati'!$I$3:$I$31</c:f>
              <c:strCache>
                <c:ptCount val="29"/>
                <c:pt idx="0">
                  <c:v>phytoene</c:v>
                </c:pt>
                <c:pt idx="1">
                  <c:v>phytofluene</c:v>
                </c:pt>
                <c:pt idx="2">
                  <c:v>z-carotene</c:v>
                </c:pt>
                <c:pt idx="3">
                  <c:v>lycopene</c:v>
                </c:pt>
                <c:pt idx="4">
                  <c:v>a-carotene</c:v>
                </c:pt>
                <c:pt idx="5">
                  <c:v>lutein</c:v>
                </c:pt>
                <c:pt idx="6">
                  <c:v>g-carotene</c:v>
                </c:pt>
                <c:pt idx="7">
                  <c:v>b-carotene</c:v>
                </c:pt>
                <c:pt idx="8">
                  <c:v>violaxanthin</c:v>
                </c:pt>
                <c:pt idx="9">
                  <c:v>neoxanthin</c:v>
                </c:pt>
                <c:pt idx="10">
                  <c:v>luteoxanthin</c:v>
                </c:pt>
                <c:pt idx="11">
                  <c:v>chlorophyll_a</c:v>
                </c:pt>
                <c:pt idx="12">
                  <c:v>chlorophyll_b</c:v>
                </c:pt>
                <c:pt idx="13">
                  <c:v>chlorophyllide_b</c:v>
                </c:pt>
                <c:pt idx="14">
                  <c:v>pheophorbide_a</c:v>
                </c:pt>
                <c:pt idx="15">
                  <c:v>pheophorbide_b</c:v>
                </c:pt>
                <c:pt idx="16">
                  <c:v>pheophytin_a</c:v>
                </c:pt>
                <c:pt idx="17">
                  <c:v>pheophytin_b</c:v>
                </c:pt>
                <c:pt idx="18">
                  <c:v>a-tocopherol</c:v>
                </c:pt>
                <c:pt idx="19">
                  <c:v>a-tocotrienol</c:v>
                </c:pt>
                <c:pt idx="20">
                  <c:v>g-tocopherol/b-tocopherol</c:v>
                </c:pt>
                <c:pt idx="21">
                  <c:v>b-tocotrienol/g-tocotrienol</c:v>
                </c:pt>
                <c:pt idx="22">
                  <c:v>d-tocopherol</c:v>
                </c:pt>
                <c:pt idx="23">
                  <c:v>a-tocopherol-quinone</c:v>
                </c:pt>
                <c:pt idx="24">
                  <c:v>phylloquinone</c:v>
                </c:pt>
                <c:pt idx="25">
                  <c:v>plastoquinol-9</c:v>
                </c:pt>
                <c:pt idx="26">
                  <c:v>plastoquinone</c:v>
                </c:pt>
                <c:pt idx="27">
                  <c:v>ubiquinone_9</c:v>
                </c:pt>
                <c:pt idx="28">
                  <c:v>ubiquinone-10</c:v>
                </c:pt>
              </c:strCache>
            </c:strRef>
          </c:cat>
          <c:val>
            <c:numRef>
              <c:f>'solo trasformati'!$K$3:$K$31</c:f>
              <c:numCache>
                <c:formatCode>General</c:formatCode>
                <c:ptCount val="29"/>
                <c:pt idx="0">
                  <c:v>0.77124303137836925</c:v>
                </c:pt>
                <c:pt idx="1">
                  <c:v>0.58640735308856506</c:v>
                </c:pt>
                <c:pt idx="2">
                  <c:v>0.26241959170500861</c:v>
                </c:pt>
                <c:pt idx="3">
                  <c:v>0.4070881276095788</c:v>
                </c:pt>
                <c:pt idx="4">
                  <c:v>2.4585334236309473</c:v>
                </c:pt>
                <c:pt idx="5">
                  <c:v>-0.40767395128056605</c:v>
                </c:pt>
                <c:pt idx="6">
                  <c:v>-5.3315176576071526</c:v>
                </c:pt>
                <c:pt idx="7">
                  <c:v>2.7739202225404136</c:v>
                </c:pt>
                <c:pt idx="8">
                  <c:v>-1.0230363310997694</c:v>
                </c:pt>
                <c:pt idx="9">
                  <c:v>-0.4246980366422225</c:v>
                </c:pt>
                <c:pt idx="10">
                  <c:v>-1.6584088293590933</c:v>
                </c:pt>
                <c:pt idx="11">
                  <c:v>1.0919289068596389</c:v>
                </c:pt>
                <c:pt idx="12">
                  <c:v>0.58648562096794543</c:v>
                </c:pt>
                <c:pt idx="13">
                  <c:v>-11.162489320448534</c:v>
                </c:pt>
                <c:pt idx="14">
                  <c:v>-1.6813067048007193</c:v>
                </c:pt>
                <c:pt idx="15">
                  <c:v>-2.6388863092143944</c:v>
                </c:pt>
                <c:pt idx="16">
                  <c:v>-1.7733038189082742</c:v>
                </c:pt>
                <c:pt idx="17">
                  <c:v>-2.4234371718228669</c:v>
                </c:pt>
                <c:pt idx="18">
                  <c:v>-0.13983357657801557</c:v>
                </c:pt>
                <c:pt idx="19">
                  <c:v>-7.7119282564208996E-2</c:v>
                </c:pt>
                <c:pt idx="20">
                  <c:v>-0.37924093374646334</c:v>
                </c:pt>
                <c:pt idx="21">
                  <c:v>4.179037087440559E-2</c:v>
                </c:pt>
                <c:pt idx="22">
                  <c:v>7.5158234744456723E-2</c:v>
                </c:pt>
                <c:pt idx="23">
                  <c:v>2.2195884704473E-2</c:v>
                </c:pt>
                <c:pt idx="24">
                  <c:v>1.0324897261696515E-3</c:v>
                </c:pt>
                <c:pt idx="25">
                  <c:v>-0.16168558022908411</c:v>
                </c:pt>
                <c:pt idx="26">
                  <c:v>-1.0697928504969476</c:v>
                </c:pt>
                <c:pt idx="27">
                  <c:v>0.74277495287203044</c:v>
                </c:pt>
                <c:pt idx="28">
                  <c:v>0.226921477142750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06A-476F-82AC-8CBD5B432E97}"/>
            </c:ext>
          </c:extLst>
        </c:ser>
        <c:ser>
          <c:idx val="2"/>
          <c:order val="2"/>
          <c:tx>
            <c:strRef>
              <c:f>'solo trasformati'!$L$2</c:f>
              <c:strCache>
                <c:ptCount val="1"/>
                <c:pt idx="0">
                  <c:v>12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solo trasformati'!$I$3:$I$31</c:f>
              <c:strCache>
                <c:ptCount val="29"/>
                <c:pt idx="0">
                  <c:v>phytoene</c:v>
                </c:pt>
                <c:pt idx="1">
                  <c:v>phytofluene</c:v>
                </c:pt>
                <c:pt idx="2">
                  <c:v>z-carotene</c:v>
                </c:pt>
                <c:pt idx="3">
                  <c:v>lycopene</c:v>
                </c:pt>
                <c:pt idx="4">
                  <c:v>a-carotene</c:v>
                </c:pt>
                <c:pt idx="5">
                  <c:v>lutein</c:v>
                </c:pt>
                <c:pt idx="6">
                  <c:v>g-carotene</c:v>
                </c:pt>
                <c:pt idx="7">
                  <c:v>b-carotene</c:v>
                </c:pt>
                <c:pt idx="8">
                  <c:v>violaxanthin</c:v>
                </c:pt>
                <c:pt idx="9">
                  <c:v>neoxanthin</c:v>
                </c:pt>
                <c:pt idx="10">
                  <c:v>luteoxanthin</c:v>
                </c:pt>
                <c:pt idx="11">
                  <c:v>chlorophyll_a</c:v>
                </c:pt>
                <c:pt idx="12">
                  <c:v>chlorophyll_b</c:v>
                </c:pt>
                <c:pt idx="13">
                  <c:v>chlorophyllide_b</c:v>
                </c:pt>
                <c:pt idx="14">
                  <c:v>pheophorbide_a</c:v>
                </c:pt>
                <c:pt idx="15">
                  <c:v>pheophorbide_b</c:v>
                </c:pt>
                <c:pt idx="16">
                  <c:v>pheophytin_a</c:v>
                </c:pt>
                <c:pt idx="17">
                  <c:v>pheophytin_b</c:v>
                </c:pt>
                <c:pt idx="18">
                  <c:v>a-tocopherol</c:v>
                </c:pt>
                <c:pt idx="19">
                  <c:v>a-tocotrienol</c:v>
                </c:pt>
                <c:pt idx="20">
                  <c:v>g-tocopherol/b-tocopherol</c:v>
                </c:pt>
                <c:pt idx="21">
                  <c:v>b-tocotrienol/g-tocotrienol</c:v>
                </c:pt>
                <c:pt idx="22">
                  <c:v>d-tocopherol</c:v>
                </c:pt>
                <c:pt idx="23">
                  <c:v>a-tocopherol-quinone</c:v>
                </c:pt>
                <c:pt idx="24">
                  <c:v>phylloquinone</c:v>
                </c:pt>
                <c:pt idx="25">
                  <c:v>plastoquinol-9</c:v>
                </c:pt>
                <c:pt idx="26">
                  <c:v>plastoquinone</c:v>
                </c:pt>
                <c:pt idx="27">
                  <c:v>ubiquinone_9</c:v>
                </c:pt>
                <c:pt idx="28">
                  <c:v>ubiquinone-10</c:v>
                </c:pt>
              </c:strCache>
            </c:strRef>
          </c:cat>
          <c:val>
            <c:numRef>
              <c:f>'solo trasformati'!$L$3:$L$31</c:f>
              <c:numCache>
                <c:formatCode>General</c:formatCode>
                <c:ptCount val="29"/>
                <c:pt idx="0">
                  <c:v>0.48552886958362862</c:v>
                </c:pt>
                <c:pt idx="1">
                  <c:v>0.50845768967771543</c:v>
                </c:pt>
                <c:pt idx="2">
                  <c:v>0.23053976957826658</c:v>
                </c:pt>
                <c:pt idx="3">
                  <c:v>0.75738928023698437</c:v>
                </c:pt>
                <c:pt idx="4">
                  <c:v>2.6469716174080333</c:v>
                </c:pt>
                <c:pt idx="5">
                  <c:v>-0.14968743806028106</c:v>
                </c:pt>
                <c:pt idx="6">
                  <c:v>0.68267032207039047</c:v>
                </c:pt>
                <c:pt idx="7">
                  <c:v>2.7008183653009903</c:v>
                </c:pt>
                <c:pt idx="8">
                  <c:v>-1.029593365107955</c:v>
                </c:pt>
                <c:pt idx="9">
                  <c:v>0.31361628023725835</c:v>
                </c:pt>
                <c:pt idx="10">
                  <c:v>-2.7955945021724955</c:v>
                </c:pt>
                <c:pt idx="11">
                  <c:v>1.3005060644193287</c:v>
                </c:pt>
                <c:pt idx="12">
                  <c:v>1.0493576471707735</c:v>
                </c:pt>
                <c:pt idx="13">
                  <c:v>-11.162489320448534</c:v>
                </c:pt>
                <c:pt idx="14">
                  <c:v>-2.1140222810607678</c:v>
                </c:pt>
                <c:pt idx="15">
                  <c:v>-1.7971959081017046</c:v>
                </c:pt>
                <c:pt idx="16">
                  <c:v>-1.7256664466608194</c:v>
                </c:pt>
                <c:pt idx="17">
                  <c:v>-2.0660157804638222</c:v>
                </c:pt>
                <c:pt idx="18">
                  <c:v>-0.20994250309397289</c:v>
                </c:pt>
                <c:pt idx="19">
                  <c:v>-0.11428893210224861</c:v>
                </c:pt>
                <c:pt idx="20">
                  <c:v>-0.89011180205525364</c:v>
                </c:pt>
                <c:pt idx="21">
                  <c:v>5.3736441015250956E-2</c:v>
                </c:pt>
                <c:pt idx="22">
                  <c:v>-0.4253166665523388</c:v>
                </c:pt>
                <c:pt idx="23">
                  <c:v>1.4566925325147232E-2</c:v>
                </c:pt>
                <c:pt idx="24">
                  <c:v>-0.4633236555813679</c:v>
                </c:pt>
                <c:pt idx="25">
                  <c:v>-0.22283491262473648</c:v>
                </c:pt>
                <c:pt idx="26">
                  <c:v>-0.43471478297427785</c:v>
                </c:pt>
                <c:pt idx="27">
                  <c:v>2.2447437396071703</c:v>
                </c:pt>
                <c:pt idx="28">
                  <c:v>-1.191962628465683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06A-476F-82AC-8CBD5B432E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62583536"/>
        <c:axId val="152415600"/>
      </c:barChart>
      <c:catAx>
        <c:axId val="26258353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600" b="1" dirty="0"/>
                  <a:t>Compound</a:t>
                </a:r>
                <a:endParaRPr lang="it-IT" b="1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52415600"/>
        <c:crosses val="autoZero"/>
        <c:auto val="1"/>
        <c:lblAlgn val="ctr"/>
        <c:lblOffset val="100"/>
        <c:noMultiLvlLbl val="0"/>
      </c:catAx>
      <c:valAx>
        <c:axId val="1524156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 i="0" baseline="0" noProof="0" dirty="0">
                    <a:effectLst/>
                  </a:rPr>
                  <a:t>Abundance</a:t>
                </a:r>
                <a:r>
                  <a:rPr lang="it-IT" sz="1600" b="1" i="0" baseline="0" dirty="0">
                    <a:effectLst/>
                  </a:rPr>
                  <a:t> relative to WT (log2)</a:t>
                </a:r>
                <a:endParaRPr lang="it-IT" sz="9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1.1657102505297964E-2"/>
              <c:y val="0.1627823980236459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2625835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delete val="1"/>
      </c:legendEntry>
      <c:layout>
        <c:manualLayout>
          <c:xMode val="edge"/>
          <c:yMode val="edge"/>
          <c:x val="0.22042298312560138"/>
          <c:y val="0.84271194936468108"/>
          <c:w val="0.14580210155449305"/>
          <c:h val="5.901760725822519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sz="3200" b="1" dirty="0"/>
              <a:t>Br+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title>
    <c:autoTitleDeleted val="0"/>
    <c:plotArea>
      <c:layout>
        <c:manualLayout>
          <c:layoutTarget val="inner"/>
          <c:xMode val="edge"/>
          <c:yMode val="edge"/>
          <c:x val="6.5346035105300543E-2"/>
          <c:y val="0.13133177640861624"/>
          <c:w val="0.9187021923880383"/>
          <c:h val="0.5542073646542606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olo trasformati'!$P$2</c:f>
              <c:strCache>
                <c:ptCount val="1"/>
                <c:pt idx="0">
                  <c:v> W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solo trasformati'!$O$3:$O$31</c:f>
              <c:strCache>
                <c:ptCount val="29"/>
                <c:pt idx="0">
                  <c:v>phytoene</c:v>
                </c:pt>
                <c:pt idx="1">
                  <c:v>phytofluene</c:v>
                </c:pt>
                <c:pt idx="2">
                  <c:v>z-carotene</c:v>
                </c:pt>
                <c:pt idx="3">
                  <c:v>lycopene</c:v>
                </c:pt>
                <c:pt idx="4">
                  <c:v>a-carotene</c:v>
                </c:pt>
                <c:pt idx="5">
                  <c:v>lutein</c:v>
                </c:pt>
                <c:pt idx="6">
                  <c:v>g-carotene</c:v>
                </c:pt>
                <c:pt idx="7">
                  <c:v>b-carotene</c:v>
                </c:pt>
                <c:pt idx="8">
                  <c:v>violaxanthin</c:v>
                </c:pt>
                <c:pt idx="9">
                  <c:v>neoxanthin</c:v>
                </c:pt>
                <c:pt idx="10">
                  <c:v>luteoxanthin</c:v>
                </c:pt>
                <c:pt idx="11">
                  <c:v>chlorophyll_a</c:v>
                </c:pt>
                <c:pt idx="12">
                  <c:v>chlorophyll_b</c:v>
                </c:pt>
                <c:pt idx="13">
                  <c:v>chlorophyllide_b</c:v>
                </c:pt>
                <c:pt idx="14">
                  <c:v>pheophorbide_a</c:v>
                </c:pt>
                <c:pt idx="15">
                  <c:v>pheophorbide_b</c:v>
                </c:pt>
                <c:pt idx="16">
                  <c:v>pheophytin_a</c:v>
                </c:pt>
                <c:pt idx="17">
                  <c:v>pheophytin_b</c:v>
                </c:pt>
                <c:pt idx="18">
                  <c:v>a-tocopherol</c:v>
                </c:pt>
                <c:pt idx="19">
                  <c:v>a-tocotrienol</c:v>
                </c:pt>
                <c:pt idx="20">
                  <c:v>g-tocopherol/b-tocopherol</c:v>
                </c:pt>
                <c:pt idx="21">
                  <c:v>b-tocotrienol/g-tocotrienol</c:v>
                </c:pt>
                <c:pt idx="22">
                  <c:v>d-tocopherol</c:v>
                </c:pt>
                <c:pt idx="23">
                  <c:v>a-tocopherol-quinone</c:v>
                </c:pt>
                <c:pt idx="24">
                  <c:v>phylloquinone</c:v>
                </c:pt>
                <c:pt idx="25">
                  <c:v>plastoquinol-9</c:v>
                </c:pt>
                <c:pt idx="26">
                  <c:v>plastoquinone</c:v>
                </c:pt>
                <c:pt idx="27">
                  <c:v>ubiquinone_9</c:v>
                </c:pt>
                <c:pt idx="28">
                  <c:v>ubiquinone-10</c:v>
                </c:pt>
              </c:strCache>
            </c:strRef>
          </c:cat>
          <c:val>
            <c:numRef>
              <c:f>'solo trasformati'!$P$3:$P$31</c:f>
              <c:numCache>
                <c:formatCode>General</c:formatCode>
                <c:ptCount val="2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79D-4EE9-A126-53D2F5624CA3}"/>
            </c:ext>
          </c:extLst>
        </c:ser>
        <c:ser>
          <c:idx val="1"/>
          <c:order val="1"/>
          <c:tx>
            <c:strRef>
              <c:f>'solo trasformati'!$Q$2</c:f>
              <c:strCache>
                <c:ptCount val="1"/>
                <c:pt idx="0">
                  <c:v>2B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solo trasformati'!$O$3:$O$31</c:f>
              <c:strCache>
                <c:ptCount val="29"/>
                <c:pt idx="0">
                  <c:v>phytoene</c:v>
                </c:pt>
                <c:pt idx="1">
                  <c:v>phytofluene</c:v>
                </c:pt>
                <c:pt idx="2">
                  <c:v>z-carotene</c:v>
                </c:pt>
                <c:pt idx="3">
                  <c:v>lycopene</c:v>
                </c:pt>
                <c:pt idx="4">
                  <c:v>a-carotene</c:v>
                </c:pt>
                <c:pt idx="5">
                  <c:v>lutein</c:v>
                </c:pt>
                <c:pt idx="6">
                  <c:v>g-carotene</c:v>
                </c:pt>
                <c:pt idx="7">
                  <c:v>b-carotene</c:v>
                </c:pt>
                <c:pt idx="8">
                  <c:v>violaxanthin</c:v>
                </c:pt>
                <c:pt idx="9">
                  <c:v>neoxanthin</c:v>
                </c:pt>
                <c:pt idx="10">
                  <c:v>luteoxanthin</c:v>
                </c:pt>
                <c:pt idx="11">
                  <c:v>chlorophyll_a</c:v>
                </c:pt>
                <c:pt idx="12">
                  <c:v>chlorophyll_b</c:v>
                </c:pt>
                <c:pt idx="13">
                  <c:v>chlorophyllide_b</c:v>
                </c:pt>
                <c:pt idx="14">
                  <c:v>pheophorbide_a</c:v>
                </c:pt>
                <c:pt idx="15">
                  <c:v>pheophorbide_b</c:v>
                </c:pt>
                <c:pt idx="16">
                  <c:v>pheophytin_a</c:v>
                </c:pt>
                <c:pt idx="17">
                  <c:v>pheophytin_b</c:v>
                </c:pt>
                <c:pt idx="18">
                  <c:v>a-tocopherol</c:v>
                </c:pt>
                <c:pt idx="19">
                  <c:v>a-tocotrienol</c:v>
                </c:pt>
                <c:pt idx="20">
                  <c:v>g-tocopherol/b-tocopherol</c:v>
                </c:pt>
                <c:pt idx="21">
                  <c:v>b-tocotrienol/g-tocotrienol</c:v>
                </c:pt>
                <c:pt idx="22">
                  <c:v>d-tocopherol</c:v>
                </c:pt>
                <c:pt idx="23">
                  <c:v>a-tocopherol-quinone</c:v>
                </c:pt>
                <c:pt idx="24">
                  <c:v>phylloquinone</c:v>
                </c:pt>
                <c:pt idx="25">
                  <c:v>plastoquinol-9</c:v>
                </c:pt>
                <c:pt idx="26">
                  <c:v>plastoquinone</c:v>
                </c:pt>
                <c:pt idx="27">
                  <c:v>ubiquinone_9</c:v>
                </c:pt>
                <c:pt idx="28">
                  <c:v>ubiquinone-10</c:v>
                </c:pt>
              </c:strCache>
            </c:strRef>
          </c:cat>
          <c:val>
            <c:numRef>
              <c:f>'solo trasformati'!$Q$3:$Q$31</c:f>
              <c:numCache>
                <c:formatCode>General</c:formatCode>
                <c:ptCount val="29"/>
                <c:pt idx="0">
                  <c:v>1.4814184043430667</c:v>
                </c:pt>
                <c:pt idx="1">
                  <c:v>2.2516852555218687</c:v>
                </c:pt>
                <c:pt idx="2">
                  <c:v>3.9490479512134771</c:v>
                </c:pt>
                <c:pt idx="3">
                  <c:v>2.7446608274244664</c:v>
                </c:pt>
                <c:pt idx="4">
                  <c:v>2.3485083100112978</c:v>
                </c:pt>
                <c:pt idx="5">
                  <c:v>0.648660627902514</c:v>
                </c:pt>
                <c:pt idx="6">
                  <c:v>8.188788473722127</c:v>
                </c:pt>
                <c:pt idx="7">
                  <c:v>3.4324010396840343</c:v>
                </c:pt>
                <c:pt idx="8">
                  <c:v>-0.50003135464459925</c:v>
                </c:pt>
                <c:pt idx="9">
                  <c:v>-0.8586449207593847</c:v>
                </c:pt>
                <c:pt idx="10">
                  <c:v>-1.2987384091800043</c:v>
                </c:pt>
                <c:pt idx="11">
                  <c:v>1.7934545145062906</c:v>
                </c:pt>
                <c:pt idx="12">
                  <c:v>2.5356440931019906</c:v>
                </c:pt>
                <c:pt idx="13">
                  <c:v>-12.01786487173173</c:v>
                </c:pt>
                <c:pt idx="14">
                  <c:v>-1.4774389505381271</c:v>
                </c:pt>
                <c:pt idx="15">
                  <c:v>-0.27163137149608579</c:v>
                </c:pt>
                <c:pt idx="16">
                  <c:v>-2.094859100859277</c:v>
                </c:pt>
                <c:pt idx="17">
                  <c:v>-0.41716066170364369</c:v>
                </c:pt>
                <c:pt idx="18">
                  <c:v>0.75419293519426067</c:v>
                </c:pt>
                <c:pt idx="19">
                  <c:v>2.9184539035831701E-2</c:v>
                </c:pt>
                <c:pt idx="20">
                  <c:v>1.0813203642877529</c:v>
                </c:pt>
                <c:pt idx="21">
                  <c:v>0.12785580399470445</c:v>
                </c:pt>
                <c:pt idx="22">
                  <c:v>0.61329782497559793</c:v>
                </c:pt>
                <c:pt idx="23">
                  <c:v>-5.0937782579636489E-3</c:v>
                </c:pt>
                <c:pt idx="24">
                  <c:v>0.38219552443849986</c:v>
                </c:pt>
                <c:pt idx="25">
                  <c:v>0.78748648840165514</c:v>
                </c:pt>
                <c:pt idx="26">
                  <c:v>0.6227133587119168</c:v>
                </c:pt>
                <c:pt idx="27">
                  <c:v>4.047874588242335</c:v>
                </c:pt>
                <c:pt idx="28">
                  <c:v>0.203932724841058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79D-4EE9-A126-53D2F5624CA3}"/>
            </c:ext>
          </c:extLst>
        </c:ser>
        <c:ser>
          <c:idx val="2"/>
          <c:order val="2"/>
          <c:tx>
            <c:strRef>
              <c:f>'solo trasformati'!$R$2</c:f>
              <c:strCache>
                <c:ptCount val="1"/>
                <c:pt idx="0">
                  <c:v>12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solo trasformati'!$O$3:$O$31</c:f>
              <c:strCache>
                <c:ptCount val="29"/>
                <c:pt idx="0">
                  <c:v>phytoene</c:v>
                </c:pt>
                <c:pt idx="1">
                  <c:v>phytofluene</c:v>
                </c:pt>
                <c:pt idx="2">
                  <c:v>z-carotene</c:v>
                </c:pt>
                <c:pt idx="3">
                  <c:v>lycopene</c:v>
                </c:pt>
                <c:pt idx="4">
                  <c:v>a-carotene</c:v>
                </c:pt>
                <c:pt idx="5">
                  <c:v>lutein</c:v>
                </c:pt>
                <c:pt idx="6">
                  <c:v>g-carotene</c:v>
                </c:pt>
                <c:pt idx="7">
                  <c:v>b-carotene</c:v>
                </c:pt>
                <c:pt idx="8">
                  <c:v>violaxanthin</c:v>
                </c:pt>
                <c:pt idx="9">
                  <c:v>neoxanthin</c:v>
                </c:pt>
                <c:pt idx="10">
                  <c:v>luteoxanthin</c:v>
                </c:pt>
                <c:pt idx="11">
                  <c:v>chlorophyll_a</c:v>
                </c:pt>
                <c:pt idx="12">
                  <c:v>chlorophyll_b</c:v>
                </c:pt>
                <c:pt idx="13">
                  <c:v>chlorophyllide_b</c:v>
                </c:pt>
                <c:pt idx="14">
                  <c:v>pheophorbide_a</c:v>
                </c:pt>
                <c:pt idx="15">
                  <c:v>pheophorbide_b</c:v>
                </c:pt>
                <c:pt idx="16">
                  <c:v>pheophytin_a</c:v>
                </c:pt>
                <c:pt idx="17">
                  <c:v>pheophytin_b</c:v>
                </c:pt>
                <c:pt idx="18">
                  <c:v>a-tocopherol</c:v>
                </c:pt>
                <c:pt idx="19">
                  <c:v>a-tocotrienol</c:v>
                </c:pt>
                <c:pt idx="20">
                  <c:v>g-tocopherol/b-tocopherol</c:v>
                </c:pt>
                <c:pt idx="21">
                  <c:v>b-tocotrienol/g-tocotrienol</c:v>
                </c:pt>
                <c:pt idx="22">
                  <c:v>d-tocopherol</c:v>
                </c:pt>
                <c:pt idx="23">
                  <c:v>a-tocopherol-quinone</c:v>
                </c:pt>
                <c:pt idx="24">
                  <c:v>phylloquinone</c:v>
                </c:pt>
                <c:pt idx="25">
                  <c:v>plastoquinol-9</c:v>
                </c:pt>
                <c:pt idx="26">
                  <c:v>plastoquinone</c:v>
                </c:pt>
                <c:pt idx="27">
                  <c:v>ubiquinone_9</c:v>
                </c:pt>
                <c:pt idx="28">
                  <c:v>ubiquinone-10</c:v>
                </c:pt>
              </c:strCache>
            </c:strRef>
          </c:cat>
          <c:val>
            <c:numRef>
              <c:f>'solo trasformati'!$R$3:$R$31</c:f>
              <c:numCache>
                <c:formatCode>General</c:formatCode>
                <c:ptCount val="29"/>
                <c:pt idx="0">
                  <c:v>0.80087614213794533</c:v>
                </c:pt>
                <c:pt idx="1">
                  <c:v>4.088949835747905</c:v>
                </c:pt>
                <c:pt idx="2">
                  <c:v>7.3313565520297015</c:v>
                </c:pt>
                <c:pt idx="3">
                  <c:v>3.0386822685520647</c:v>
                </c:pt>
                <c:pt idx="4">
                  <c:v>2.3165439859832913</c:v>
                </c:pt>
                <c:pt idx="5">
                  <c:v>0.41545270099585824</c:v>
                </c:pt>
                <c:pt idx="6">
                  <c:v>10.371839397286355</c:v>
                </c:pt>
                <c:pt idx="7">
                  <c:v>3.6210096890881163</c:v>
                </c:pt>
                <c:pt idx="8">
                  <c:v>-1.1245789710939222</c:v>
                </c:pt>
                <c:pt idx="9">
                  <c:v>-1.445814276006179</c:v>
                </c:pt>
                <c:pt idx="10">
                  <c:v>-2.0397942458146034</c:v>
                </c:pt>
                <c:pt idx="11">
                  <c:v>1.8259728778478073</c:v>
                </c:pt>
                <c:pt idx="12">
                  <c:v>1.9198349055315778</c:v>
                </c:pt>
                <c:pt idx="13">
                  <c:v>-12.01786487173173</c:v>
                </c:pt>
                <c:pt idx="14">
                  <c:v>-0.75573010565476251</c:v>
                </c:pt>
                <c:pt idx="15">
                  <c:v>0.99467602052929172</c:v>
                </c:pt>
                <c:pt idx="16">
                  <c:v>-1.1852694923560094</c:v>
                </c:pt>
                <c:pt idx="17">
                  <c:v>1.3292937045572406</c:v>
                </c:pt>
                <c:pt idx="18">
                  <c:v>0.55731127934010771</c:v>
                </c:pt>
                <c:pt idx="19">
                  <c:v>-7.8076846655693088E-2</c:v>
                </c:pt>
                <c:pt idx="20">
                  <c:v>1.704613153302093</c:v>
                </c:pt>
                <c:pt idx="21">
                  <c:v>-7.822825184372284E-2</c:v>
                </c:pt>
                <c:pt idx="22">
                  <c:v>1.287141965717975</c:v>
                </c:pt>
                <c:pt idx="23">
                  <c:v>-0.49640427445431179</c:v>
                </c:pt>
                <c:pt idx="24">
                  <c:v>0.12576527015062622</c:v>
                </c:pt>
                <c:pt idx="25">
                  <c:v>0.82872317769955728</c:v>
                </c:pt>
                <c:pt idx="26">
                  <c:v>-0.35604264725047047</c:v>
                </c:pt>
                <c:pt idx="27">
                  <c:v>6.0219197849776123</c:v>
                </c:pt>
                <c:pt idx="28">
                  <c:v>0.553159742097630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79D-4EE9-A126-53D2F5624C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54526128"/>
        <c:axId val="142946736"/>
      </c:barChart>
      <c:catAx>
        <c:axId val="2545261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600" b="1" dirty="0"/>
                  <a:t>Compound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42946736"/>
        <c:crosses val="autoZero"/>
        <c:auto val="1"/>
        <c:lblAlgn val="ctr"/>
        <c:lblOffset val="100"/>
        <c:noMultiLvlLbl val="0"/>
      </c:catAx>
      <c:valAx>
        <c:axId val="1429467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600" b="1" dirty="0" err="1"/>
                  <a:t>Abundance</a:t>
                </a:r>
                <a:r>
                  <a:rPr lang="it-IT" sz="1600" b="1" baseline="0" dirty="0"/>
                  <a:t> relative to WT (log2)</a:t>
                </a:r>
                <a:endParaRPr lang="it-IT" sz="1600" b="1" dirty="0"/>
              </a:p>
            </c:rich>
          </c:tx>
          <c:layout>
            <c:manualLayout>
              <c:xMode val="edge"/>
              <c:yMode val="edge"/>
              <c:x val="9.6955085856961411E-3"/>
              <c:y val="0.2354966229767142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2545261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delete val="1"/>
      </c:legendEntry>
      <c:layout>
        <c:manualLayout>
          <c:xMode val="edge"/>
          <c:yMode val="edge"/>
          <c:x val="0.22425293578798036"/>
          <c:y val="0.82684380289045933"/>
          <c:w val="0.13183980555649219"/>
          <c:h val="5.975712604699802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sz="3200" b="1" dirty="0"/>
              <a:t>Br+4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olo trasformati'!$V$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solo trasformati'!$U$3:$U$31</c:f>
              <c:strCache>
                <c:ptCount val="29"/>
                <c:pt idx="0">
                  <c:v>phytoene</c:v>
                </c:pt>
                <c:pt idx="1">
                  <c:v>phytofluene</c:v>
                </c:pt>
                <c:pt idx="2">
                  <c:v>z-carotene</c:v>
                </c:pt>
                <c:pt idx="3">
                  <c:v>lycopene</c:v>
                </c:pt>
                <c:pt idx="4">
                  <c:v>a-carotene</c:v>
                </c:pt>
                <c:pt idx="5">
                  <c:v>lutein</c:v>
                </c:pt>
                <c:pt idx="6">
                  <c:v>g-carotene</c:v>
                </c:pt>
                <c:pt idx="7">
                  <c:v>b-carotene</c:v>
                </c:pt>
                <c:pt idx="8">
                  <c:v>violaxanthin</c:v>
                </c:pt>
                <c:pt idx="9">
                  <c:v>neoxanthin</c:v>
                </c:pt>
                <c:pt idx="10">
                  <c:v>luteoxanthin</c:v>
                </c:pt>
                <c:pt idx="11">
                  <c:v>chlorophyll_a</c:v>
                </c:pt>
                <c:pt idx="12">
                  <c:v>chlorophyll_b</c:v>
                </c:pt>
                <c:pt idx="13">
                  <c:v>chlorophyllide_b</c:v>
                </c:pt>
                <c:pt idx="14">
                  <c:v>pheophorbide_a</c:v>
                </c:pt>
                <c:pt idx="15">
                  <c:v>pheophorbide_b</c:v>
                </c:pt>
                <c:pt idx="16">
                  <c:v>pheophytin_a</c:v>
                </c:pt>
                <c:pt idx="17">
                  <c:v>pheophytin_b</c:v>
                </c:pt>
                <c:pt idx="18">
                  <c:v>a-tocopherol</c:v>
                </c:pt>
                <c:pt idx="19">
                  <c:v>a-tocotrienol</c:v>
                </c:pt>
                <c:pt idx="20">
                  <c:v>g-tocopherol/b-tocopherol</c:v>
                </c:pt>
                <c:pt idx="21">
                  <c:v>b-tocotrienol/g-tocotrienol</c:v>
                </c:pt>
                <c:pt idx="22">
                  <c:v>d-tocopherol</c:v>
                </c:pt>
                <c:pt idx="23">
                  <c:v>a-tocopherol-quinone</c:v>
                </c:pt>
                <c:pt idx="24">
                  <c:v>phylloquinone</c:v>
                </c:pt>
                <c:pt idx="25">
                  <c:v>plastoquinol-9</c:v>
                </c:pt>
                <c:pt idx="26">
                  <c:v>plastoquinone</c:v>
                </c:pt>
                <c:pt idx="27">
                  <c:v>ubiquinone_9</c:v>
                </c:pt>
                <c:pt idx="28">
                  <c:v>ubiquinone-10</c:v>
                </c:pt>
              </c:strCache>
            </c:strRef>
          </c:cat>
          <c:val>
            <c:numRef>
              <c:f>'solo trasformati'!$V$3:$V$31</c:f>
              <c:numCache>
                <c:formatCode>General</c:formatCode>
                <c:ptCount val="2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5FC-42ED-8F16-F64B6D6DA173}"/>
            </c:ext>
          </c:extLst>
        </c:ser>
        <c:ser>
          <c:idx val="1"/>
          <c:order val="1"/>
          <c:tx>
            <c:strRef>
              <c:f>'solo trasformati'!$W$2</c:f>
              <c:strCache>
                <c:ptCount val="1"/>
                <c:pt idx="0">
                  <c:v>2B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solo trasformati'!$U$3:$U$31</c:f>
              <c:strCache>
                <c:ptCount val="29"/>
                <c:pt idx="0">
                  <c:v>phytoene</c:v>
                </c:pt>
                <c:pt idx="1">
                  <c:v>phytofluene</c:v>
                </c:pt>
                <c:pt idx="2">
                  <c:v>z-carotene</c:v>
                </c:pt>
                <c:pt idx="3">
                  <c:v>lycopene</c:v>
                </c:pt>
                <c:pt idx="4">
                  <c:v>a-carotene</c:v>
                </c:pt>
                <c:pt idx="5">
                  <c:v>lutein</c:v>
                </c:pt>
                <c:pt idx="6">
                  <c:v>g-carotene</c:v>
                </c:pt>
                <c:pt idx="7">
                  <c:v>b-carotene</c:v>
                </c:pt>
                <c:pt idx="8">
                  <c:v>violaxanthin</c:v>
                </c:pt>
                <c:pt idx="9">
                  <c:v>neoxanthin</c:v>
                </c:pt>
                <c:pt idx="10">
                  <c:v>luteoxanthin</c:v>
                </c:pt>
                <c:pt idx="11">
                  <c:v>chlorophyll_a</c:v>
                </c:pt>
                <c:pt idx="12">
                  <c:v>chlorophyll_b</c:v>
                </c:pt>
                <c:pt idx="13">
                  <c:v>chlorophyllide_b</c:v>
                </c:pt>
                <c:pt idx="14">
                  <c:v>pheophorbide_a</c:v>
                </c:pt>
                <c:pt idx="15">
                  <c:v>pheophorbide_b</c:v>
                </c:pt>
                <c:pt idx="16">
                  <c:v>pheophytin_a</c:v>
                </c:pt>
                <c:pt idx="17">
                  <c:v>pheophytin_b</c:v>
                </c:pt>
                <c:pt idx="18">
                  <c:v>a-tocopherol</c:v>
                </c:pt>
                <c:pt idx="19">
                  <c:v>a-tocotrienol</c:v>
                </c:pt>
                <c:pt idx="20">
                  <c:v>g-tocopherol/b-tocopherol</c:v>
                </c:pt>
                <c:pt idx="21">
                  <c:v>b-tocotrienol/g-tocotrienol</c:v>
                </c:pt>
                <c:pt idx="22">
                  <c:v>d-tocopherol</c:v>
                </c:pt>
                <c:pt idx="23">
                  <c:v>a-tocopherol-quinone</c:v>
                </c:pt>
                <c:pt idx="24">
                  <c:v>phylloquinone</c:v>
                </c:pt>
                <c:pt idx="25">
                  <c:v>plastoquinol-9</c:v>
                </c:pt>
                <c:pt idx="26">
                  <c:v>plastoquinone</c:v>
                </c:pt>
                <c:pt idx="27">
                  <c:v>ubiquinone_9</c:v>
                </c:pt>
                <c:pt idx="28">
                  <c:v>ubiquinone-10</c:v>
                </c:pt>
              </c:strCache>
            </c:strRef>
          </c:cat>
          <c:val>
            <c:numRef>
              <c:f>'solo trasformati'!$W$3:$W$31</c:f>
              <c:numCache>
                <c:formatCode>General</c:formatCode>
                <c:ptCount val="29"/>
                <c:pt idx="0">
                  <c:v>1.8391996190536291</c:v>
                </c:pt>
                <c:pt idx="1">
                  <c:v>1.6564952004180884</c:v>
                </c:pt>
                <c:pt idx="2">
                  <c:v>2.0475505895979191</c:v>
                </c:pt>
                <c:pt idx="3">
                  <c:v>2.1314218938256082</c:v>
                </c:pt>
                <c:pt idx="4">
                  <c:v>0.20957690933335638</c:v>
                </c:pt>
                <c:pt idx="5">
                  <c:v>-0.30109231272389708</c:v>
                </c:pt>
                <c:pt idx="6">
                  <c:v>3.3340207689360496E-2</c:v>
                </c:pt>
                <c:pt idx="7">
                  <c:v>3.7748754859526503</c:v>
                </c:pt>
                <c:pt idx="8">
                  <c:v>0.61685186176918105</c:v>
                </c:pt>
                <c:pt idx="9">
                  <c:v>0.23394328170779316</c:v>
                </c:pt>
                <c:pt idx="10">
                  <c:v>0.92558516701446636</c:v>
                </c:pt>
                <c:pt idx="11">
                  <c:v>12.354671005761096</c:v>
                </c:pt>
                <c:pt idx="12">
                  <c:v>11.805346892036866</c:v>
                </c:pt>
                <c:pt idx="13">
                  <c:v>0</c:v>
                </c:pt>
                <c:pt idx="14">
                  <c:v>-0.37867134068145963</c:v>
                </c:pt>
                <c:pt idx="15">
                  <c:v>-0.78336733387473689</c:v>
                </c:pt>
                <c:pt idx="16">
                  <c:v>-0.45152232080589882</c:v>
                </c:pt>
                <c:pt idx="17">
                  <c:v>-2.2715983567104239</c:v>
                </c:pt>
                <c:pt idx="18">
                  <c:v>3.950830760307193</c:v>
                </c:pt>
                <c:pt idx="19">
                  <c:v>3.0496304446789733</c:v>
                </c:pt>
                <c:pt idx="20">
                  <c:v>2.7501682229340192</c:v>
                </c:pt>
                <c:pt idx="21">
                  <c:v>2.8233326418326463</c:v>
                </c:pt>
                <c:pt idx="22">
                  <c:v>2.8526086567462983</c:v>
                </c:pt>
                <c:pt idx="23">
                  <c:v>-0.44076305853901188</c:v>
                </c:pt>
                <c:pt idx="24">
                  <c:v>-0.29414170404262391</c:v>
                </c:pt>
                <c:pt idx="25">
                  <c:v>-5.3027470076030148E-2</c:v>
                </c:pt>
                <c:pt idx="26">
                  <c:v>-0.31886245771833938</c:v>
                </c:pt>
                <c:pt idx="27">
                  <c:v>0.41305318432064353</c:v>
                </c:pt>
                <c:pt idx="28">
                  <c:v>0.31583602836403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5FC-42ED-8F16-F64B6D6DA173}"/>
            </c:ext>
          </c:extLst>
        </c:ser>
        <c:ser>
          <c:idx val="2"/>
          <c:order val="2"/>
          <c:tx>
            <c:strRef>
              <c:f>'solo trasformati'!$X$2</c:f>
              <c:strCache>
                <c:ptCount val="1"/>
                <c:pt idx="0">
                  <c:v>12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solo trasformati'!$U$3:$U$31</c:f>
              <c:strCache>
                <c:ptCount val="29"/>
                <c:pt idx="0">
                  <c:v>phytoene</c:v>
                </c:pt>
                <c:pt idx="1">
                  <c:v>phytofluene</c:v>
                </c:pt>
                <c:pt idx="2">
                  <c:v>z-carotene</c:v>
                </c:pt>
                <c:pt idx="3">
                  <c:v>lycopene</c:v>
                </c:pt>
                <c:pt idx="4">
                  <c:v>a-carotene</c:v>
                </c:pt>
                <c:pt idx="5">
                  <c:v>lutein</c:v>
                </c:pt>
                <c:pt idx="6">
                  <c:v>g-carotene</c:v>
                </c:pt>
                <c:pt idx="7">
                  <c:v>b-carotene</c:v>
                </c:pt>
                <c:pt idx="8">
                  <c:v>violaxanthin</c:v>
                </c:pt>
                <c:pt idx="9">
                  <c:v>neoxanthin</c:v>
                </c:pt>
                <c:pt idx="10">
                  <c:v>luteoxanthin</c:v>
                </c:pt>
                <c:pt idx="11">
                  <c:v>chlorophyll_a</c:v>
                </c:pt>
                <c:pt idx="12">
                  <c:v>chlorophyll_b</c:v>
                </c:pt>
                <c:pt idx="13">
                  <c:v>chlorophyllide_b</c:v>
                </c:pt>
                <c:pt idx="14">
                  <c:v>pheophorbide_a</c:v>
                </c:pt>
                <c:pt idx="15">
                  <c:v>pheophorbide_b</c:v>
                </c:pt>
                <c:pt idx="16">
                  <c:v>pheophytin_a</c:v>
                </c:pt>
                <c:pt idx="17">
                  <c:v>pheophytin_b</c:v>
                </c:pt>
                <c:pt idx="18">
                  <c:v>a-tocopherol</c:v>
                </c:pt>
                <c:pt idx="19">
                  <c:v>a-tocotrienol</c:v>
                </c:pt>
                <c:pt idx="20">
                  <c:v>g-tocopherol/b-tocopherol</c:v>
                </c:pt>
                <c:pt idx="21">
                  <c:v>b-tocotrienol/g-tocotrienol</c:v>
                </c:pt>
                <c:pt idx="22">
                  <c:v>d-tocopherol</c:v>
                </c:pt>
                <c:pt idx="23">
                  <c:v>a-tocopherol-quinone</c:v>
                </c:pt>
                <c:pt idx="24">
                  <c:v>phylloquinone</c:v>
                </c:pt>
                <c:pt idx="25">
                  <c:v>plastoquinol-9</c:v>
                </c:pt>
                <c:pt idx="26">
                  <c:v>plastoquinone</c:v>
                </c:pt>
                <c:pt idx="27">
                  <c:v>ubiquinone_9</c:v>
                </c:pt>
                <c:pt idx="28">
                  <c:v>ubiquinone-10</c:v>
                </c:pt>
              </c:strCache>
            </c:strRef>
          </c:cat>
          <c:val>
            <c:numRef>
              <c:f>'solo trasformati'!$X$3:$X$31</c:f>
              <c:numCache>
                <c:formatCode>General</c:formatCode>
                <c:ptCount val="29"/>
                <c:pt idx="0">
                  <c:v>1.6248469902007341</c:v>
                </c:pt>
                <c:pt idx="1">
                  <c:v>1.6650243839100354</c:v>
                </c:pt>
                <c:pt idx="2">
                  <c:v>0.86079365706409727</c:v>
                </c:pt>
                <c:pt idx="3">
                  <c:v>2.6497705016845887</c:v>
                </c:pt>
                <c:pt idx="4">
                  <c:v>5.9981679442221068E-2</c:v>
                </c:pt>
                <c:pt idx="5">
                  <c:v>-0.41057700883555642</c:v>
                </c:pt>
                <c:pt idx="6">
                  <c:v>0.20913290780934257</c:v>
                </c:pt>
                <c:pt idx="7">
                  <c:v>3.798319449243472</c:v>
                </c:pt>
                <c:pt idx="8">
                  <c:v>-0.24794984079000659</c:v>
                </c:pt>
                <c:pt idx="9">
                  <c:v>-0.34445995616230796</c:v>
                </c:pt>
                <c:pt idx="10">
                  <c:v>0.29144298606699509</c:v>
                </c:pt>
                <c:pt idx="11">
                  <c:v>11.534186843020485</c:v>
                </c:pt>
                <c:pt idx="12">
                  <c:v>10.791952231657575</c:v>
                </c:pt>
                <c:pt idx="13">
                  <c:v>0</c:v>
                </c:pt>
                <c:pt idx="14">
                  <c:v>-0.86717357725147504</c:v>
                </c:pt>
                <c:pt idx="15">
                  <c:v>-1.2849890286411172</c:v>
                </c:pt>
                <c:pt idx="16">
                  <c:v>-0.95078342741796751</c:v>
                </c:pt>
                <c:pt idx="17">
                  <c:v>-1.1349842208300129</c:v>
                </c:pt>
                <c:pt idx="18">
                  <c:v>4.7012713371117494</c:v>
                </c:pt>
                <c:pt idx="19">
                  <c:v>3.2725271616144149</c:v>
                </c:pt>
                <c:pt idx="20">
                  <c:v>3.3084061394232696</c:v>
                </c:pt>
                <c:pt idx="21">
                  <c:v>3.1201584875105843</c:v>
                </c:pt>
                <c:pt idx="22">
                  <c:v>2.844815350133139</c:v>
                </c:pt>
                <c:pt idx="23">
                  <c:v>-0.26333847360798218</c:v>
                </c:pt>
                <c:pt idx="24">
                  <c:v>-0.25765738124672949</c:v>
                </c:pt>
                <c:pt idx="25">
                  <c:v>-4.6104706805758233E-2</c:v>
                </c:pt>
                <c:pt idx="26">
                  <c:v>7.0075295766685808E-2</c:v>
                </c:pt>
                <c:pt idx="27">
                  <c:v>-2.4809816717168077E-2</c:v>
                </c:pt>
                <c:pt idx="28">
                  <c:v>0.175658192717526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5FC-42ED-8F16-F64B6D6DA1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6589568"/>
        <c:axId val="279903648"/>
      </c:barChart>
      <c:catAx>
        <c:axId val="2065895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600" b="1" dirty="0"/>
                  <a:t>Compound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279903648"/>
        <c:crosses val="autoZero"/>
        <c:auto val="1"/>
        <c:lblAlgn val="ctr"/>
        <c:lblOffset val="100"/>
        <c:noMultiLvlLbl val="0"/>
      </c:catAx>
      <c:valAx>
        <c:axId val="2799036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600" b="1" dirty="0" err="1"/>
                  <a:t>Abundance</a:t>
                </a:r>
                <a:r>
                  <a:rPr lang="it-IT" sz="1600" b="1" dirty="0"/>
                  <a:t> relative to WT (log2)</a:t>
                </a:r>
              </a:p>
            </c:rich>
          </c:tx>
          <c:layout>
            <c:manualLayout>
              <c:xMode val="edge"/>
              <c:yMode val="edge"/>
              <c:x val="3.0167472038671722E-4"/>
              <c:y val="0.2035034073516343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2065895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delete val="1"/>
      </c:legendEntry>
      <c:layout>
        <c:manualLayout>
          <c:xMode val="edge"/>
          <c:yMode val="edge"/>
          <c:x val="0.21921730539954667"/>
          <c:y val="0.82436037281614905"/>
          <c:w val="0.13688195532813871"/>
          <c:h val="4.306384764042121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  <c:userShapes r:id="rId4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sz="3200" b="1" dirty="0"/>
              <a:t>Br+6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olo trasformati'!$AB$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solo trasformati'!$AA$3:$AA$31</c:f>
              <c:strCache>
                <c:ptCount val="29"/>
                <c:pt idx="0">
                  <c:v>phytoene</c:v>
                </c:pt>
                <c:pt idx="1">
                  <c:v>phytofluene</c:v>
                </c:pt>
                <c:pt idx="2">
                  <c:v>z-carotene</c:v>
                </c:pt>
                <c:pt idx="3">
                  <c:v>lycopene</c:v>
                </c:pt>
                <c:pt idx="4">
                  <c:v>a-carotene</c:v>
                </c:pt>
                <c:pt idx="5">
                  <c:v>lutein</c:v>
                </c:pt>
                <c:pt idx="6">
                  <c:v>g-carotene</c:v>
                </c:pt>
                <c:pt idx="7">
                  <c:v>b-carotene</c:v>
                </c:pt>
                <c:pt idx="8">
                  <c:v>violaxanthin</c:v>
                </c:pt>
                <c:pt idx="9">
                  <c:v>neoxanthin</c:v>
                </c:pt>
                <c:pt idx="10">
                  <c:v>luteoxanthin</c:v>
                </c:pt>
                <c:pt idx="11">
                  <c:v>chlorophyll_a</c:v>
                </c:pt>
                <c:pt idx="12">
                  <c:v>chlorophyll_b</c:v>
                </c:pt>
                <c:pt idx="13">
                  <c:v>chlorophyllide_b</c:v>
                </c:pt>
                <c:pt idx="14">
                  <c:v>pheophorbide_a</c:v>
                </c:pt>
                <c:pt idx="15">
                  <c:v>pheophorbide_b</c:v>
                </c:pt>
                <c:pt idx="16">
                  <c:v>pheophytin_a</c:v>
                </c:pt>
                <c:pt idx="17">
                  <c:v>pheophytin_b</c:v>
                </c:pt>
                <c:pt idx="18">
                  <c:v>a-tocopherol</c:v>
                </c:pt>
                <c:pt idx="19">
                  <c:v>a-tocotrienol</c:v>
                </c:pt>
                <c:pt idx="20">
                  <c:v>g-tocopherol/b-tocopherol</c:v>
                </c:pt>
                <c:pt idx="21">
                  <c:v>b-tocotrienol/g-tocotrienol</c:v>
                </c:pt>
                <c:pt idx="22">
                  <c:v>d-tocopherol</c:v>
                </c:pt>
                <c:pt idx="23">
                  <c:v>a-tocopherol-quinone</c:v>
                </c:pt>
                <c:pt idx="24">
                  <c:v>phylloquinone</c:v>
                </c:pt>
                <c:pt idx="25">
                  <c:v>plastoquinol-9</c:v>
                </c:pt>
                <c:pt idx="26">
                  <c:v>plastoquinone</c:v>
                </c:pt>
                <c:pt idx="27">
                  <c:v>ubiquinone_9</c:v>
                </c:pt>
                <c:pt idx="28">
                  <c:v>ubiquinone-10</c:v>
                </c:pt>
              </c:strCache>
            </c:strRef>
          </c:cat>
          <c:val>
            <c:numRef>
              <c:f>'solo trasformati'!$AB$3:$AB$31</c:f>
              <c:numCache>
                <c:formatCode>General</c:formatCode>
                <c:ptCount val="2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18E-4825-A017-5475784E9F69}"/>
            </c:ext>
          </c:extLst>
        </c:ser>
        <c:ser>
          <c:idx val="1"/>
          <c:order val="1"/>
          <c:tx>
            <c:strRef>
              <c:f>'solo trasformati'!$AC$2</c:f>
              <c:strCache>
                <c:ptCount val="1"/>
                <c:pt idx="0">
                  <c:v>2B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solo trasformati'!$AA$3:$AA$31</c:f>
              <c:strCache>
                <c:ptCount val="29"/>
                <c:pt idx="0">
                  <c:v>phytoene</c:v>
                </c:pt>
                <c:pt idx="1">
                  <c:v>phytofluene</c:v>
                </c:pt>
                <c:pt idx="2">
                  <c:v>z-carotene</c:v>
                </c:pt>
                <c:pt idx="3">
                  <c:v>lycopene</c:v>
                </c:pt>
                <c:pt idx="4">
                  <c:v>a-carotene</c:v>
                </c:pt>
                <c:pt idx="5">
                  <c:v>lutein</c:v>
                </c:pt>
                <c:pt idx="6">
                  <c:v>g-carotene</c:v>
                </c:pt>
                <c:pt idx="7">
                  <c:v>b-carotene</c:v>
                </c:pt>
                <c:pt idx="8">
                  <c:v>violaxanthin</c:v>
                </c:pt>
                <c:pt idx="9">
                  <c:v>neoxanthin</c:v>
                </c:pt>
                <c:pt idx="10">
                  <c:v>luteoxanthin</c:v>
                </c:pt>
                <c:pt idx="11">
                  <c:v>chlorophyll_a</c:v>
                </c:pt>
                <c:pt idx="12">
                  <c:v>chlorophyll_b</c:v>
                </c:pt>
                <c:pt idx="13">
                  <c:v>chlorophyllide_b</c:v>
                </c:pt>
                <c:pt idx="14">
                  <c:v>pheophorbide_a</c:v>
                </c:pt>
                <c:pt idx="15">
                  <c:v>pheophorbide_b</c:v>
                </c:pt>
                <c:pt idx="16">
                  <c:v>pheophytin_a</c:v>
                </c:pt>
                <c:pt idx="17">
                  <c:v>pheophytin_b</c:v>
                </c:pt>
                <c:pt idx="18">
                  <c:v>a-tocopherol</c:v>
                </c:pt>
                <c:pt idx="19">
                  <c:v>a-tocotrienol</c:v>
                </c:pt>
                <c:pt idx="20">
                  <c:v>g-tocopherol/b-tocopherol</c:v>
                </c:pt>
                <c:pt idx="21">
                  <c:v>b-tocotrienol/g-tocotrienol</c:v>
                </c:pt>
                <c:pt idx="22">
                  <c:v>d-tocopherol</c:v>
                </c:pt>
                <c:pt idx="23">
                  <c:v>a-tocopherol-quinone</c:v>
                </c:pt>
                <c:pt idx="24">
                  <c:v>phylloquinone</c:v>
                </c:pt>
                <c:pt idx="25">
                  <c:v>plastoquinol-9</c:v>
                </c:pt>
                <c:pt idx="26">
                  <c:v>plastoquinone</c:v>
                </c:pt>
                <c:pt idx="27">
                  <c:v>ubiquinone_9</c:v>
                </c:pt>
                <c:pt idx="28">
                  <c:v>ubiquinone-10</c:v>
                </c:pt>
              </c:strCache>
            </c:strRef>
          </c:cat>
          <c:val>
            <c:numRef>
              <c:f>'solo trasformati'!$AC$3:$AC$31</c:f>
              <c:numCache>
                <c:formatCode>General</c:formatCode>
                <c:ptCount val="29"/>
                <c:pt idx="0">
                  <c:v>1.4112661240616007</c:v>
                </c:pt>
                <c:pt idx="1">
                  <c:v>2.6852064964680089</c:v>
                </c:pt>
                <c:pt idx="2">
                  <c:v>6.0328417544072339</c:v>
                </c:pt>
                <c:pt idx="3">
                  <c:v>1.0516540790978743</c:v>
                </c:pt>
                <c:pt idx="4">
                  <c:v>1.8766792653699398</c:v>
                </c:pt>
                <c:pt idx="5">
                  <c:v>0.90319625627969524</c:v>
                </c:pt>
                <c:pt idx="6">
                  <c:v>7.8182825280622446</c:v>
                </c:pt>
                <c:pt idx="7">
                  <c:v>2.0486716311741815</c:v>
                </c:pt>
                <c:pt idx="8">
                  <c:v>-0.5020518412549233</c:v>
                </c:pt>
                <c:pt idx="9">
                  <c:v>-0.47081237949369759</c:v>
                </c:pt>
                <c:pt idx="10">
                  <c:v>-0.95664005318674006</c:v>
                </c:pt>
                <c:pt idx="11">
                  <c:v>11.491493587449099</c:v>
                </c:pt>
                <c:pt idx="12">
                  <c:v>10.872476862790394</c:v>
                </c:pt>
                <c:pt idx="13">
                  <c:v>-11.738201865428341</c:v>
                </c:pt>
                <c:pt idx="14">
                  <c:v>-1.0318970736458675</c:v>
                </c:pt>
                <c:pt idx="15">
                  <c:v>-0.57910103439525262</c:v>
                </c:pt>
                <c:pt idx="16">
                  <c:v>-1.4041579634685699</c:v>
                </c:pt>
                <c:pt idx="17">
                  <c:v>-1.6055346913983151</c:v>
                </c:pt>
                <c:pt idx="18">
                  <c:v>0.84983114072823818</c:v>
                </c:pt>
                <c:pt idx="19">
                  <c:v>3.3162307014123296</c:v>
                </c:pt>
                <c:pt idx="20">
                  <c:v>1.1536200080256371</c:v>
                </c:pt>
                <c:pt idx="21">
                  <c:v>0.27556952441139271</c:v>
                </c:pt>
                <c:pt idx="22">
                  <c:v>0.87503751049383249</c:v>
                </c:pt>
                <c:pt idx="23">
                  <c:v>-0.14098679281429943</c:v>
                </c:pt>
                <c:pt idx="24">
                  <c:v>-0.39802078723220657</c:v>
                </c:pt>
                <c:pt idx="25">
                  <c:v>0.62234190782294863</c:v>
                </c:pt>
                <c:pt idx="26">
                  <c:v>0.7672348208334353</c:v>
                </c:pt>
                <c:pt idx="27">
                  <c:v>1.1739409107378951</c:v>
                </c:pt>
                <c:pt idx="28">
                  <c:v>0.286149438226995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18E-4825-A017-5475784E9F69}"/>
            </c:ext>
          </c:extLst>
        </c:ser>
        <c:ser>
          <c:idx val="2"/>
          <c:order val="2"/>
          <c:tx>
            <c:strRef>
              <c:f>'solo trasformati'!$AD$2</c:f>
              <c:strCache>
                <c:ptCount val="1"/>
                <c:pt idx="0">
                  <c:v>12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solo trasformati'!$AA$3:$AA$31</c:f>
              <c:strCache>
                <c:ptCount val="29"/>
                <c:pt idx="0">
                  <c:v>phytoene</c:v>
                </c:pt>
                <c:pt idx="1">
                  <c:v>phytofluene</c:v>
                </c:pt>
                <c:pt idx="2">
                  <c:v>z-carotene</c:v>
                </c:pt>
                <c:pt idx="3">
                  <c:v>lycopene</c:v>
                </c:pt>
                <c:pt idx="4">
                  <c:v>a-carotene</c:v>
                </c:pt>
                <c:pt idx="5">
                  <c:v>lutein</c:v>
                </c:pt>
                <c:pt idx="6">
                  <c:v>g-carotene</c:v>
                </c:pt>
                <c:pt idx="7">
                  <c:v>b-carotene</c:v>
                </c:pt>
                <c:pt idx="8">
                  <c:v>violaxanthin</c:v>
                </c:pt>
                <c:pt idx="9">
                  <c:v>neoxanthin</c:v>
                </c:pt>
                <c:pt idx="10">
                  <c:v>luteoxanthin</c:v>
                </c:pt>
                <c:pt idx="11">
                  <c:v>chlorophyll_a</c:v>
                </c:pt>
                <c:pt idx="12">
                  <c:v>chlorophyll_b</c:v>
                </c:pt>
                <c:pt idx="13">
                  <c:v>chlorophyllide_b</c:v>
                </c:pt>
                <c:pt idx="14">
                  <c:v>pheophorbide_a</c:v>
                </c:pt>
                <c:pt idx="15">
                  <c:v>pheophorbide_b</c:v>
                </c:pt>
                <c:pt idx="16">
                  <c:v>pheophytin_a</c:v>
                </c:pt>
                <c:pt idx="17">
                  <c:v>pheophytin_b</c:v>
                </c:pt>
                <c:pt idx="18">
                  <c:v>a-tocopherol</c:v>
                </c:pt>
                <c:pt idx="19">
                  <c:v>a-tocotrienol</c:v>
                </c:pt>
                <c:pt idx="20">
                  <c:v>g-tocopherol/b-tocopherol</c:v>
                </c:pt>
                <c:pt idx="21">
                  <c:v>b-tocotrienol/g-tocotrienol</c:v>
                </c:pt>
                <c:pt idx="22">
                  <c:v>d-tocopherol</c:v>
                </c:pt>
                <c:pt idx="23">
                  <c:v>a-tocopherol-quinone</c:v>
                </c:pt>
                <c:pt idx="24">
                  <c:v>phylloquinone</c:v>
                </c:pt>
                <c:pt idx="25">
                  <c:v>plastoquinol-9</c:v>
                </c:pt>
                <c:pt idx="26">
                  <c:v>plastoquinone</c:v>
                </c:pt>
                <c:pt idx="27">
                  <c:v>ubiquinone_9</c:v>
                </c:pt>
                <c:pt idx="28">
                  <c:v>ubiquinone-10</c:v>
                </c:pt>
              </c:strCache>
            </c:strRef>
          </c:cat>
          <c:val>
            <c:numRef>
              <c:f>'solo trasformati'!$AD$3:$AD$31</c:f>
              <c:numCache>
                <c:formatCode>General</c:formatCode>
                <c:ptCount val="29"/>
                <c:pt idx="0">
                  <c:v>2.6504094865164491</c:v>
                </c:pt>
                <c:pt idx="1">
                  <c:v>1.3085490292633009</c:v>
                </c:pt>
                <c:pt idx="2">
                  <c:v>8.4340607348824665</c:v>
                </c:pt>
                <c:pt idx="3">
                  <c:v>3.0247218765094206</c:v>
                </c:pt>
                <c:pt idx="4">
                  <c:v>2.6220858105980094</c:v>
                </c:pt>
                <c:pt idx="5">
                  <c:v>1.2408235933532241</c:v>
                </c:pt>
                <c:pt idx="6">
                  <c:v>9.9320345929439</c:v>
                </c:pt>
                <c:pt idx="7">
                  <c:v>2.5589032920741976</c:v>
                </c:pt>
                <c:pt idx="8">
                  <c:v>-0.91032301276592076</c:v>
                </c:pt>
                <c:pt idx="9">
                  <c:v>-1.2453282952208189</c:v>
                </c:pt>
                <c:pt idx="10">
                  <c:v>-1.5402105330153932</c:v>
                </c:pt>
                <c:pt idx="11">
                  <c:v>11.814674931981376</c:v>
                </c:pt>
                <c:pt idx="12">
                  <c:v>10.700220530195224</c:v>
                </c:pt>
                <c:pt idx="13">
                  <c:v>-11.738201865428341</c:v>
                </c:pt>
                <c:pt idx="14">
                  <c:v>-1.4698144478826956</c:v>
                </c:pt>
                <c:pt idx="15">
                  <c:v>-8.9834856959188747E-2</c:v>
                </c:pt>
                <c:pt idx="16">
                  <c:v>-1.6205020617972719</c:v>
                </c:pt>
                <c:pt idx="17">
                  <c:v>-2.448772694423289</c:v>
                </c:pt>
                <c:pt idx="18">
                  <c:v>1.0144002615611791</c:v>
                </c:pt>
                <c:pt idx="19">
                  <c:v>-0.41462487969880257</c:v>
                </c:pt>
                <c:pt idx="20">
                  <c:v>1.8757166249470771</c:v>
                </c:pt>
                <c:pt idx="21">
                  <c:v>0.68968249193108289</c:v>
                </c:pt>
                <c:pt idx="22">
                  <c:v>1.5938185103189726</c:v>
                </c:pt>
                <c:pt idx="23">
                  <c:v>-0.72316529914981487</c:v>
                </c:pt>
                <c:pt idx="24">
                  <c:v>-6.8537279163792134E-3</c:v>
                </c:pt>
                <c:pt idx="25">
                  <c:v>1.2789991818402555</c:v>
                </c:pt>
                <c:pt idx="26">
                  <c:v>0.46781408325750168</c:v>
                </c:pt>
                <c:pt idx="27">
                  <c:v>0.38287416204241448</c:v>
                </c:pt>
                <c:pt idx="28">
                  <c:v>0.787564376506303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18E-4825-A017-5475784E9F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77338992"/>
        <c:axId val="152414768"/>
      </c:barChart>
      <c:catAx>
        <c:axId val="2773389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600" b="1" dirty="0"/>
                  <a:t>Compound</a:t>
                </a:r>
              </a:p>
            </c:rich>
          </c:tx>
          <c:layout>
            <c:manualLayout>
              <c:xMode val="edge"/>
              <c:yMode val="edge"/>
              <c:x val="0.4671036166633315"/>
              <c:y val="0.8704200382424002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52414768"/>
        <c:crosses val="autoZero"/>
        <c:auto val="1"/>
        <c:lblAlgn val="ctr"/>
        <c:lblOffset val="100"/>
        <c:noMultiLvlLbl val="0"/>
      </c:catAx>
      <c:valAx>
        <c:axId val="152414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600" b="1" dirty="0" err="1"/>
                  <a:t>Abundance</a:t>
                </a:r>
                <a:r>
                  <a:rPr lang="it-IT" sz="1600" b="1" dirty="0"/>
                  <a:t> relative to WT (log2)</a:t>
                </a:r>
              </a:p>
            </c:rich>
          </c:tx>
          <c:layout>
            <c:manualLayout>
              <c:xMode val="edge"/>
              <c:yMode val="edge"/>
              <c:x val="2.2651220814866726E-2"/>
              <c:y val="0.1622394487510766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2773389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delete val="1"/>
      </c:legendEntry>
      <c:layout>
        <c:manualLayout>
          <c:xMode val="edge"/>
          <c:yMode val="edge"/>
          <c:x val="0.18445918682020768"/>
          <c:y val="0.81114898419297377"/>
          <c:w val="0.18684225955801809"/>
          <c:h val="0.101447173691353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  <c:userShapes r:id="rId4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sz="3200" b="1" dirty="0"/>
              <a:t>Br+8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title>
    <c:autoTitleDeleted val="0"/>
    <c:plotArea>
      <c:layout>
        <c:manualLayout>
          <c:layoutTarget val="inner"/>
          <c:xMode val="edge"/>
          <c:yMode val="edge"/>
          <c:x val="6.4198512139685707E-2"/>
          <c:y val="0.13295746052828966"/>
          <c:w val="0.92302084900036563"/>
          <c:h val="0.5839120077209604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olo trasformati'!$AH$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solo trasformati'!$AG$3:$AG$31</c:f>
              <c:strCache>
                <c:ptCount val="29"/>
                <c:pt idx="0">
                  <c:v>phytoene</c:v>
                </c:pt>
                <c:pt idx="1">
                  <c:v>phytofluene</c:v>
                </c:pt>
                <c:pt idx="2">
                  <c:v>z-carotene</c:v>
                </c:pt>
                <c:pt idx="3">
                  <c:v>lycopene</c:v>
                </c:pt>
                <c:pt idx="4">
                  <c:v>a-carotene</c:v>
                </c:pt>
                <c:pt idx="5">
                  <c:v>lutein</c:v>
                </c:pt>
                <c:pt idx="6">
                  <c:v>g-carotene</c:v>
                </c:pt>
                <c:pt idx="7">
                  <c:v>b-carotene</c:v>
                </c:pt>
                <c:pt idx="8">
                  <c:v>violaxanthin</c:v>
                </c:pt>
                <c:pt idx="9">
                  <c:v>neoxanthin</c:v>
                </c:pt>
                <c:pt idx="10">
                  <c:v>luteoxanthin</c:v>
                </c:pt>
                <c:pt idx="11">
                  <c:v>chlorophyll_a</c:v>
                </c:pt>
                <c:pt idx="12">
                  <c:v>chlorophyll_b</c:v>
                </c:pt>
                <c:pt idx="13">
                  <c:v>chlorophyllide_b</c:v>
                </c:pt>
                <c:pt idx="14">
                  <c:v>pheophorbide_a</c:v>
                </c:pt>
                <c:pt idx="15">
                  <c:v>pheophorbide_b</c:v>
                </c:pt>
                <c:pt idx="16">
                  <c:v>pheophytin_a</c:v>
                </c:pt>
                <c:pt idx="17">
                  <c:v>pheophytin_b</c:v>
                </c:pt>
                <c:pt idx="18">
                  <c:v>a-tocopherol</c:v>
                </c:pt>
                <c:pt idx="19">
                  <c:v>a-tocotrienol</c:v>
                </c:pt>
                <c:pt idx="20">
                  <c:v>g-tocopherol/b-tocopherol</c:v>
                </c:pt>
                <c:pt idx="21">
                  <c:v>b-tocotrienol/g-tocotrienol</c:v>
                </c:pt>
                <c:pt idx="22">
                  <c:v>d-tocopherol</c:v>
                </c:pt>
                <c:pt idx="23">
                  <c:v>a-tocopherol-quinone</c:v>
                </c:pt>
                <c:pt idx="24">
                  <c:v>phylloquinone</c:v>
                </c:pt>
                <c:pt idx="25">
                  <c:v>plastoquinol-9</c:v>
                </c:pt>
                <c:pt idx="26">
                  <c:v>plastoquinone</c:v>
                </c:pt>
                <c:pt idx="27">
                  <c:v>ubiquinone_9</c:v>
                </c:pt>
                <c:pt idx="28">
                  <c:v>ubiquinone-10</c:v>
                </c:pt>
              </c:strCache>
            </c:strRef>
          </c:cat>
          <c:val>
            <c:numRef>
              <c:f>'solo trasformati'!$AH$3:$AH$31</c:f>
              <c:numCache>
                <c:formatCode>General</c:formatCode>
                <c:ptCount val="2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980-44B9-97B7-C5F6B87AE250}"/>
            </c:ext>
          </c:extLst>
        </c:ser>
        <c:ser>
          <c:idx val="1"/>
          <c:order val="1"/>
          <c:tx>
            <c:strRef>
              <c:f>'solo trasformati'!$AI$2</c:f>
              <c:strCache>
                <c:ptCount val="1"/>
                <c:pt idx="0">
                  <c:v>2B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solo trasformati'!$AG$3:$AG$31</c:f>
              <c:strCache>
                <c:ptCount val="29"/>
                <c:pt idx="0">
                  <c:v>phytoene</c:v>
                </c:pt>
                <c:pt idx="1">
                  <c:v>phytofluene</c:v>
                </c:pt>
                <c:pt idx="2">
                  <c:v>z-carotene</c:v>
                </c:pt>
                <c:pt idx="3">
                  <c:v>lycopene</c:v>
                </c:pt>
                <c:pt idx="4">
                  <c:v>a-carotene</c:v>
                </c:pt>
                <c:pt idx="5">
                  <c:v>lutein</c:v>
                </c:pt>
                <c:pt idx="6">
                  <c:v>g-carotene</c:v>
                </c:pt>
                <c:pt idx="7">
                  <c:v>b-carotene</c:v>
                </c:pt>
                <c:pt idx="8">
                  <c:v>violaxanthin</c:v>
                </c:pt>
                <c:pt idx="9">
                  <c:v>neoxanthin</c:v>
                </c:pt>
                <c:pt idx="10">
                  <c:v>luteoxanthin</c:v>
                </c:pt>
                <c:pt idx="11">
                  <c:v>chlorophyll_a</c:v>
                </c:pt>
                <c:pt idx="12">
                  <c:v>chlorophyll_b</c:v>
                </c:pt>
                <c:pt idx="13">
                  <c:v>chlorophyllide_b</c:v>
                </c:pt>
                <c:pt idx="14">
                  <c:v>pheophorbide_a</c:v>
                </c:pt>
                <c:pt idx="15">
                  <c:v>pheophorbide_b</c:v>
                </c:pt>
                <c:pt idx="16">
                  <c:v>pheophytin_a</c:v>
                </c:pt>
                <c:pt idx="17">
                  <c:v>pheophytin_b</c:v>
                </c:pt>
                <c:pt idx="18">
                  <c:v>a-tocopherol</c:v>
                </c:pt>
                <c:pt idx="19">
                  <c:v>a-tocotrienol</c:v>
                </c:pt>
                <c:pt idx="20">
                  <c:v>g-tocopherol/b-tocopherol</c:v>
                </c:pt>
                <c:pt idx="21">
                  <c:v>b-tocotrienol/g-tocotrienol</c:v>
                </c:pt>
                <c:pt idx="22">
                  <c:v>d-tocopherol</c:v>
                </c:pt>
                <c:pt idx="23">
                  <c:v>a-tocopherol-quinone</c:v>
                </c:pt>
                <c:pt idx="24">
                  <c:v>phylloquinone</c:v>
                </c:pt>
                <c:pt idx="25">
                  <c:v>plastoquinol-9</c:v>
                </c:pt>
                <c:pt idx="26">
                  <c:v>plastoquinone</c:v>
                </c:pt>
                <c:pt idx="27">
                  <c:v>ubiquinone_9</c:v>
                </c:pt>
                <c:pt idx="28">
                  <c:v>ubiquinone-10</c:v>
                </c:pt>
              </c:strCache>
            </c:strRef>
          </c:cat>
          <c:val>
            <c:numRef>
              <c:f>'solo trasformati'!$AI$3:$AI$31</c:f>
              <c:numCache>
                <c:formatCode>General</c:formatCode>
                <c:ptCount val="29"/>
                <c:pt idx="0">
                  <c:v>1.7195170641408062</c:v>
                </c:pt>
                <c:pt idx="1">
                  <c:v>1.4525064035123332</c:v>
                </c:pt>
                <c:pt idx="2">
                  <c:v>-0.40097806651031948</c:v>
                </c:pt>
                <c:pt idx="3">
                  <c:v>1.6409915700125286</c:v>
                </c:pt>
                <c:pt idx="4">
                  <c:v>-0.2309102675573261</c:v>
                </c:pt>
                <c:pt idx="5">
                  <c:v>-0.26326412506972507</c:v>
                </c:pt>
                <c:pt idx="6">
                  <c:v>0.63261423992650467</c:v>
                </c:pt>
                <c:pt idx="7">
                  <c:v>0.77165607755996102</c:v>
                </c:pt>
                <c:pt idx="8">
                  <c:v>-7.6257957224032683E-2</c:v>
                </c:pt>
                <c:pt idx="9">
                  <c:v>0.10856987675332014</c:v>
                </c:pt>
                <c:pt idx="10">
                  <c:v>-0.22693205082675627</c:v>
                </c:pt>
                <c:pt idx="11">
                  <c:v>10.696955386668899</c:v>
                </c:pt>
                <c:pt idx="12">
                  <c:v>10.408584145015652</c:v>
                </c:pt>
                <c:pt idx="13">
                  <c:v>0</c:v>
                </c:pt>
                <c:pt idx="14">
                  <c:v>-0.25437101082719898</c:v>
                </c:pt>
                <c:pt idx="15">
                  <c:v>7.812146793453377E-2</c:v>
                </c:pt>
                <c:pt idx="16">
                  <c:v>-0.61997588170262863</c:v>
                </c:pt>
                <c:pt idx="17">
                  <c:v>-7.8820928403500093E-2</c:v>
                </c:pt>
                <c:pt idx="18">
                  <c:v>2.2462043499248061</c:v>
                </c:pt>
                <c:pt idx="19">
                  <c:v>1.0199852352992138</c:v>
                </c:pt>
                <c:pt idx="20">
                  <c:v>1.070198839089169</c:v>
                </c:pt>
                <c:pt idx="21">
                  <c:v>1.0859391161431255</c:v>
                </c:pt>
                <c:pt idx="22">
                  <c:v>1.4945054000596192</c:v>
                </c:pt>
                <c:pt idx="23">
                  <c:v>-0.39465322783210266</c:v>
                </c:pt>
                <c:pt idx="24">
                  <c:v>-0.12849509820871247</c:v>
                </c:pt>
                <c:pt idx="25">
                  <c:v>-0.30869903600548204</c:v>
                </c:pt>
                <c:pt idx="26">
                  <c:v>-1.8362134860435677</c:v>
                </c:pt>
                <c:pt idx="27">
                  <c:v>-1.3000521884558436</c:v>
                </c:pt>
                <c:pt idx="28">
                  <c:v>-0.414853525994847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980-44B9-97B7-C5F6B87AE250}"/>
            </c:ext>
          </c:extLst>
        </c:ser>
        <c:ser>
          <c:idx val="2"/>
          <c:order val="2"/>
          <c:tx>
            <c:strRef>
              <c:f>'solo trasformati'!$AJ$2</c:f>
              <c:strCache>
                <c:ptCount val="1"/>
                <c:pt idx="0">
                  <c:v> 12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solo trasformati'!$AG$3:$AG$31</c:f>
              <c:strCache>
                <c:ptCount val="29"/>
                <c:pt idx="0">
                  <c:v>phytoene</c:v>
                </c:pt>
                <c:pt idx="1">
                  <c:v>phytofluene</c:v>
                </c:pt>
                <c:pt idx="2">
                  <c:v>z-carotene</c:v>
                </c:pt>
                <c:pt idx="3">
                  <c:v>lycopene</c:v>
                </c:pt>
                <c:pt idx="4">
                  <c:v>a-carotene</c:v>
                </c:pt>
                <c:pt idx="5">
                  <c:v>lutein</c:v>
                </c:pt>
                <c:pt idx="6">
                  <c:v>g-carotene</c:v>
                </c:pt>
                <c:pt idx="7">
                  <c:v>b-carotene</c:v>
                </c:pt>
                <c:pt idx="8">
                  <c:v>violaxanthin</c:v>
                </c:pt>
                <c:pt idx="9">
                  <c:v>neoxanthin</c:v>
                </c:pt>
                <c:pt idx="10">
                  <c:v>luteoxanthin</c:v>
                </c:pt>
                <c:pt idx="11">
                  <c:v>chlorophyll_a</c:v>
                </c:pt>
                <c:pt idx="12">
                  <c:v>chlorophyll_b</c:v>
                </c:pt>
                <c:pt idx="13">
                  <c:v>chlorophyllide_b</c:v>
                </c:pt>
                <c:pt idx="14">
                  <c:v>pheophorbide_a</c:v>
                </c:pt>
                <c:pt idx="15">
                  <c:v>pheophorbide_b</c:v>
                </c:pt>
                <c:pt idx="16">
                  <c:v>pheophytin_a</c:v>
                </c:pt>
                <c:pt idx="17">
                  <c:v>pheophytin_b</c:v>
                </c:pt>
                <c:pt idx="18">
                  <c:v>a-tocopherol</c:v>
                </c:pt>
                <c:pt idx="19">
                  <c:v>a-tocotrienol</c:v>
                </c:pt>
                <c:pt idx="20">
                  <c:v>g-tocopherol/b-tocopherol</c:v>
                </c:pt>
                <c:pt idx="21">
                  <c:v>b-tocotrienol/g-tocotrienol</c:v>
                </c:pt>
                <c:pt idx="22">
                  <c:v>d-tocopherol</c:v>
                </c:pt>
                <c:pt idx="23">
                  <c:v>a-tocopherol-quinone</c:v>
                </c:pt>
                <c:pt idx="24">
                  <c:v>phylloquinone</c:v>
                </c:pt>
                <c:pt idx="25">
                  <c:v>plastoquinol-9</c:v>
                </c:pt>
                <c:pt idx="26">
                  <c:v>plastoquinone</c:v>
                </c:pt>
                <c:pt idx="27">
                  <c:v>ubiquinone_9</c:v>
                </c:pt>
                <c:pt idx="28">
                  <c:v>ubiquinone-10</c:v>
                </c:pt>
              </c:strCache>
            </c:strRef>
          </c:cat>
          <c:val>
            <c:numRef>
              <c:f>'solo trasformati'!$AJ$3:$AJ$31</c:f>
              <c:numCache>
                <c:formatCode>General</c:formatCode>
                <c:ptCount val="29"/>
                <c:pt idx="0">
                  <c:v>1.412170344814472</c:v>
                </c:pt>
                <c:pt idx="1">
                  <c:v>1.0989339221020515</c:v>
                </c:pt>
                <c:pt idx="2">
                  <c:v>-0.14958353630545165</c:v>
                </c:pt>
                <c:pt idx="3">
                  <c:v>1.3391973085536872</c:v>
                </c:pt>
                <c:pt idx="4">
                  <c:v>-0.20364487978463802</c:v>
                </c:pt>
                <c:pt idx="5">
                  <c:v>-0.5037857374999154</c:v>
                </c:pt>
                <c:pt idx="6">
                  <c:v>0.17747812228578325</c:v>
                </c:pt>
                <c:pt idx="7">
                  <c:v>0.69152133419012385</c:v>
                </c:pt>
                <c:pt idx="8">
                  <c:v>-0.55404154049297916</c:v>
                </c:pt>
                <c:pt idx="9">
                  <c:v>-0.35635235506399737</c:v>
                </c:pt>
                <c:pt idx="10">
                  <c:v>1.4034598623239218E-2</c:v>
                </c:pt>
                <c:pt idx="11">
                  <c:v>11.22803864697155</c:v>
                </c:pt>
                <c:pt idx="12">
                  <c:v>10.73003181638429</c:v>
                </c:pt>
                <c:pt idx="13">
                  <c:v>0</c:v>
                </c:pt>
                <c:pt idx="14">
                  <c:v>-0.90331883899178145</c:v>
                </c:pt>
                <c:pt idx="15">
                  <c:v>-0.5860822116281752</c:v>
                </c:pt>
                <c:pt idx="16">
                  <c:v>-1.2137127608489726</c:v>
                </c:pt>
                <c:pt idx="17">
                  <c:v>-0.67790332832409639</c:v>
                </c:pt>
                <c:pt idx="18">
                  <c:v>2.2537114424271496</c:v>
                </c:pt>
                <c:pt idx="19">
                  <c:v>1.1184918042874374</c:v>
                </c:pt>
                <c:pt idx="20">
                  <c:v>0.99458942269441275</c:v>
                </c:pt>
                <c:pt idx="21">
                  <c:v>-14.767391085212541</c:v>
                </c:pt>
                <c:pt idx="22">
                  <c:v>1.0890910014381063</c:v>
                </c:pt>
                <c:pt idx="23">
                  <c:v>9.3766886818151568E-2</c:v>
                </c:pt>
                <c:pt idx="24">
                  <c:v>0.20086122759976824</c:v>
                </c:pt>
                <c:pt idx="25">
                  <c:v>-0.25224594298405584</c:v>
                </c:pt>
                <c:pt idx="26">
                  <c:v>-0.94585561272819396</c:v>
                </c:pt>
                <c:pt idx="27">
                  <c:v>-0.85102015970102085</c:v>
                </c:pt>
                <c:pt idx="28">
                  <c:v>-0.380801355184577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980-44B9-97B7-C5F6B87AE2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68037664"/>
        <c:axId val="149981776"/>
      </c:barChart>
      <c:catAx>
        <c:axId val="2680376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600" b="1" dirty="0"/>
                  <a:t>Compound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49981776"/>
        <c:crosses val="autoZero"/>
        <c:auto val="1"/>
        <c:lblAlgn val="ctr"/>
        <c:lblOffset val="100"/>
        <c:noMultiLvlLbl val="0"/>
      </c:catAx>
      <c:valAx>
        <c:axId val="1499817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600" b="1" noProof="0" dirty="0"/>
                  <a:t>Abundance</a:t>
                </a:r>
                <a:r>
                  <a:rPr lang="it-IT" sz="1600" b="1" dirty="0"/>
                  <a:t> relative to WT (log2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2680376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delete val="1"/>
      </c:legendEntry>
      <c:layout>
        <c:manualLayout>
          <c:xMode val="edge"/>
          <c:yMode val="edge"/>
          <c:x val="0.21722584934984332"/>
          <c:y val="0.85506416757333914"/>
          <c:w val="0.17195818214282271"/>
          <c:h val="5.474490871122861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5208</cdr:x>
      <cdr:y>0.24484</cdr:y>
    </cdr:from>
    <cdr:to>
      <cdr:x>0.16386</cdr:x>
      <cdr:y>0.26394</cdr:y>
    </cdr:to>
    <cdr:sp macro="" textlink="">
      <cdr:nvSpPr>
        <cdr:cNvPr id="2" name="CasellaDiTesto 1">
          <a:extLst xmlns:a="http://schemas.openxmlformats.org/drawingml/2006/main">
            <a:ext uri="{FF2B5EF4-FFF2-40B4-BE49-F238E27FC236}">
              <a16:creationId xmlns:a16="http://schemas.microsoft.com/office/drawing/2014/main" id="{66F89F7C-4411-49C6-8740-14BB2A0F45D7}"/>
            </a:ext>
          </a:extLst>
        </cdr:cNvPr>
        <cdr:cNvSpPr txBox="1"/>
      </cdr:nvSpPr>
      <cdr:spPr>
        <a:xfrm xmlns:a="http://schemas.openxmlformats.org/drawingml/2006/main">
          <a:off x="1711570" y="152930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5998</cdr:x>
      <cdr:y>0.24078</cdr:y>
    </cdr:from>
    <cdr:to>
      <cdr:x>0.17176</cdr:x>
      <cdr:y>0.25987</cdr:y>
    </cdr:to>
    <cdr:sp macro="" textlink="">
      <cdr:nvSpPr>
        <cdr:cNvPr id="3" name="CasellaDiTesto 1">
          <a:extLst xmlns:a="http://schemas.openxmlformats.org/drawingml/2006/main">
            <a:ext uri="{FF2B5EF4-FFF2-40B4-BE49-F238E27FC236}">
              <a16:creationId xmlns:a16="http://schemas.microsoft.com/office/drawing/2014/main" id="{52267F9B-B3D0-4C06-A3FC-F11DDD1E0D6B}"/>
            </a:ext>
          </a:extLst>
        </cdr:cNvPr>
        <cdr:cNvSpPr txBox="1"/>
      </cdr:nvSpPr>
      <cdr:spPr>
        <a:xfrm xmlns:a="http://schemas.openxmlformats.org/drawingml/2006/main">
          <a:off x="1800470" y="150390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8537</cdr:x>
      <cdr:y>0.5</cdr:y>
    </cdr:from>
    <cdr:to>
      <cdr:x>0.19715</cdr:x>
      <cdr:y>0.5191</cdr:y>
    </cdr:to>
    <cdr:sp macro="" textlink="">
      <cdr:nvSpPr>
        <cdr:cNvPr id="4" name="CasellaDiTesto 1">
          <a:extLst xmlns:a="http://schemas.openxmlformats.org/drawingml/2006/main">
            <a:ext uri="{FF2B5EF4-FFF2-40B4-BE49-F238E27FC236}">
              <a16:creationId xmlns:a16="http://schemas.microsoft.com/office/drawing/2014/main" id="{52267F9B-B3D0-4C06-A3FC-F11DDD1E0D6B}"/>
            </a:ext>
          </a:extLst>
        </cdr:cNvPr>
        <cdr:cNvSpPr txBox="1"/>
      </cdr:nvSpPr>
      <cdr:spPr>
        <a:xfrm xmlns:a="http://schemas.openxmlformats.org/drawingml/2006/main">
          <a:off x="2086220" y="3123027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9214</cdr:x>
      <cdr:y>0.5</cdr:y>
    </cdr:from>
    <cdr:to>
      <cdr:x>0.20392</cdr:x>
      <cdr:y>0.5191</cdr:y>
    </cdr:to>
    <cdr:sp macro="" textlink="">
      <cdr:nvSpPr>
        <cdr:cNvPr id="5" name="CasellaDiTesto 1">
          <a:extLst xmlns:a="http://schemas.openxmlformats.org/drawingml/2006/main">
            <a:ext uri="{FF2B5EF4-FFF2-40B4-BE49-F238E27FC236}">
              <a16:creationId xmlns:a16="http://schemas.microsoft.com/office/drawing/2014/main" id="{52267F9B-B3D0-4C06-A3FC-F11DDD1E0D6B}"/>
            </a:ext>
          </a:extLst>
        </cdr:cNvPr>
        <cdr:cNvSpPr txBox="1"/>
      </cdr:nvSpPr>
      <cdr:spPr>
        <a:xfrm xmlns:a="http://schemas.openxmlformats.org/drawingml/2006/main">
          <a:off x="2162420" y="3123027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497</cdr:x>
      <cdr:y>0.31855</cdr:y>
    </cdr:from>
    <cdr:to>
      <cdr:x>0.26147</cdr:x>
      <cdr:y>0.33764</cdr:y>
    </cdr:to>
    <cdr:sp macro="" textlink="">
      <cdr:nvSpPr>
        <cdr:cNvPr id="6" name="CasellaDiTesto 1">
          <a:extLst xmlns:a="http://schemas.openxmlformats.org/drawingml/2006/main">
            <a:ext uri="{FF2B5EF4-FFF2-40B4-BE49-F238E27FC236}">
              <a16:creationId xmlns:a16="http://schemas.microsoft.com/office/drawing/2014/main" id="{52267F9B-B3D0-4C06-A3FC-F11DDD1E0D6B}"/>
            </a:ext>
          </a:extLst>
        </cdr:cNvPr>
        <cdr:cNvSpPr txBox="1"/>
      </cdr:nvSpPr>
      <cdr:spPr>
        <a:xfrm xmlns:a="http://schemas.openxmlformats.org/drawingml/2006/main">
          <a:off x="2810120" y="198967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5675</cdr:x>
      <cdr:y>0.38006</cdr:y>
    </cdr:from>
    <cdr:to>
      <cdr:x>0.26852</cdr:x>
      <cdr:y>0.39915</cdr:y>
    </cdr:to>
    <cdr:sp macro="" textlink="">
      <cdr:nvSpPr>
        <cdr:cNvPr id="7" name="CasellaDiTesto 1">
          <a:extLst xmlns:a="http://schemas.openxmlformats.org/drawingml/2006/main">
            <a:ext uri="{FF2B5EF4-FFF2-40B4-BE49-F238E27FC236}">
              <a16:creationId xmlns:a16="http://schemas.microsoft.com/office/drawing/2014/main" id="{7EA37C81-96B5-4673-A29A-ABA1F5F33A10}"/>
            </a:ext>
          </a:extLst>
        </cdr:cNvPr>
        <cdr:cNvSpPr txBox="1"/>
      </cdr:nvSpPr>
      <cdr:spPr>
        <a:xfrm xmlns:a="http://schemas.openxmlformats.org/drawingml/2006/main">
          <a:off x="2889495" y="237385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8218</cdr:x>
      <cdr:y>0.45877</cdr:y>
    </cdr:from>
    <cdr:to>
      <cdr:x>0.29396</cdr:x>
      <cdr:y>0.47787</cdr:y>
    </cdr:to>
    <cdr:sp macro="" textlink="">
      <cdr:nvSpPr>
        <cdr:cNvPr id="8" name="CasellaDiTesto 1">
          <a:extLst xmlns:a="http://schemas.openxmlformats.org/drawingml/2006/main">
            <a:ext uri="{FF2B5EF4-FFF2-40B4-BE49-F238E27FC236}">
              <a16:creationId xmlns:a16="http://schemas.microsoft.com/office/drawing/2014/main" id="{7EA37C81-96B5-4673-A29A-ABA1F5F33A10}"/>
            </a:ext>
          </a:extLst>
        </cdr:cNvPr>
        <cdr:cNvSpPr txBox="1"/>
      </cdr:nvSpPr>
      <cdr:spPr>
        <a:xfrm xmlns:a="http://schemas.openxmlformats.org/drawingml/2006/main">
          <a:off x="3175673" y="2865496"/>
          <a:ext cx="132574" cy="119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5323</cdr:x>
      <cdr:y>0.45913</cdr:y>
    </cdr:from>
    <cdr:to>
      <cdr:x>0.36501</cdr:x>
      <cdr:y>0.47823</cdr:y>
    </cdr:to>
    <cdr:sp macro="" textlink="">
      <cdr:nvSpPr>
        <cdr:cNvPr id="9" name="CasellaDiTesto 1">
          <a:extLst xmlns:a="http://schemas.openxmlformats.org/drawingml/2006/main">
            <a:ext uri="{FF2B5EF4-FFF2-40B4-BE49-F238E27FC236}">
              <a16:creationId xmlns:a16="http://schemas.microsoft.com/office/drawing/2014/main" id="{7EA37C81-96B5-4673-A29A-ABA1F5F33A10}"/>
            </a:ext>
          </a:extLst>
        </cdr:cNvPr>
        <cdr:cNvSpPr txBox="1"/>
      </cdr:nvSpPr>
      <cdr:spPr>
        <a:xfrm xmlns:a="http://schemas.openxmlformats.org/drawingml/2006/main">
          <a:off x="3975345" y="286777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1079</cdr:x>
      <cdr:y>0.45935</cdr:y>
    </cdr:from>
    <cdr:to>
      <cdr:x>0.42256</cdr:x>
      <cdr:y>0.47845</cdr:y>
    </cdr:to>
    <cdr:sp macro="" textlink="">
      <cdr:nvSpPr>
        <cdr:cNvPr id="10" name="CasellaDiTesto 1">
          <a:extLst xmlns:a="http://schemas.openxmlformats.org/drawingml/2006/main">
            <a:ext uri="{FF2B5EF4-FFF2-40B4-BE49-F238E27FC236}">
              <a16:creationId xmlns:a16="http://schemas.microsoft.com/office/drawing/2014/main" id="{7EA37C81-96B5-4673-A29A-ABA1F5F33A10}"/>
            </a:ext>
          </a:extLst>
        </cdr:cNvPr>
        <cdr:cNvSpPr txBox="1"/>
      </cdr:nvSpPr>
      <cdr:spPr>
        <a:xfrm xmlns:a="http://schemas.openxmlformats.org/drawingml/2006/main">
          <a:off x="4623045" y="286915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4295</cdr:x>
      <cdr:y>0.45783</cdr:y>
    </cdr:from>
    <cdr:to>
      <cdr:x>0.45472</cdr:x>
      <cdr:y>0.47692</cdr:y>
    </cdr:to>
    <cdr:sp macro="" textlink="">
      <cdr:nvSpPr>
        <cdr:cNvPr id="11" name="CasellaDiTesto 1">
          <a:extLst xmlns:a="http://schemas.openxmlformats.org/drawingml/2006/main">
            <a:ext uri="{FF2B5EF4-FFF2-40B4-BE49-F238E27FC236}">
              <a16:creationId xmlns:a16="http://schemas.microsoft.com/office/drawing/2014/main" id="{7EA37C81-96B5-4673-A29A-ABA1F5F33A10}"/>
            </a:ext>
          </a:extLst>
        </cdr:cNvPr>
        <cdr:cNvSpPr txBox="1"/>
      </cdr:nvSpPr>
      <cdr:spPr>
        <a:xfrm xmlns:a="http://schemas.openxmlformats.org/drawingml/2006/main">
          <a:off x="4984995" y="285962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8188</cdr:x>
      <cdr:y>0.72927</cdr:y>
    </cdr:from>
    <cdr:to>
      <cdr:x>0.49365</cdr:x>
      <cdr:y>0.74837</cdr:y>
    </cdr:to>
    <cdr:sp macro="" textlink="">
      <cdr:nvSpPr>
        <cdr:cNvPr id="12" name="CasellaDiTesto 1">
          <a:extLst xmlns:a="http://schemas.openxmlformats.org/drawingml/2006/main">
            <a:ext uri="{FF2B5EF4-FFF2-40B4-BE49-F238E27FC236}">
              <a16:creationId xmlns:a16="http://schemas.microsoft.com/office/drawing/2014/main" id="{7EA37C81-96B5-4673-A29A-ABA1F5F33A10}"/>
            </a:ext>
          </a:extLst>
        </cdr:cNvPr>
        <cdr:cNvSpPr txBox="1"/>
      </cdr:nvSpPr>
      <cdr:spPr>
        <a:xfrm xmlns:a="http://schemas.openxmlformats.org/drawingml/2006/main">
          <a:off x="5423145" y="455507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046</cdr:x>
      <cdr:y>0.5</cdr:y>
    </cdr:from>
    <cdr:to>
      <cdr:x>0.61638</cdr:x>
      <cdr:y>0.5191</cdr:y>
    </cdr:to>
    <cdr:sp macro="" textlink="">
      <cdr:nvSpPr>
        <cdr:cNvPr id="13" name="CasellaDiTesto 1">
          <a:extLst xmlns:a="http://schemas.openxmlformats.org/drawingml/2006/main">
            <a:ext uri="{FF2B5EF4-FFF2-40B4-BE49-F238E27FC236}">
              <a16:creationId xmlns:a16="http://schemas.microsoft.com/office/drawing/2014/main" id="{7EA37C81-96B5-4673-A29A-ABA1F5F33A10}"/>
            </a:ext>
          </a:extLst>
        </cdr:cNvPr>
        <cdr:cNvSpPr txBox="1"/>
      </cdr:nvSpPr>
      <cdr:spPr>
        <a:xfrm xmlns:a="http://schemas.openxmlformats.org/drawingml/2006/main">
          <a:off x="6804270" y="3123027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4353</cdr:x>
      <cdr:y>0.45935</cdr:y>
    </cdr:from>
    <cdr:to>
      <cdr:x>0.65531</cdr:x>
      <cdr:y>0.47845</cdr:y>
    </cdr:to>
    <cdr:sp macro="" textlink="">
      <cdr:nvSpPr>
        <cdr:cNvPr id="14" name="CasellaDiTesto 1">
          <a:extLst xmlns:a="http://schemas.openxmlformats.org/drawingml/2006/main">
            <a:ext uri="{FF2B5EF4-FFF2-40B4-BE49-F238E27FC236}">
              <a16:creationId xmlns:a16="http://schemas.microsoft.com/office/drawing/2014/main" id="{7EA37C81-96B5-4673-A29A-ABA1F5F33A10}"/>
            </a:ext>
          </a:extLst>
        </cdr:cNvPr>
        <cdr:cNvSpPr txBox="1"/>
      </cdr:nvSpPr>
      <cdr:spPr>
        <a:xfrm xmlns:a="http://schemas.openxmlformats.org/drawingml/2006/main">
          <a:off x="7242420" y="286915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087</cdr:x>
      <cdr:y>0.45688</cdr:y>
    </cdr:from>
    <cdr:to>
      <cdr:x>0.71999</cdr:x>
      <cdr:y>0.47235</cdr:y>
    </cdr:to>
    <cdr:sp macro="" textlink="">
      <cdr:nvSpPr>
        <cdr:cNvPr id="15" name="CasellaDiTesto 1">
          <a:extLst xmlns:a="http://schemas.openxmlformats.org/drawingml/2006/main">
            <a:ext uri="{FF2B5EF4-FFF2-40B4-BE49-F238E27FC236}">
              <a16:creationId xmlns:a16="http://schemas.microsoft.com/office/drawing/2014/main" id="{7EA37C81-96B5-4673-A29A-ABA1F5F33A10}"/>
            </a:ext>
          </a:extLst>
        </cdr:cNvPr>
        <cdr:cNvSpPr txBox="1"/>
      </cdr:nvSpPr>
      <cdr:spPr>
        <a:xfrm xmlns:a="http://schemas.openxmlformats.org/drawingml/2006/main">
          <a:off x="7975845" y="2853691"/>
          <a:ext cx="127000" cy="966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6547</cdr:x>
      <cdr:y>0.45953</cdr:y>
    </cdr:from>
    <cdr:to>
      <cdr:x>0.77725</cdr:x>
      <cdr:y>0.47863</cdr:y>
    </cdr:to>
    <cdr:sp macro="" textlink="">
      <cdr:nvSpPr>
        <cdr:cNvPr id="16" name="CasellaDiTesto 1">
          <a:extLst xmlns:a="http://schemas.openxmlformats.org/drawingml/2006/main">
            <a:ext uri="{FF2B5EF4-FFF2-40B4-BE49-F238E27FC236}">
              <a16:creationId xmlns:a16="http://schemas.microsoft.com/office/drawing/2014/main" id="{7EA37C81-96B5-4673-A29A-ABA1F5F33A10}"/>
            </a:ext>
          </a:extLst>
        </cdr:cNvPr>
        <cdr:cNvSpPr txBox="1"/>
      </cdr:nvSpPr>
      <cdr:spPr>
        <a:xfrm xmlns:a="http://schemas.openxmlformats.org/drawingml/2006/main">
          <a:off x="8614681" y="2870226"/>
          <a:ext cx="132574" cy="119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7303</cdr:x>
      <cdr:y>0.45935</cdr:y>
    </cdr:from>
    <cdr:to>
      <cdr:x>0.7848</cdr:x>
      <cdr:y>0.47845</cdr:y>
    </cdr:to>
    <cdr:sp macro="" textlink="">
      <cdr:nvSpPr>
        <cdr:cNvPr id="17" name="CasellaDiTesto 1">
          <a:extLst xmlns:a="http://schemas.openxmlformats.org/drawingml/2006/main">
            <a:ext uri="{FF2B5EF4-FFF2-40B4-BE49-F238E27FC236}">
              <a16:creationId xmlns:a16="http://schemas.microsoft.com/office/drawing/2014/main" id="{7EA37C81-96B5-4673-A29A-ABA1F5F33A10}"/>
            </a:ext>
          </a:extLst>
        </cdr:cNvPr>
        <cdr:cNvSpPr txBox="1"/>
      </cdr:nvSpPr>
      <cdr:spPr>
        <a:xfrm xmlns:a="http://schemas.openxmlformats.org/drawingml/2006/main">
          <a:off x="8699745" y="286915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9757</cdr:x>
      <cdr:y>0.45935</cdr:y>
    </cdr:from>
    <cdr:to>
      <cdr:x>0.80934</cdr:x>
      <cdr:y>0.47845</cdr:y>
    </cdr:to>
    <cdr:sp macro="" textlink="">
      <cdr:nvSpPr>
        <cdr:cNvPr id="18" name="CasellaDiTesto 1">
          <a:extLst xmlns:a="http://schemas.openxmlformats.org/drawingml/2006/main">
            <a:ext uri="{FF2B5EF4-FFF2-40B4-BE49-F238E27FC236}">
              <a16:creationId xmlns:a16="http://schemas.microsoft.com/office/drawing/2014/main" id="{7EA37C81-96B5-4673-A29A-ABA1F5F33A10}"/>
            </a:ext>
          </a:extLst>
        </cdr:cNvPr>
        <cdr:cNvSpPr txBox="1"/>
      </cdr:nvSpPr>
      <cdr:spPr>
        <a:xfrm xmlns:a="http://schemas.openxmlformats.org/drawingml/2006/main">
          <a:off x="8975970" y="286915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80519</cdr:x>
      <cdr:y>0.45173</cdr:y>
    </cdr:from>
    <cdr:to>
      <cdr:x>0.81696</cdr:x>
      <cdr:y>0.47082</cdr:y>
    </cdr:to>
    <cdr:sp macro="" textlink="">
      <cdr:nvSpPr>
        <cdr:cNvPr id="19" name="CasellaDiTesto 1">
          <a:extLst xmlns:a="http://schemas.openxmlformats.org/drawingml/2006/main">
            <a:ext uri="{FF2B5EF4-FFF2-40B4-BE49-F238E27FC236}">
              <a16:creationId xmlns:a16="http://schemas.microsoft.com/office/drawing/2014/main" id="{7EA37C81-96B5-4673-A29A-ABA1F5F33A10}"/>
            </a:ext>
          </a:extLst>
        </cdr:cNvPr>
        <cdr:cNvSpPr txBox="1"/>
      </cdr:nvSpPr>
      <cdr:spPr>
        <a:xfrm xmlns:a="http://schemas.openxmlformats.org/drawingml/2006/main">
          <a:off x="9061695" y="282152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83142</cdr:x>
      <cdr:y>0.5</cdr:y>
    </cdr:from>
    <cdr:to>
      <cdr:x>0.8432</cdr:x>
      <cdr:y>0.5191</cdr:y>
    </cdr:to>
    <cdr:sp macro="" textlink="">
      <cdr:nvSpPr>
        <cdr:cNvPr id="20" name="CasellaDiTesto 1">
          <a:extLst xmlns:a="http://schemas.openxmlformats.org/drawingml/2006/main">
            <a:ext uri="{FF2B5EF4-FFF2-40B4-BE49-F238E27FC236}">
              <a16:creationId xmlns:a16="http://schemas.microsoft.com/office/drawing/2014/main" id="{7EA37C81-96B5-4673-A29A-ABA1F5F33A10}"/>
            </a:ext>
          </a:extLst>
        </cdr:cNvPr>
        <cdr:cNvSpPr txBox="1"/>
      </cdr:nvSpPr>
      <cdr:spPr>
        <a:xfrm xmlns:a="http://schemas.openxmlformats.org/drawingml/2006/main">
          <a:off x="9356970" y="3123027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it-IT" sz="1100" dirty="0"/>
        </a:p>
      </cdr:txBody>
    </cdr:sp>
  </cdr:relSizeAnchor>
  <cdr:relSizeAnchor xmlns:cdr="http://schemas.openxmlformats.org/drawingml/2006/chartDrawing">
    <cdr:from>
      <cdr:x>0.8949</cdr:x>
      <cdr:y>0.4563</cdr:y>
    </cdr:from>
    <cdr:to>
      <cdr:x>0.90668</cdr:x>
      <cdr:y>0.4754</cdr:y>
    </cdr:to>
    <cdr:sp macro="" textlink="">
      <cdr:nvSpPr>
        <cdr:cNvPr id="21" name="CasellaDiTesto 1">
          <a:extLst xmlns:a="http://schemas.openxmlformats.org/drawingml/2006/main">
            <a:ext uri="{FF2B5EF4-FFF2-40B4-BE49-F238E27FC236}">
              <a16:creationId xmlns:a16="http://schemas.microsoft.com/office/drawing/2014/main" id="{7EA37C81-96B5-4673-A29A-ABA1F5F33A10}"/>
            </a:ext>
          </a:extLst>
        </cdr:cNvPr>
        <cdr:cNvSpPr txBox="1"/>
      </cdr:nvSpPr>
      <cdr:spPr>
        <a:xfrm xmlns:a="http://schemas.openxmlformats.org/drawingml/2006/main">
          <a:off x="10071345" y="285010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0167</cdr:x>
      <cdr:y>0.45173</cdr:y>
    </cdr:from>
    <cdr:to>
      <cdr:x>0.91345</cdr:x>
      <cdr:y>0.47082</cdr:y>
    </cdr:to>
    <cdr:sp macro="" textlink="">
      <cdr:nvSpPr>
        <cdr:cNvPr id="22" name="CasellaDiTesto 1">
          <a:extLst xmlns:a="http://schemas.openxmlformats.org/drawingml/2006/main">
            <a:ext uri="{FF2B5EF4-FFF2-40B4-BE49-F238E27FC236}">
              <a16:creationId xmlns:a16="http://schemas.microsoft.com/office/drawing/2014/main" id="{7EA37C81-96B5-4673-A29A-ABA1F5F33A10}"/>
            </a:ext>
          </a:extLst>
        </cdr:cNvPr>
        <cdr:cNvSpPr txBox="1"/>
      </cdr:nvSpPr>
      <cdr:spPr>
        <a:xfrm xmlns:a="http://schemas.openxmlformats.org/drawingml/2006/main">
          <a:off x="10147545" y="282152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6599</cdr:x>
      <cdr:y>0.45783</cdr:y>
    </cdr:from>
    <cdr:to>
      <cdr:x>0.97777</cdr:x>
      <cdr:y>0.47692</cdr:y>
    </cdr:to>
    <cdr:sp macro="" textlink="">
      <cdr:nvSpPr>
        <cdr:cNvPr id="23" name="CasellaDiTesto 1">
          <a:extLst xmlns:a="http://schemas.openxmlformats.org/drawingml/2006/main">
            <a:ext uri="{FF2B5EF4-FFF2-40B4-BE49-F238E27FC236}">
              <a16:creationId xmlns:a16="http://schemas.microsoft.com/office/drawing/2014/main" id="{7EA37C81-96B5-4673-A29A-ABA1F5F33A10}"/>
            </a:ext>
          </a:extLst>
        </cdr:cNvPr>
        <cdr:cNvSpPr txBox="1"/>
      </cdr:nvSpPr>
      <cdr:spPr>
        <a:xfrm xmlns:a="http://schemas.openxmlformats.org/drawingml/2006/main">
          <a:off x="10871445" y="285962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2826</cdr:x>
      <cdr:y>0.50223</cdr:y>
    </cdr:from>
    <cdr:to>
      <cdr:x>0.94004</cdr:x>
      <cdr:y>0.52133</cdr:y>
    </cdr:to>
    <cdr:sp macro="" textlink="">
      <cdr:nvSpPr>
        <cdr:cNvPr id="24" name="CasellaDiTesto 1">
          <a:extLst xmlns:a="http://schemas.openxmlformats.org/drawingml/2006/main">
            <a:ext uri="{FF2B5EF4-FFF2-40B4-BE49-F238E27FC236}">
              <a16:creationId xmlns:a16="http://schemas.microsoft.com/office/drawing/2014/main" id="{7EA37C81-96B5-4673-A29A-ABA1F5F33A10}"/>
            </a:ext>
          </a:extLst>
        </cdr:cNvPr>
        <cdr:cNvSpPr txBox="1"/>
      </cdr:nvSpPr>
      <cdr:spPr>
        <a:xfrm xmlns:a="http://schemas.openxmlformats.org/drawingml/2006/main">
          <a:off x="10446823" y="3136957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1343</cdr:x>
      <cdr:y>0.50151</cdr:y>
    </cdr:from>
    <cdr:to>
      <cdr:x>0.32521</cdr:x>
      <cdr:y>0.52061</cdr:y>
    </cdr:to>
    <cdr:sp macro="" textlink="">
      <cdr:nvSpPr>
        <cdr:cNvPr id="26" name="CasellaDiTesto 1">
          <a:extLst xmlns:a="http://schemas.openxmlformats.org/drawingml/2006/main">
            <a:ext uri="{FF2B5EF4-FFF2-40B4-BE49-F238E27FC236}">
              <a16:creationId xmlns:a16="http://schemas.microsoft.com/office/drawing/2014/main" id="{A43BAECA-F7DD-40F3-8376-186229901FDA}"/>
            </a:ext>
          </a:extLst>
        </cdr:cNvPr>
        <cdr:cNvSpPr txBox="1"/>
      </cdr:nvSpPr>
      <cdr:spPr>
        <a:xfrm xmlns:a="http://schemas.openxmlformats.org/drawingml/2006/main">
          <a:off x="3527338" y="3132438"/>
          <a:ext cx="132574" cy="119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7861</cdr:x>
      <cdr:y>0.5</cdr:y>
    </cdr:from>
    <cdr:to>
      <cdr:x>0.39039</cdr:x>
      <cdr:y>0.5191</cdr:y>
    </cdr:to>
    <cdr:sp macro="" textlink="">
      <cdr:nvSpPr>
        <cdr:cNvPr id="27" name="CasellaDiTesto 1">
          <a:extLst xmlns:a="http://schemas.openxmlformats.org/drawingml/2006/main">
            <a:ext uri="{FF2B5EF4-FFF2-40B4-BE49-F238E27FC236}">
              <a16:creationId xmlns:a16="http://schemas.microsoft.com/office/drawing/2014/main" id="{A43BAECA-F7DD-40F3-8376-186229901FDA}"/>
            </a:ext>
          </a:extLst>
        </cdr:cNvPr>
        <cdr:cNvSpPr txBox="1"/>
      </cdr:nvSpPr>
      <cdr:spPr>
        <a:xfrm xmlns:a="http://schemas.openxmlformats.org/drawingml/2006/main">
          <a:off x="4260983" y="3123027"/>
          <a:ext cx="132574" cy="119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7498</cdr:x>
      <cdr:y>0.51342</cdr:y>
    </cdr:from>
    <cdr:to>
      <cdr:x>0.48676</cdr:x>
      <cdr:y>0.53252</cdr:y>
    </cdr:to>
    <cdr:sp macro="" textlink="">
      <cdr:nvSpPr>
        <cdr:cNvPr id="28" name="CasellaDiTesto 1">
          <a:extLst xmlns:a="http://schemas.openxmlformats.org/drawingml/2006/main">
            <a:ext uri="{FF2B5EF4-FFF2-40B4-BE49-F238E27FC236}">
              <a16:creationId xmlns:a16="http://schemas.microsoft.com/office/drawing/2014/main" id="{A43BAECA-F7DD-40F3-8376-186229901FDA}"/>
            </a:ext>
          </a:extLst>
        </cdr:cNvPr>
        <cdr:cNvSpPr txBox="1"/>
      </cdr:nvSpPr>
      <cdr:spPr>
        <a:xfrm xmlns:a="http://schemas.openxmlformats.org/drawingml/2006/main">
          <a:off x="5345504" y="3206865"/>
          <a:ext cx="132574" cy="119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0172</cdr:x>
      <cdr:y>0.45953</cdr:y>
    </cdr:from>
    <cdr:to>
      <cdr:x>0.7135</cdr:x>
      <cdr:y>0.47863</cdr:y>
    </cdr:to>
    <cdr:sp macro="" textlink="">
      <cdr:nvSpPr>
        <cdr:cNvPr id="29" name="CasellaDiTesto 1">
          <a:extLst xmlns:a="http://schemas.openxmlformats.org/drawingml/2006/main">
            <a:ext uri="{FF2B5EF4-FFF2-40B4-BE49-F238E27FC236}">
              <a16:creationId xmlns:a16="http://schemas.microsoft.com/office/drawing/2014/main" id="{A43BAECA-F7DD-40F3-8376-186229901FDA}"/>
            </a:ext>
          </a:extLst>
        </cdr:cNvPr>
        <cdr:cNvSpPr txBox="1"/>
      </cdr:nvSpPr>
      <cdr:spPr>
        <a:xfrm xmlns:a="http://schemas.openxmlformats.org/drawingml/2006/main">
          <a:off x="7897318" y="2870256"/>
          <a:ext cx="132574" cy="119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83872</cdr:x>
      <cdr:y>0.5</cdr:y>
    </cdr:from>
    <cdr:to>
      <cdr:x>0.8505</cdr:x>
      <cdr:y>0.5191</cdr:y>
    </cdr:to>
    <cdr:sp macro="" textlink="">
      <cdr:nvSpPr>
        <cdr:cNvPr id="30" name="CasellaDiTesto 1">
          <a:extLst xmlns:a="http://schemas.openxmlformats.org/drawingml/2006/main">
            <a:ext uri="{FF2B5EF4-FFF2-40B4-BE49-F238E27FC236}">
              <a16:creationId xmlns:a16="http://schemas.microsoft.com/office/drawing/2014/main" id="{A43BAECA-F7DD-40F3-8376-186229901FDA}"/>
            </a:ext>
          </a:extLst>
        </cdr:cNvPr>
        <cdr:cNvSpPr txBox="1"/>
      </cdr:nvSpPr>
      <cdr:spPr>
        <a:xfrm xmlns:a="http://schemas.openxmlformats.org/drawingml/2006/main">
          <a:off x="9439039" y="3123027"/>
          <a:ext cx="132574" cy="119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</cdr:x>
      <cdr:y>0.0675</cdr:y>
    </cdr:from>
    <cdr:to>
      <cdr:x>1</cdr:x>
      <cdr:y>0.28263</cdr:y>
    </cdr:to>
    <cdr:sp macro="" textlink="">
      <cdr:nvSpPr>
        <cdr:cNvPr id="2" name="Titolo 1">
          <a:extLst xmlns:a="http://schemas.openxmlformats.org/drawingml/2006/main">
            <a:ext uri="{FF2B5EF4-FFF2-40B4-BE49-F238E27FC236}">
              <a16:creationId xmlns:a16="http://schemas.microsoft.com/office/drawing/2014/main" id="{1BF55607-A9AB-4045-A543-3BB56ED5A656}"/>
            </a:ext>
          </a:extLst>
        </cdr:cNvPr>
        <cdr:cNvSpPr>
          <a:spLocks xmlns:a="http://schemas.openxmlformats.org/drawingml/2006/main" noGrp="1"/>
        </cdr:cNvSpPr>
      </cdr:nvSpPr>
      <cdr:spPr>
        <a:xfrm xmlns:a="http://schemas.openxmlformats.org/drawingml/2006/main">
          <a:off x="889000" y="415925"/>
          <a:ext cx="10515600" cy="13255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="horz" lIns="91440" tIns="45720" rIns="91440" bIns="45720" rtlCol="0" anchor="ctr">
          <a:normAutofit/>
        </a:bodyPr>
        <a:lstStyle xmlns:a="http://schemas.openxmlformats.org/drawingml/2006/main">
          <a:lvl1pPr algn="l" defTabSz="914400" rtl="0" eaLnBrk="1" latinLnBrk="0" hangingPunct="1">
            <a:lnSpc>
              <a:spcPct val="90000"/>
            </a:lnSpc>
            <a:spcBef>
              <a:spcPct val="0"/>
            </a:spcBef>
            <a:buNone/>
            <a:defRPr sz="4400" kern="1200">
              <a:solidFill>
                <a:schemeClr val="tx1"/>
              </a:solidFill>
              <a:latin typeface="+mj-lt"/>
              <a:ea typeface="+mj-ea"/>
              <a:cs typeface="+mj-cs"/>
            </a:defRPr>
          </a:lvl1pPr>
        </a:lstStyle>
        <a:p xmlns:a="http://schemas.openxmlformats.org/drawingml/2006/main">
          <a:endParaRPr lang="it-IT" dirty="0"/>
        </a:p>
      </cdr:txBody>
    </cdr:sp>
  </cdr:relSizeAnchor>
  <cdr:relSizeAnchor xmlns:cdr="http://schemas.openxmlformats.org/drawingml/2006/chartDrawing">
    <cdr:from>
      <cdr:x>0.0831</cdr:x>
      <cdr:y>0.22192</cdr:y>
    </cdr:from>
    <cdr:to>
      <cdr:x>0.09644</cdr:x>
      <cdr:y>0.24089</cdr:y>
    </cdr:to>
    <cdr:sp macro="" textlink="">
      <cdr:nvSpPr>
        <cdr:cNvPr id="3" name="CasellaDiTesto 1">
          <a:extLst xmlns:a="http://schemas.openxmlformats.org/drawingml/2006/main">
            <a:ext uri="{FF2B5EF4-FFF2-40B4-BE49-F238E27FC236}">
              <a16:creationId xmlns:a16="http://schemas.microsoft.com/office/drawing/2014/main" id="{7EA37C81-96B5-4673-A29A-ABA1F5F33A10}"/>
            </a:ext>
          </a:extLst>
        </cdr:cNvPr>
        <cdr:cNvSpPr txBox="1"/>
      </cdr:nvSpPr>
      <cdr:spPr>
        <a:xfrm xmlns:a="http://schemas.openxmlformats.org/drawingml/2006/main">
          <a:off x="825305" y="13954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0776</cdr:x>
      <cdr:y>0.22192</cdr:y>
    </cdr:from>
    <cdr:to>
      <cdr:x>0.1211</cdr:x>
      <cdr:y>0.24089</cdr:y>
    </cdr:to>
    <cdr:sp macro="" textlink="">
      <cdr:nvSpPr>
        <cdr:cNvPr id="4" name="CasellaDiTesto 1">
          <a:extLst xmlns:a="http://schemas.openxmlformats.org/drawingml/2006/main">
            <a:ext uri="{FF2B5EF4-FFF2-40B4-BE49-F238E27FC236}">
              <a16:creationId xmlns:a16="http://schemas.microsoft.com/office/drawing/2014/main" id="{7EA37C81-96B5-4673-A29A-ABA1F5F33A10}"/>
            </a:ext>
          </a:extLst>
        </cdr:cNvPr>
        <cdr:cNvSpPr txBox="1"/>
      </cdr:nvSpPr>
      <cdr:spPr>
        <a:xfrm xmlns:a="http://schemas.openxmlformats.org/drawingml/2006/main">
          <a:off x="1070220" y="13954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1543</cdr:x>
      <cdr:y>0.22192</cdr:y>
    </cdr:from>
    <cdr:to>
      <cdr:x>0.12877</cdr:x>
      <cdr:y>0.24089</cdr:y>
    </cdr:to>
    <cdr:sp macro="" textlink="">
      <cdr:nvSpPr>
        <cdr:cNvPr id="5" name="CasellaDiTesto 1">
          <a:extLst xmlns:a="http://schemas.openxmlformats.org/drawingml/2006/main">
            <a:ext uri="{FF2B5EF4-FFF2-40B4-BE49-F238E27FC236}">
              <a16:creationId xmlns:a16="http://schemas.microsoft.com/office/drawing/2014/main" id="{7EA37C81-96B5-4673-A29A-ABA1F5F33A10}"/>
            </a:ext>
          </a:extLst>
        </cdr:cNvPr>
        <cdr:cNvSpPr txBox="1"/>
      </cdr:nvSpPr>
      <cdr:spPr>
        <a:xfrm xmlns:a="http://schemas.openxmlformats.org/drawingml/2006/main">
          <a:off x="1146420" y="13954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7809</cdr:x>
      <cdr:y>0.21244</cdr:y>
    </cdr:from>
    <cdr:to>
      <cdr:x>0.19143</cdr:x>
      <cdr:y>0.2314</cdr:y>
    </cdr:to>
    <cdr:sp macro="" textlink="">
      <cdr:nvSpPr>
        <cdr:cNvPr id="6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1768720" y="133585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0206</cdr:x>
      <cdr:y>0.1482</cdr:y>
    </cdr:from>
    <cdr:to>
      <cdr:x>0.21541</cdr:x>
      <cdr:y>0.16717</cdr:y>
    </cdr:to>
    <cdr:sp macro="" textlink="">
      <cdr:nvSpPr>
        <cdr:cNvPr id="7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2006845" y="9319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0974</cdr:x>
      <cdr:y>0.14063</cdr:y>
    </cdr:from>
    <cdr:to>
      <cdr:x>0.22308</cdr:x>
      <cdr:y>0.1596</cdr:y>
    </cdr:to>
    <cdr:sp macro="" textlink="">
      <cdr:nvSpPr>
        <cdr:cNvPr id="8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2083045" y="8843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3371</cdr:x>
      <cdr:y>0.27695</cdr:y>
    </cdr:from>
    <cdr:to>
      <cdr:x>0.24705</cdr:x>
      <cdr:y>0.29592</cdr:y>
    </cdr:to>
    <cdr:sp macro="" textlink="">
      <cdr:nvSpPr>
        <cdr:cNvPr id="9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2321170" y="17415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6536</cdr:x>
      <cdr:y>0.45872</cdr:y>
    </cdr:from>
    <cdr:to>
      <cdr:x>0.2787</cdr:x>
      <cdr:y>0.47769</cdr:y>
    </cdr:to>
    <cdr:sp macro="" textlink="">
      <cdr:nvSpPr>
        <cdr:cNvPr id="10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2635495" y="28845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7207</cdr:x>
      <cdr:y>0.21244</cdr:y>
    </cdr:from>
    <cdr:to>
      <cdr:x>0.28542</cdr:x>
      <cdr:y>0.2314</cdr:y>
    </cdr:to>
    <cdr:sp macro="" textlink="">
      <cdr:nvSpPr>
        <cdr:cNvPr id="11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2702170" y="133585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9701</cdr:x>
      <cdr:y>0.13608</cdr:y>
    </cdr:from>
    <cdr:to>
      <cdr:x>0.31035</cdr:x>
      <cdr:y>0.15505</cdr:y>
    </cdr:to>
    <cdr:sp macro="" textlink="">
      <cdr:nvSpPr>
        <cdr:cNvPr id="12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2949820" y="8557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0372</cdr:x>
      <cdr:y>0.13911</cdr:y>
    </cdr:from>
    <cdr:to>
      <cdr:x>0.31706</cdr:x>
      <cdr:y>0.15808</cdr:y>
    </cdr:to>
    <cdr:sp macro="" textlink="">
      <cdr:nvSpPr>
        <cdr:cNvPr id="13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3016495" y="8747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2866</cdr:x>
      <cdr:y>0.30422</cdr:y>
    </cdr:from>
    <cdr:to>
      <cdr:x>0.342</cdr:x>
      <cdr:y>0.32319</cdr:y>
    </cdr:to>
    <cdr:sp macro="" textlink="">
      <cdr:nvSpPr>
        <cdr:cNvPr id="14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3264145" y="19130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3633</cdr:x>
      <cdr:y>0.30422</cdr:y>
    </cdr:from>
    <cdr:to>
      <cdr:x>0.34967</cdr:x>
      <cdr:y>0.32319</cdr:y>
    </cdr:to>
    <cdr:sp macro="" textlink="">
      <cdr:nvSpPr>
        <cdr:cNvPr id="15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3340345" y="19130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9195</cdr:x>
      <cdr:y>0.32391</cdr:y>
    </cdr:from>
    <cdr:to>
      <cdr:x>0.4053</cdr:x>
      <cdr:y>0.34288</cdr:y>
    </cdr:to>
    <cdr:sp macro="" textlink="">
      <cdr:nvSpPr>
        <cdr:cNvPr id="16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3892795" y="20368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9867</cdr:x>
      <cdr:y>0.36481</cdr:y>
    </cdr:from>
    <cdr:to>
      <cdr:x>0.41201</cdr:x>
      <cdr:y>0.38378</cdr:y>
    </cdr:to>
    <cdr:sp macro="" textlink="">
      <cdr:nvSpPr>
        <cdr:cNvPr id="17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3959470" y="22940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236</cdr:x>
      <cdr:y>0.20295</cdr:y>
    </cdr:from>
    <cdr:to>
      <cdr:x>0.43694</cdr:x>
      <cdr:y>0.22192</cdr:y>
    </cdr:to>
    <cdr:sp macro="" textlink="">
      <cdr:nvSpPr>
        <cdr:cNvPr id="18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4207120" y="127621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3031</cdr:x>
      <cdr:y>0.19347</cdr:y>
    </cdr:from>
    <cdr:to>
      <cdr:x>0.44366</cdr:x>
      <cdr:y>0.21244</cdr:y>
    </cdr:to>
    <cdr:sp macro="" textlink="">
      <cdr:nvSpPr>
        <cdr:cNvPr id="19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4273795" y="121658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5525</cdr:x>
      <cdr:y>0.22192</cdr:y>
    </cdr:from>
    <cdr:to>
      <cdr:x>0.46859</cdr:x>
      <cdr:y>0.24089</cdr:y>
    </cdr:to>
    <cdr:sp macro="" textlink="">
      <cdr:nvSpPr>
        <cdr:cNvPr id="20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4521445" y="13954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6196</cdr:x>
      <cdr:y>0.20295</cdr:y>
    </cdr:from>
    <cdr:to>
      <cdr:x>0.47531</cdr:x>
      <cdr:y>0.22192</cdr:y>
    </cdr:to>
    <cdr:sp macro="" textlink="">
      <cdr:nvSpPr>
        <cdr:cNvPr id="21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4588120" y="127621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8666</cdr:x>
      <cdr:y>0.67684</cdr:y>
    </cdr:from>
    <cdr:to>
      <cdr:x>0.5</cdr:x>
      <cdr:y>0.69581</cdr:y>
    </cdr:to>
    <cdr:sp macro="" textlink="">
      <cdr:nvSpPr>
        <cdr:cNvPr id="22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4833373" y="42561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9333</cdr:x>
      <cdr:y>0.67684</cdr:y>
    </cdr:from>
    <cdr:to>
      <cdr:x>0.50667</cdr:x>
      <cdr:y>0.69581</cdr:y>
    </cdr:to>
    <cdr:sp macro="" textlink="">
      <cdr:nvSpPr>
        <cdr:cNvPr id="23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4899634" y="42561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1759</cdr:x>
      <cdr:y>0.32543</cdr:y>
    </cdr:from>
    <cdr:to>
      <cdr:x>0.53093</cdr:x>
      <cdr:y>0.34439</cdr:y>
    </cdr:to>
    <cdr:sp macro="" textlink="">
      <cdr:nvSpPr>
        <cdr:cNvPr id="24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5140570" y="20463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2526</cdr:x>
      <cdr:y>0.33906</cdr:y>
    </cdr:from>
    <cdr:to>
      <cdr:x>0.5386</cdr:x>
      <cdr:y>0.35803</cdr:y>
    </cdr:to>
    <cdr:sp macro="" textlink="">
      <cdr:nvSpPr>
        <cdr:cNvPr id="25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5216770" y="21320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4924</cdr:x>
      <cdr:y>0.35875</cdr:y>
    </cdr:from>
    <cdr:to>
      <cdr:x>0.56258</cdr:x>
      <cdr:y>0.37772</cdr:y>
    </cdr:to>
    <cdr:sp macro="" textlink="">
      <cdr:nvSpPr>
        <cdr:cNvPr id="26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5454895" y="22559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5691</cdr:x>
      <cdr:y>0.333</cdr:y>
    </cdr:from>
    <cdr:to>
      <cdr:x>0.57025</cdr:x>
      <cdr:y>0.35197</cdr:y>
    </cdr:to>
    <cdr:sp macro="" textlink="">
      <cdr:nvSpPr>
        <cdr:cNvPr id="27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5531095" y="20939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8184</cdr:x>
      <cdr:y>0.32846</cdr:y>
    </cdr:from>
    <cdr:to>
      <cdr:x>0.59519</cdr:x>
      <cdr:y>0.34742</cdr:y>
    </cdr:to>
    <cdr:sp macro="" textlink="">
      <cdr:nvSpPr>
        <cdr:cNvPr id="28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5778745" y="20654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8952</cdr:x>
      <cdr:y>0.32391</cdr:y>
    </cdr:from>
    <cdr:to>
      <cdr:x>0.60286</cdr:x>
      <cdr:y>0.34288</cdr:y>
    </cdr:to>
    <cdr:sp macro="" textlink="">
      <cdr:nvSpPr>
        <cdr:cNvPr id="29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5854945" y="20368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1253</cdr:x>
      <cdr:y>0.35118</cdr:y>
    </cdr:from>
    <cdr:to>
      <cdr:x>0.62588</cdr:x>
      <cdr:y>0.37014</cdr:y>
    </cdr:to>
    <cdr:sp macro="" textlink="">
      <cdr:nvSpPr>
        <cdr:cNvPr id="30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6083545" y="22082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202</cdr:x>
      <cdr:y>0.33906</cdr:y>
    </cdr:from>
    <cdr:to>
      <cdr:x>0.63355</cdr:x>
      <cdr:y>0.35803</cdr:y>
    </cdr:to>
    <cdr:sp macro="" textlink="">
      <cdr:nvSpPr>
        <cdr:cNvPr id="31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6159745" y="21320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5089</cdr:x>
      <cdr:y>0.2709</cdr:y>
    </cdr:from>
    <cdr:to>
      <cdr:x>0.66424</cdr:x>
      <cdr:y>0.28986</cdr:y>
    </cdr:to>
    <cdr:sp macro="" textlink="">
      <cdr:nvSpPr>
        <cdr:cNvPr id="32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6464545" y="17034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0748</cdr:x>
      <cdr:y>0.27695</cdr:y>
    </cdr:from>
    <cdr:to>
      <cdr:x>0.72082</cdr:x>
      <cdr:y>0.29592</cdr:y>
    </cdr:to>
    <cdr:sp macro="" textlink="">
      <cdr:nvSpPr>
        <cdr:cNvPr id="33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7026520" y="17415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it-IT" sz="1100" dirty="0"/>
        </a:p>
      </cdr:txBody>
    </cdr:sp>
  </cdr:relSizeAnchor>
  <cdr:relSizeAnchor xmlns:cdr="http://schemas.openxmlformats.org/drawingml/2006/chartDrawing">
    <cdr:from>
      <cdr:x>0.71515</cdr:x>
      <cdr:y>0.29513</cdr:y>
    </cdr:from>
    <cdr:to>
      <cdr:x>0.72849</cdr:x>
      <cdr:y>0.3141</cdr:y>
    </cdr:to>
    <cdr:sp macro="" textlink="">
      <cdr:nvSpPr>
        <cdr:cNvPr id="34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7102720" y="18558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7749</cdr:x>
      <cdr:y>0.27695</cdr:y>
    </cdr:from>
    <cdr:to>
      <cdr:x>0.79083</cdr:x>
      <cdr:y>0.29592</cdr:y>
    </cdr:to>
    <cdr:sp macro="" textlink="">
      <cdr:nvSpPr>
        <cdr:cNvPr id="35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7721845" y="17415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84078</cdr:x>
      <cdr:y>0.27998</cdr:y>
    </cdr:from>
    <cdr:to>
      <cdr:x>0.85413</cdr:x>
      <cdr:y>0.29895</cdr:y>
    </cdr:to>
    <cdr:sp macro="" textlink="">
      <cdr:nvSpPr>
        <cdr:cNvPr id="36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8350495" y="17606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87243</cdr:x>
      <cdr:y>0.26938</cdr:y>
    </cdr:from>
    <cdr:to>
      <cdr:x>0.88578</cdr:x>
      <cdr:y>0.28835</cdr:y>
    </cdr:to>
    <cdr:sp macro="" textlink="">
      <cdr:nvSpPr>
        <cdr:cNvPr id="37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8664820" y="16939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89737</cdr:x>
      <cdr:y>0.3027</cdr:y>
    </cdr:from>
    <cdr:to>
      <cdr:x>0.91071</cdr:x>
      <cdr:y>0.32167</cdr:y>
    </cdr:to>
    <cdr:sp macro="" textlink="">
      <cdr:nvSpPr>
        <cdr:cNvPr id="38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8912470" y="19034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0408</cdr:x>
      <cdr:y>0.27847</cdr:y>
    </cdr:from>
    <cdr:to>
      <cdr:x>0.91742</cdr:x>
      <cdr:y>0.29744</cdr:y>
    </cdr:to>
    <cdr:sp macro="" textlink="">
      <cdr:nvSpPr>
        <cdr:cNvPr id="39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8979145" y="17510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2806</cdr:x>
      <cdr:y>0.21244</cdr:y>
    </cdr:from>
    <cdr:to>
      <cdr:x>0.9414</cdr:x>
      <cdr:y>0.2314</cdr:y>
    </cdr:to>
    <cdr:sp macro="" textlink="">
      <cdr:nvSpPr>
        <cdr:cNvPr id="40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9217270" y="133585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3477</cdr:x>
      <cdr:y>0.15426</cdr:y>
    </cdr:from>
    <cdr:to>
      <cdr:x>0.94811</cdr:x>
      <cdr:y>0.17323</cdr:y>
    </cdr:to>
    <cdr:sp macro="" textlink="">
      <cdr:nvSpPr>
        <cdr:cNvPr id="41" name="CasellaDiTesto 1">
          <a:extLst xmlns:a="http://schemas.openxmlformats.org/drawingml/2006/main">
            <a:ext uri="{FF2B5EF4-FFF2-40B4-BE49-F238E27FC236}">
              <a16:creationId xmlns:a16="http://schemas.microsoft.com/office/drawing/2014/main" id="{D94601AE-55C0-43A8-A61F-E57CC6B75E4F}"/>
            </a:ext>
          </a:extLst>
        </cdr:cNvPr>
        <cdr:cNvSpPr txBox="1"/>
      </cdr:nvSpPr>
      <cdr:spPr>
        <a:xfrm xmlns:a="http://schemas.openxmlformats.org/drawingml/2006/main">
          <a:off x="9283945" y="9700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4988</cdr:x>
      <cdr:y>0.9006</cdr:y>
    </cdr:from>
    <cdr:to>
      <cdr:x>0.39277</cdr:x>
      <cdr:y>0.95059</cdr:y>
    </cdr:to>
    <cdr:sp macro="" textlink="">
      <cdr:nvSpPr>
        <cdr:cNvPr id="42" name="CasellaDiTesto 1">
          <a:extLst xmlns:a="http://schemas.openxmlformats.org/drawingml/2006/main">
            <a:ext uri="{FF2B5EF4-FFF2-40B4-BE49-F238E27FC236}">
              <a16:creationId xmlns:a16="http://schemas.microsoft.com/office/drawing/2014/main" id="{7D62CF96-A96D-4AEE-98C6-F7DA1F74053F}"/>
            </a:ext>
          </a:extLst>
        </cdr:cNvPr>
        <cdr:cNvSpPr txBox="1"/>
      </cdr:nvSpPr>
      <cdr:spPr>
        <a:xfrm xmlns:a="http://schemas.openxmlformats.org/drawingml/2006/main">
          <a:off x="2481726" y="5663223"/>
          <a:ext cx="1419225" cy="314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200" b="1" dirty="0"/>
            <a:t>* = </a:t>
          </a:r>
          <a:r>
            <a:rPr lang="it-IT" sz="1200" b="1" i="1" dirty="0"/>
            <a:t>p</a:t>
          </a:r>
          <a:r>
            <a:rPr lang="it-IT" sz="1200" b="1" dirty="0"/>
            <a:t> &lt; 0.05</a:t>
          </a:r>
        </a:p>
      </cdr:txBody>
    </cdr:sp>
  </cdr:relSizeAnchor>
  <cdr:relSizeAnchor xmlns:cdr="http://schemas.openxmlformats.org/drawingml/2006/chartDrawing">
    <cdr:from>
      <cdr:x>0.17131</cdr:x>
      <cdr:y>0.22192</cdr:y>
    </cdr:from>
    <cdr:to>
      <cdr:x>0.18466</cdr:x>
      <cdr:y>0.24089</cdr:y>
    </cdr:to>
    <cdr:sp macro="" textlink="">
      <cdr:nvSpPr>
        <cdr:cNvPr id="43" name="CasellaDiTesto 1">
          <a:extLst xmlns:a="http://schemas.openxmlformats.org/drawingml/2006/main">
            <a:ext uri="{FF2B5EF4-FFF2-40B4-BE49-F238E27FC236}">
              <a16:creationId xmlns:a16="http://schemas.microsoft.com/office/drawing/2014/main" id="{A43BAECA-F7DD-40F3-8376-186229901FDA}"/>
            </a:ext>
          </a:extLst>
        </cdr:cNvPr>
        <cdr:cNvSpPr txBox="1"/>
      </cdr:nvSpPr>
      <cdr:spPr>
        <a:xfrm xmlns:a="http://schemas.openxmlformats.org/drawingml/2006/main">
          <a:off x="1701410" y="1395486"/>
          <a:ext cx="132574" cy="119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607</cdr:x>
      <cdr:y>0.28174</cdr:y>
    </cdr:from>
    <cdr:to>
      <cdr:x>0.37405</cdr:x>
      <cdr:y>0.30071</cdr:y>
    </cdr:to>
    <cdr:sp macro="" textlink="">
      <cdr:nvSpPr>
        <cdr:cNvPr id="44" name="CasellaDiTesto 1">
          <a:extLst xmlns:a="http://schemas.openxmlformats.org/drawingml/2006/main">
            <a:ext uri="{FF2B5EF4-FFF2-40B4-BE49-F238E27FC236}">
              <a16:creationId xmlns:a16="http://schemas.microsoft.com/office/drawing/2014/main" id="{A43BAECA-F7DD-40F3-8376-186229901FDA}"/>
            </a:ext>
          </a:extLst>
        </cdr:cNvPr>
        <cdr:cNvSpPr txBox="1"/>
      </cdr:nvSpPr>
      <cdr:spPr>
        <a:xfrm xmlns:a="http://schemas.openxmlformats.org/drawingml/2006/main">
          <a:off x="3582423" y="1771673"/>
          <a:ext cx="132574" cy="119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07181</cdr:x>
      <cdr:y>0.35049</cdr:y>
    </cdr:from>
    <cdr:to>
      <cdr:x>0.08461</cdr:x>
      <cdr:y>0.37138</cdr:y>
    </cdr:to>
    <cdr:sp macro="" textlink="">
      <cdr:nvSpPr>
        <cdr:cNvPr id="2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743195" y="20019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07825</cdr:x>
      <cdr:y>0.36217</cdr:y>
    </cdr:from>
    <cdr:to>
      <cdr:x>0.09105</cdr:x>
      <cdr:y>0.38305</cdr:y>
    </cdr:to>
    <cdr:sp macro="" textlink="">
      <cdr:nvSpPr>
        <cdr:cNvPr id="3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809870" y="20685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0218</cdr:x>
      <cdr:y>0.33382</cdr:y>
    </cdr:from>
    <cdr:to>
      <cdr:x>0.11498</cdr:x>
      <cdr:y>0.3547</cdr:y>
    </cdr:to>
    <cdr:sp macro="" textlink="">
      <cdr:nvSpPr>
        <cdr:cNvPr id="4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1057520" y="19066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1046</cdr:x>
      <cdr:y>0.30213</cdr:y>
    </cdr:from>
    <cdr:to>
      <cdr:x>0.12326</cdr:x>
      <cdr:y>0.32301</cdr:y>
    </cdr:to>
    <cdr:sp macro="" textlink="">
      <cdr:nvSpPr>
        <cdr:cNvPr id="5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1143245" y="17256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3439</cdr:x>
      <cdr:y>0.30547</cdr:y>
    </cdr:from>
    <cdr:to>
      <cdr:x>0.14719</cdr:x>
      <cdr:y>0.32635</cdr:y>
    </cdr:to>
    <cdr:sp macro="" textlink="">
      <cdr:nvSpPr>
        <cdr:cNvPr id="6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1390895" y="17447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4175</cdr:x>
      <cdr:y>0.2471</cdr:y>
    </cdr:from>
    <cdr:to>
      <cdr:x>0.15455</cdr:x>
      <cdr:y>0.26798</cdr:y>
    </cdr:to>
    <cdr:sp macro="" textlink="">
      <cdr:nvSpPr>
        <cdr:cNvPr id="7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1467095" y="14113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666</cdr:x>
      <cdr:y>0.33048</cdr:y>
    </cdr:from>
    <cdr:to>
      <cdr:x>0.1794</cdr:x>
      <cdr:y>0.35136</cdr:y>
    </cdr:to>
    <cdr:sp macro="" textlink="">
      <cdr:nvSpPr>
        <cdr:cNvPr id="8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1724270" y="18876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7304</cdr:x>
      <cdr:y>0.32381</cdr:y>
    </cdr:from>
    <cdr:to>
      <cdr:x>0.18584</cdr:x>
      <cdr:y>0.34469</cdr:y>
    </cdr:to>
    <cdr:sp macro="" textlink="">
      <cdr:nvSpPr>
        <cdr:cNvPr id="9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1790945" y="18495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9789</cdr:x>
      <cdr:y>0.33715</cdr:y>
    </cdr:from>
    <cdr:to>
      <cdr:x>0.21069</cdr:x>
      <cdr:y>0.35803</cdr:y>
    </cdr:to>
    <cdr:sp macro="" textlink="">
      <cdr:nvSpPr>
        <cdr:cNvPr id="10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2048120" y="19257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0525</cdr:x>
      <cdr:y>0.33715</cdr:y>
    </cdr:from>
    <cdr:to>
      <cdr:x>0.21805</cdr:x>
      <cdr:y>0.35803</cdr:y>
    </cdr:to>
    <cdr:sp macro="" textlink="">
      <cdr:nvSpPr>
        <cdr:cNvPr id="11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2124320" y="19257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301</cdr:x>
      <cdr:y>0.36884</cdr:y>
    </cdr:from>
    <cdr:to>
      <cdr:x>0.2429</cdr:x>
      <cdr:y>0.38972</cdr:y>
    </cdr:to>
    <cdr:sp macro="" textlink="">
      <cdr:nvSpPr>
        <cdr:cNvPr id="12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2381495" y="21066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3654</cdr:x>
      <cdr:y>0.37217</cdr:y>
    </cdr:from>
    <cdr:to>
      <cdr:x>0.24934</cdr:x>
      <cdr:y>0.39305</cdr:y>
    </cdr:to>
    <cdr:sp macro="" textlink="">
      <cdr:nvSpPr>
        <cdr:cNvPr id="13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2448170" y="21257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6139</cdr:x>
      <cdr:y>0.21708</cdr:y>
    </cdr:from>
    <cdr:to>
      <cdr:x>0.27419</cdr:x>
      <cdr:y>0.23796</cdr:y>
    </cdr:to>
    <cdr:sp macro="" textlink="">
      <cdr:nvSpPr>
        <cdr:cNvPr id="14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2705345" y="12399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6875</cdr:x>
      <cdr:y>0.1854</cdr:y>
    </cdr:from>
    <cdr:to>
      <cdr:x>0.28155</cdr:x>
      <cdr:y>0.20628</cdr:y>
    </cdr:to>
    <cdr:sp macro="" textlink="">
      <cdr:nvSpPr>
        <cdr:cNvPr id="15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2781545" y="10589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9268</cdr:x>
      <cdr:y>0.31547</cdr:y>
    </cdr:from>
    <cdr:to>
      <cdr:x>0.30548</cdr:x>
      <cdr:y>0.33636</cdr:y>
    </cdr:to>
    <cdr:sp macro="" textlink="">
      <cdr:nvSpPr>
        <cdr:cNvPr id="16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3029195" y="18018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0004</cdr:x>
      <cdr:y>0.31381</cdr:y>
    </cdr:from>
    <cdr:to>
      <cdr:x>0.31284</cdr:x>
      <cdr:y>0.33469</cdr:y>
    </cdr:to>
    <cdr:sp macro="" textlink="">
      <cdr:nvSpPr>
        <cdr:cNvPr id="17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3105395" y="17923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2489</cdr:x>
      <cdr:y>0.40886</cdr:y>
    </cdr:from>
    <cdr:to>
      <cdr:x>0.33769</cdr:x>
      <cdr:y>0.42974</cdr:y>
    </cdr:to>
    <cdr:sp macro="" textlink="">
      <cdr:nvSpPr>
        <cdr:cNvPr id="18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3362570" y="23352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3133</cdr:x>
      <cdr:y>0.41887</cdr:y>
    </cdr:from>
    <cdr:to>
      <cdr:x>0.34413</cdr:x>
      <cdr:y>0.43975</cdr:y>
    </cdr:to>
    <cdr:sp macro="" textlink="">
      <cdr:nvSpPr>
        <cdr:cNvPr id="19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3429245" y="23924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5618</cdr:x>
      <cdr:y>0.41553</cdr:y>
    </cdr:from>
    <cdr:to>
      <cdr:x>0.36898</cdr:x>
      <cdr:y>0.43641</cdr:y>
    </cdr:to>
    <cdr:sp macro="" textlink="">
      <cdr:nvSpPr>
        <cdr:cNvPr id="20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3686420" y="23733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6354</cdr:x>
      <cdr:y>0.43054</cdr:y>
    </cdr:from>
    <cdr:to>
      <cdr:x>0.37634</cdr:x>
      <cdr:y>0.45142</cdr:y>
    </cdr:to>
    <cdr:sp macro="" textlink="">
      <cdr:nvSpPr>
        <cdr:cNvPr id="21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3762620" y="24591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8839</cdr:x>
      <cdr:y>0.4222</cdr:y>
    </cdr:from>
    <cdr:to>
      <cdr:x>0.40119</cdr:x>
      <cdr:y>0.44308</cdr:y>
    </cdr:to>
    <cdr:sp macro="" textlink="">
      <cdr:nvSpPr>
        <cdr:cNvPr id="22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4019795" y="24114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9483</cdr:x>
      <cdr:y>0.43888</cdr:y>
    </cdr:from>
    <cdr:to>
      <cdr:x>0.40763</cdr:x>
      <cdr:y>0.45976</cdr:y>
    </cdr:to>
    <cdr:sp macro="" textlink="">
      <cdr:nvSpPr>
        <cdr:cNvPr id="23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4086470" y="25067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1968</cdr:x>
      <cdr:y>0.34216</cdr:y>
    </cdr:from>
    <cdr:to>
      <cdr:x>0.43248</cdr:x>
      <cdr:y>0.36304</cdr:y>
    </cdr:to>
    <cdr:sp macro="" textlink="">
      <cdr:nvSpPr>
        <cdr:cNvPr id="24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4343645" y="19542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2704</cdr:x>
      <cdr:y>0.34216</cdr:y>
    </cdr:from>
    <cdr:to>
      <cdr:x>0.43984</cdr:x>
      <cdr:y>0.36304</cdr:y>
    </cdr:to>
    <cdr:sp macro="" textlink="">
      <cdr:nvSpPr>
        <cdr:cNvPr id="25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4419845" y="19542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5097</cdr:x>
      <cdr:y>0.33048</cdr:y>
    </cdr:from>
    <cdr:to>
      <cdr:x>0.46377</cdr:x>
      <cdr:y>0.35136</cdr:y>
    </cdr:to>
    <cdr:sp macro="" textlink="">
      <cdr:nvSpPr>
        <cdr:cNvPr id="26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4667495" y="18876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5833</cdr:x>
      <cdr:y>0.34216</cdr:y>
    </cdr:from>
    <cdr:to>
      <cdr:x>0.47113</cdr:x>
      <cdr:y>0.36304</cdr:y>
    </cdr:to>
    <cdr:sp macro="" textlink="">
      <cdr:nvSpPr>
        <cdr:cNvPr id="27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4743695" y="19542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8399</cdr:x>
      <cdr:y>0.62399</cdr:y>
    </cdr:from>
    <cdr:to>
      <cdr:x>0.4968</cdr:x>
      <cdr:y>0.64487</cdr:y>
    </cdr:to>
    <cdr:sp macro="" textlink="">
      <cdr:nvSpPr>
        <cdr:cNvPr id="28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5009321" y="35640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936</cdr:x>
      <cdr:y>0.62399</cdr:y>
    </cdr:from>
    <cdr:to>
      <cdr:x>0.5064</cdr:x>
      <cdr:y>0.64487</cdr:y>
    </cdr:to>
    <cdr:sp macro="" textlink="">
      <cdr:nvSpPr>
        <cdr:cNvPr id="29" name="CasellaDiTesto 1">
          <a:extLst xmlns:a="http://schemas.openxmlformats.org/drawingml/2006/main">
            <a:ext uri="{FF2B5EF4-FFF2-40B4-BE49-F238E27FC236}">
              <a16:creationId xmlns:a16="http://schemas.microsoft.com/office/drawing/2014/main" id="{237E3405-5887-4016-AC09-4B56630FB68D}"/>
            </a:ext>
          </a:extLst>
        </cdr:cNvPr>
        <cdr:cNvSpPr txBox="1"/>
      </cdr:nvSpPr>
      <cdr:spPr>
        <a:xfrm xmlns:a="http://schemas.openxmlformats.org/drawingml/2006/main">
          <a:off x="5108712" y="35640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1467</cdr:x>
      <cdr:y>0.42776</cdr:y>
    </cdr:from>
    <cdr:to>
      <cdr:x>0.52748</cdr:x>
      <cdr:y>0.44864</cdr:y>
    </cdr:to>
    <cdr:sp macro="" textlink="">
      <cdr:nvSpPr>
        <cdr:cNvPr id="30" name="CasellaDiTesto 1">
          <a:extLst xmlns:a="http://schemas.openxmlformats.org/drawingml/2006/main">
            <a:ext uri="{FF2B5EF4-FFF2-40B4-BE49-F238E27FC236}">
              <a16:creationId xmlns:a16="http://schemas.microsoft.com/office/drawing/2014/main" id="{5FB30132-DD0F-40EC-9072-9A1CCDA436F0}"/>
            </a:ext>
          </a:extLst>
        </cdr:cNvPr>
        <cdr:cNvSpPr txBox="1"/>
      </cdr:nvSpPr>
      <cdr:spPr>
        <a:xfrm xmlns:a="http://schemas.openxmlformats.org/drawingml/2006/main">
          <a:off x="5326821" y="24432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2203</cdr:x>
      <cdr:y>0.41442</cdr:y>
    </cdr:from>
    <cdr:to>
      <cdr:x>0.53484</cdr:x>
      <cdr:y>0.4353</cdr:y>
    </cdr:to>
    <cdr:sp macro="" textlink="">
      <cdr:nvSpPr>
        <cdr:cNvPr id="31" name="CasellaDiTesto 1">
          <a:extLst xmlns:a="http://schemas.openxmlformats.org/drawingml/2006/main">
            <a:ext uri="{FF2B5EF4-FFF2-40B4-BE49-F238E27FC236}">
              <a16:creationId xmlns:a16="http://schemas.microsoft.com/office/drawing/2014/main" id="{5FB30132-DD0F-40EC-9072-9A1CCDA436F0}"/>
            </a:ext>
          </a:extLst>
        </cdr:cNvPr>
        <cdr:cNvSpPr txBox="1"/>
      </cdr:nvSpPr>
      <cdr:spPr>
        <a:xfrm xmlns:a="http://schemas.openxmlformats.org/drawingml/2006/main">
          <a:off x="5403021" y="23670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5332</cdr:x>
      <cdr:y>0.36272</cdr:y>
    </cdr:from>
    <cdr:to>
      <cdr:x>0.56613</cdr:x>
      <cdr:y>0.3836</cdr:y>
    </cdr:to>
    <cdr:sp macro="" textlink="">
      <cdr:nvSpPr>
        <cdr:cNvPr id="32" name="CasellaDiTesto 1">
          <a:extLst xmlns:a="http://schemas.openxmlformats.org/drawingml/2006/main">
            <a:ext uri="{FF2B5EF4-FFF2-40B4-BE49-F238E27FC236}">
              <a16:creationId xmlns:a16="http://schemas.microsoft.com/office/drawing/2014/main" id="{5FB30132-DD0F-40EC-9072-9A1CCDA436F0}"/>
            </a:ext>
          </a:extLst>
        </cdr:cNvPr>
        <cdr:cNvSpPr txBox="1"/>
      </cdr:nvSpPr>
      <cdr:spPr>
        <a:xfrm xmlns:a="http://schemas.openxmlformats.org/drawingml/2006/main">
          <a:off x="5726871" y="20717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1682</cdr:x>
      <cdr:y>0.35605</cdr:y>
    </cdr:from>
    <cdr:to>
      <cdr:x>0.62963</cdr:x>
      <cdr:y>0.37693</cdr:y>
    </cdr:to>
    <cdr:sp macro="" textlink="">
      <cdr:nvSpPr>
        <cdr:cNvPr id="33" name="CasellaDiTesto 1">
          <a:extLst xmlns:a="http://schemas.openxmlformats.org/drawingml/2006/main">
            <a:ext uri="{FF2B5EF4-FFF2-40B4-BE49-F238E27FC236}">
              <a16:creationId xmlns:a16="http://schemas.microsoft.com/office/drawing/2014/main" id="{5FB30132-DD0F-40EC-9072-9A1CCDA436F0}"/>
            </a:ext>
          </a:extLst>
        </cdr:cNvPr>
        <cdr:cNvSpPr txBox="1"/>
      </cdr:nvSpPr>
      <cdr:spPr>
        <a:xfrm xmlns:a="http://schemas.openxmlformats.org/drawingml/2006/main">
          <a:off x="6384096" y="20336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7817</cdr:x>
      <cdr:y>0.43943</cdr:y>
    </cdr:from>
    <cdr:to>
      <cdr:x>0.59098</cdr:x>
      <cdr:y>0.46032</cdr:y>
    </cdr:to>
    <cdr:sp macro="" textlink="">
      <cdr:nvSpPr>
        <cdr:cNvPr id="34" name="CasellaDiTesto 1">
          <a:extLst xmlns:a="http://schemas.openxmlformats.org/drawingml/2006/main">
            <a:ext uri="{FF2B5EF4-FFF2-40B4-BE49-F238E27FC236}">
              <a16:creationId xmlns:a16="http://schemas.microsoft.com/office/drawing/2014/main" id="{5FB30132-DD0F-40EC-9072-9A1CCDA436F0}"/>
            </a:ext>
          </a:extLst>
        </cdr:cNvPr>
        <cdr:cNvSpPr txBox="1"/>
      </cdr:nvSpPr>
      <cdr:spPr>
        <a:xfrm xmlns:a="http://schemas.openxmlformats.org/drawingml/2006/main">
          <a:off x="5984046" y="25099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8737</cdr:x>
      <cdr:y>0.42609</cdr:y>
    </cdr:from>
    <cdr:to>
      <cdr:x>0.60018</cdr:x>
      <cdr:y>0.44697</cdr:y>
    </cdr:to>
    <cdr:sp macro="" textlink="">
      <cdr:nvSpPr>
        <cdr:cNvPr id="35" name="CasellaDiTesto 1">
          <a:extLst xmlns:a="http://schemas.openxmlformats.org/drawingml/2006/main">
            <a:ext uri="{FF2B5EF4-FFF2-40B4-BE49-F238E27FC236}">
              <a16:creationId xmlns:a16="http://schemas.microsoft.com/office/drawing/2014/main" id="{5FB30132-DD0F-40EC-9072-9A1CCDA436F0}"/>
            </a:ext>
          </a:extLst>
        </cdr:cNvPr>
        <cdr:cNvSpPr txBox="1"/>
      </cdr:nvSpPr>
      <cdr:spPr>
        <a:xfrm xmlns:a="http://schemas.openxmlformats.org/drawingml/2006/main">
          <a:off x="6079296" y="24337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4075</cdr:x>
      <cdr:y>0.36439</cdr:y>
    </cdr:from>
    <cdr:to>
      <cdr:x>0.65356</cdr:x>
      <cdr:y>0.38527</cdr:y>
    </cdr:to>
    <cdr:sp macro="" textlink="">
      <cdr:nvSpPr>
        <cdr:cNvPr id="36" name="CasellaDiTesto 1">
          <a:extLst xmlns:a="http://schemas.openxmlformats.org/drawingml/2006/main">
            <a:ext uri="{FF2B5EF4-FFF2-40B4-BE49-F238E27FC236}">
              <a16:creationId xmlns:a16="http://schemas.microsoft.com/office/drawing/2014/main" id="{5FB30132-DD0F-40EC-9072-9A1CCDA436F0}"/>
            </a:ext>
          </a:extLst>
        </cdr:cNvPr>
        <cdr:cNvSpPr txBox="1"/>
      </cdr:nvSpPr>
      <cdr:spPr>
        <a:xfrm xmlns:a="http://schemas.openxmlformats.org/drawingml/2006/main">
          <a:off x="6631746" y="20812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4995</cdr:x>
      <cdr:y>0.36606</cdr:y>
    </cdr:from>
    <cdr:to>
      <cdr:x>0.66276</cdr:x>
      <cdr:y>0.38694</cdr:y>
    </cdr:to>
    <cdr:sp macro="" textlink="">
      <cdr:nvSpPr>
        <cdr:cNvPr id="37" name="CasellaDiTesto 1">
          <a:extLst xmlns:a="http://schemas.openxmlformats.org/drawingml/2006/main">
            <a:ext uri="{FF2B5EF4-FFF2-40B4-BE49-F238E27FC236}">
              <a16:creationId xmlns:a16="http://schemas.microsoft.com/office/drawing/2014/main" id="{5FB30132-DD0F-40EC-9072-9A1CCDA436F0}"/>
            </a:ext>
          </a:extLst>
        </cdr:cNvPr>
        <cdr:cNvSpPr txBox="1"/>
      </cdr:nvSpPr>
      <cdr:spPr>
        <a:xfrm xmlns:a="http://schemas.openxmlformats.org/drawingml/2006/main">
          <a:off x="6726996" y="20908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0425</cdr:x>
      <cdr:y>0.35772</cdr:y>
    </cdr:from>
    <cdr:to>
      <cdr:x>0.71706</cdr:x>
      <cdr:y>0.3786</cdr:y>
    </cdr:to>
    <cdr:sp macro="" textlink="">
      <cdr:nvSpPr>
        <cdr:cNvPr id="38" name="CasellaDiTesto 1">
          <a:extLst xmlns:a="http://schemas.openxmlformats.org/drawingml/2006/main">
            <a:ext uri="{FF2B5EF4-FFF2-40B4-BE49-F238E27FC236}">
              <a16:creationId xmlns:a16="http://schemas.microsoft.com/office/drawing/2014/main" id="{5FB30132-DD0F-40EC-9072-9A1CCDA436F0}"/>
            </a:ext>
          </a:extLst>
        </cdr:cNvPr>
        <cdr:cNvSpPr txBox="1"/>
      </cdr:nvSpPr>
      <cdr:spPr>
        <a:xfrm xmlns:a="http://schemas.openxmlformats.org/drawingml/2006/main">
          <a:off x="7288971" y="20431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1161</cdr:x>
      <cdr:y>0.34771</cdr:y>
    </cdr:from>
    <cdr:to>
      <cdr:x>0.72442</cdr:x>
      <cdr:y>0.3686</cdr:y>
    </cdr:to>
    <cdr:sp macro="" textlink="">
      <cdr:nvSpPr>
        <cdr:cNvPr id="39" name="CasellaDiTesto 1">
          <a:extLst xmlns:a="http://schemas.openxmlformats.org/drawingml/2006/main">
            <a:ext uri="{FF2B5EF4-FFF2-40B4-BE49-F238E27FC236}">
              <a16:creationId xmlns:a16="http://schemas.microsoft.com/office/drawing/2014/main" id="{5FB30132-DD0F-40EC-9072-9A1CCDA436F0}"/>
            </a:ext>
          </a:extLst>
        </cdr:cNvPr>
        <cdr:cNvSpPr txBox="1"/>
      </cdr:nvSpPr>
      <cdr:spPr>
        <a:xfrm xmlns:a="http://schemas.openxmlformats.org/drawingml/2006/main">
          <a:off x="7365171" y="19860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6775</cdr:x>
      <cdr:y>0.36439</cdr:y>
    </cdr:from>
    <cdr:to>
      <cdr:x>0.78056</cdr:x>
      <cdr:y>0.38527</cdr:y>
    </cdr:to>
    <cdr:sp macro="" textlink="">
      <cdr:nvSpPr>
        <cdr:cNvPr id="40" name="CasellaDiTesto 1">
          <a:extLst xmlns:a="http://schemas.openxmlformats.org/drawingml/2006/main">
            <a:ext uri="{FF2B5EF4-FFF2-40B4-BE49-F238E27FC236}">
              <a16:creationId xmlns:a16="http://schemas.microsoft.com/office/drawing/2014/main" id="{5FB30132-DD0F-40EC-9072-9A1CCDA436F0}"/>
            </a:ext>
          </a:extLst>
        </cdr:cNvPr>
        <cdr:cNvSpPr txBox="1"/>
      </cdr:nvSpPr>
      <cdr:spPr>
        <a:xfrm xmlns:a="http://schemas.openxmlformats.org/drawingml/2006/main">
          <a:off x="7946196" y="20812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it-IT" sz="1100" dirty="0"/>
        </a:p>
      </cdr:txBody>
    </cdr:sp>
  </cdr:relSizeAnchor>
  <cdr:relSizeAnchor xmlns:cdr="http://schemas.openxmlformats.org/drawingml/2006/chartDrawing">
    <cdr:from>
      <cdr:x>0.77511</cdr:x>
      <cdr:y>0.35605</cdr:y>
    </cdr:from>
    <cdr:to>
      <cdr:x>0.78792</cdr:x>
      <cdr:y>0.37693</cdr:y>
    </cdr:to>
    <cdr:sp macro="" textlink="">
      <cdr:nvSpPr>
        <cdr:cNvPr id="41" name="CasellaDiTesto 1">
          <a:extLst xmlns:a="http://schemas.openxmlformats.org/drawingml/2006/main">
            <a:ext uri="{FF2B5EF4-FFF2-40B4-BE49-F238E27FC236}">
              <a16:creationId xmlns:a16="http://schemas.microsoft.com/office/drawing/2014/main" id="{5FB30132-DD0F-40EC-9072-9A1CCDA436F0}"/>
            </a:ext>
          </a:extLst>
        </cdr:cNvPr>
        <cdr:cNvSpPr txBox="1"/>
      </cdr:nvSpPr>
      <cdr:spPr>
        <a:xfrm xmlns:a="http://schemas.openxmlformats.org/drawingml/2006/main">
          <a:off x="8022396" y="20336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86254</cdr:x>
      <cdr:y>0.36106</cdr:y>
    </cdr:from>
    <cdr:to>
      <cdr:x>0.87535</cdr:x>
      <cdr:y>0.38194</cdr:y>
    </cdr:to>
    <cdr:sp macro="" textlink="">
      <cdr:nvSpPr>
        <cdr:cNvPr id="42" name="CasellaDiTesto 1">
          <a:extLst xmlns:a="http://schemas.openxmlformats.org/drawingml/2006/main">
            <a:ext uri="{FF2B5EF4-FFF2-40B4-BE49-F238E27FC236}">
              <a16:creationId xmlns:a16="http://schemas.microsoft.com/office/drawing/2014/main" id="{5FB30132-DD0F-40EC-9072-9A1CCDA436F0}"/>
            </a:ext>
          </a:extLst>
        </cdr:cNvPr>
        <cdr:cNvSpPr txBox="1"/>
      </cdr:nvSpPr>
      <cdr:spPr>
        <a:xfrm xmlns:a="http://schemas.openxmlformats.org/drawingml/2006/main">
          <a:off x="8927271" y="20622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86991</cdr:x>
      <cdr:y>0.36106</cdr:y>
    </cdr:from>
    <cdr:to>
      <cdr:x>0.88271</cdr:x>
      <cdr:y>0.38194</cdr:y>
    </cdr:to>
    <cdr:sp macro="" textlink="">
      <cdr:nvSpPr>
        <cdr:cNvPr id="43" name="CasellaDiTesto 1">
          <a:extLst xmlns:a="http://schemas.openxmlformats.org/drawingml/2006/main">
            <a:ext uri="{FF2B5EF4-FFF2-40B4-BE49-F238E27FC236}">
              <a16:creationId xmlns:a16="http://schemas.microsoft.com/office/drawing/2014/main" id="{5FB30132-DD0F-40EC-9072-9A1CCDA436F0}"/>
            </a:ext>
          </a:extLst>
        </cdr:cNvPr>
        <cdr:cNvSpPr txBox="1"/>
      </cdr:nvSpPr>
      <cdr:spPr>
        <a:xfrm xmlns:a="http://schemas.openxmlformats.org/drawingml/2006/main">
          <a:off x="9003471" y="20622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89475</cdr:x>
      <cdr:y>0.36606</cdr:y>
    </cdr:from>
    <cdr:to>
      <cdr:x>0.90756</cdr:x>
      <cdr:y>0.38694</cdr:y>
    </cdr:to>
    <cdr:sp macro="" textlink="">
      <cdr:nvSpPr>
        <cdr:cNvPr id="44" name="CasellaDiTesto 1">
          <a:extLst xmlns:a="http://schemas.openxmlformats.org/drawingml/2006/main">
            <a:ext uri="{FF2B5EF4-FFF2-40B4-BE49-F238E27FC236}">
              <a16:creationId xmlns:a16="http://schemas.microsoft.com/office/drawing/2014/main" id="{5FB30132-DD0F-40EC-9072-9A1CCDA436F0}"/>
            </a:ext>
          </a:extLst>
        </cdr:cNvPr>
        <cdr:cNvSpPr txBox="1"/>
      </cdr:nvSpPr>
      <cdr:spPr>
        <a:xfrm xmlns:a="http://schemas.openxmlformats.org/drawingml/2006/main">
          <a:off x="9260646" y="20908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2696</cdr:x>
      <cdr:y>0.30269</cdr:y>
    </cdr:from>
    <cdr:to>
      <cdr:x>0.93977</cdr:x>
      <cdr:y>0.32357</cdr:y>
    </cdr:to>
    <cdr:sp macro="" textlink="">
      <cdr:nvSpPr>
        <cdr:cNvPr id="45" name="CasellaDiTesto 1">
          <a:extLst xmlns:a="http://schemas.openxmlformats.org/drawingml/2006/main">
            <a:ext uri="{FF2B5EF4-FFF2-40B4-BE49-F238E27FC236}">
              <a16:creationId xmlns:a16="http://schemas.microsoft.com/office/drawing/2014/main" id="{5FB30132-DD0F-40EC-9072-9A1CCDA436F0}"/>
            </a:ext>
          </a:extLst>
        </cdr:cNvPr>
        <cdr:cNvSpPr txBox="1"/>
      </cdr:nvSpPr>
      <cdr:spPr>
        <a:xfrm xmlns:a="http://schemas.openxmlformats.org/drawingml/2006/main">
          <a:off x="9594021" y="17288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3341</cdr:x>
      <cdr:y>0.26767</cdr:y>
    </cdr:from>
    <cdr:to>
      <cdr:x>0.94621</cdr:x>
      <cdr:y>0.28855</cdr:y>
    </cdr:to>
    <cdr:sp macro="" textlink="">
      <cdr:nvSpPr>
        <cdr:cNvPr id="46" name="CasellaDiTesto 1">
          <a:extLst xmlns:a="http://schemas.openxmlformats.org/drawingml/2006/main">
            <a:ext uri="{FF2B5EF4-FFF2-40B4-BE49-F238E27FC236}">
              <a16:creationId xmlns:a16="http://schemas.microsoft.com/office/drawing/2014/main" id="{5FB30132-DD0F-40EC-9072-9A1CCDA436F0}"/>
            </a:ext>
          </a:extLst>
        </cdr:cNvPr>
        <cdr:cNvSpPr txBox="1"/>
      </cdr:nvSpPr>
      <cdr:spPr>
        <a:xfrm xmlns:a="http://schemas.openxmlformats.org/drawingml/2006/main">
          <a:off x="9660696" y="15288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5733</cdr:x>
      <cdr:y>0.37606</cdr:y>
    </cdr:from>
    <cdr:to>
      <cdr:x>0.97014</cdr:x>
      <cdr:y>0.39695</cdr:y>
    </cdr:to>
    <cdr:sp macro="" textlink="">
      <cdr:nvSpPr>
        <cdr:cNvPr id="47" name="CasellaDiTesto 1">
          <a:extLst xmlns:a="http://schemas.openxmlformats.org/drawingml/2006/main">
            <a:ext uri="{FF2B5EF4-FFF2-40B4-BE49-F238E27FC236}">
              <a16:creationId xmlns:a16="http://schemas.microsoft.com/office/drawing/2014/main" id="{5FB30132-DD0F-40EC-9072-9A1CCDA436F0}"/>
            </a:ext>
          </a:extLst>
        </cdr:cNvPr>
        <cdr:cNvSpPr txBox="1"/>
      </cdr:nvSpPr>
      <cdr:spPr>
        <a:xfrm xmlns:a="http://schemas.openxmlformats.org/drawingml/2006/main">
          <a:off x="9908346" y="21479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647</cdr:x>
      <cdr:y>0.36606</cdr:y>
    </cdr:from>
    <cdr:to>
      <cdr:x>0.9775</cdr:x>
      <cdr:y>0.38694</cdr:y>
    </cdr:to>
    <cdr:sp macro="" textlink="">
      <cdr:nvSpPr>
        <cdr:cNvPr id="48" name="CasellaDiTesto 1">
          <a:extLst xmlns:a="http://schemas.openxmlformats.org/drawingml/2006/main">
            <a:ext uri="{FF2B5EF4-FFF2-40B4-BE49-F238E27FC236}">
              <a16:creationId xmlns:a16="http://schemas.microsoft.com/office/drawing/2014/main" id="{5FB30132-DD0F-40EC-9072-9A1CCDA436F0}"/>
            </a:ext>
          </a:extLst>
        </cdr:cNvPr>
        <cdr:cNvSpPr txBox="1"/>
      </cdr:nvSpPr>
      <cdr:spPr>
        <a:xfrm xmlns:a="http://schemas.openxmlformats.org/drawingml/2006/main">
          <a:off x="9984546" y="20908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4622</cdr:x>
      <cdr:y>0.8866</cdr:y>
    </cdr:from>
    <cdr:to>
      <cdr:x>0.38335</cdr:x>
      <cdr:y>0.94163</cdr:y>
    </cdr:to>
    <cdr:sp macro="" textlink="">
      <cdr:nvSpPr>
        <cdr:cNvPr id="49" name="CasellaDiTesto 1">
          <a:extLst xmlns:a="http://schemas.openxmlformats.org/drawingml/2006/main">
            <a:ext uri="{FF2B5EF4-FFF2-40B4-BE49-F238E27FC236}">
              <a16:creationId xmlns:a16="http://schemas.microsoft.com/office/drawing/2014/main" id="{7D62CF96-A96D-4AEE-98C6-F7DA1F74053F}"/>
            </a:ext>
          </a:extLst>
        </cdr:cNvPr>
        <cdr:cNvSpPr txBox="1"/>
      </cdr:nvSpPr>
      <cdr:spPr>
        <a:xfrm xmlns:a="http://schemas.openxmlformats.org/drawingml/2006/main">
          <a:off x="2548401" y="5063987"/>
          <a:ext cx="1419225" cy="314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200" b="1" dirty="0"/>
            <a:t>* = </a:t>
          </a:r>
          <a:r>
            <a:rPr lang="it-IT" sz="1200" b="1" i="1" dirty="0"/>
            <a:t>p</a:t>
          </a:r>
          <a:r>
            <a:rPr lang="it-IT" sz="1200" b="1" dirty="0"/>
            <a:t> &lt; 0.05</a:t>
          </a:r>
        </a:p>
      </cdr:txBody>
    </cdr:sp>
  </cdr:relSizeAnchor>
  <cdr:relSizeAnchor xmlns:cdr="http://schemas.openxmlformats.org/drawingml/2006/chartDrawing">
    <cdr:from>
      <cdr:x>0.61033</cdr:x>
      <cdr:y>0.41386</cdr:y>
    </cdr:from>
    <cdr:to>
      <cdr:x>0.62314</cdr:x>
      <cdr:y>0.43475</cdr:y>
    </cdr:to>
    <cdr:sp macro="" textlink="">
      <cdr:nvSpPr>
        <cdr:cNvPr id="50" name="CasellaDiTesto 1">
          <a:extLst xmlns:a="http://schemas.openxmlformats.org/drawingml/2006/main">
            <a:ext uri="{FF2B5EF4-FFF2-40B4-BE49-F238E27FC236}">
              <a16:creationId xmlns:a16="http://schemas.microsoft.com/office/drawing/2014/main" id="{A43BAECA-F7DD-40F3-8376-186229901FDA}"/>
            </a:ext>
          </a:extLst>
        </cdr:cNvPr>
        <cdr:cNvSpPr txBox="1"/>
      </cdr:nvSpPr>
      <cdr:spPr>
        <a:xfrm xmlns:a="http://schemas.openxmlformats.org/drawingml/2006/main">
          <a:off x="6316915" y="2363856"/>
          <a:ext cx="132574" cy="119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6684</cdr:x>
      <cdr:y>0.35897</cdr:y>
    </cdr:from>
    <cdr:to>
      <cdr:x>0.77964</cdr:x>
      <cdr:y>0.37986</cdr:y>
    </cdr:to>
    <cdr:sp macro="" textlink="">
      <cdr:nvSpPr>
        <cdr:cNvPr id="51" name="CasellaDiTesto 1">
          <a:extLst xmlns:a="http://schemas.openxmlformats.org/drawingml/2006/main">
            <a:ext uri="{FF2B5EF4-FFF2-40B4-BE49-F238E27FC236}">
              <a16:creationId xmlns:a16="http://schemas.microsoft.com/office/drawing/2014/main" id="{A43BAECA-F7DD-40F3-8376-186229901FDA}"/>
            </a:ext>
          </a:extLst>
        </cdr:cNvPr>
        <cdr:cNvSpPr txBox="1"/>
      </cdr:nvSpPr>
      <cdr:spPr>
        <a:xfrm xmlns:a="http://schemas.openxmlformats.org/drawingml/2006/main">
          <a:off x="7936709" y="2050347"/>
          <a:ext cx="132574" cy="119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4639</cdr:x>
      <cdr:y>0.40776</cdr:y>
    </cdr:from>
    <cdr:to>
      <cdr:x>0.55919</cdr:x>
      <cdr:y>0.42865</cdr:y>
    </cdr:to>
    <cdr:sp macro="" textlink="">
      <cdr:nvSpPr>
        <cdr:cNvPr id="52" name="CasellaDiTesto 1">
          <a:extLst xmlns:a="http://schemas.openxmlformats.org/drawingml/2006/main">
            <a:ext uri="{FF2B5EF4-FFF2-40B4-BE49-F238E27FC236}">
              <a16:creationId xmlns:a16="http://schemas.microsoft.com/office/drawing/2014/main" id="{A43BAECA-F7DD-40F3-8376-186229901FDA}"/>
            </a:ext>
          </a:extLst>
        </cdr:cNvPr>
        <cdr:cNvSpPr txBox="1"/>
      </cdr:nvSpPr>
      <cdr:spPr>
        <a:xfrm xmlns:a="http://schemas.openxmlformats.org/drawingml/2006/main">
          <a:off x="5655063" y="2329022"/>
          <a:ext cx="132574" cy="119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it-IT" sz="1100" dirty="0"/>
        </a:p>
      </cdr:txBody>
    </cdr:sp>
  </cdr:relSizeAnchor>
  <cdr:relSizeAnchor xmlns:cdr="http://schemas.openxmlformats.org/drawingml/2006/chartDrawing">
    <cdr:from>
      <cdr:x>0.80806</cdr:x>
      <cdr:y>0.41386</cdr:y>
    </cdr:from>
    <cdr:to>
      <cdr:x>0.82087</cdr:x>
      <cdr:y>0.43475</cdr:y>
    </cdr:to>
    <cdr:sp macro="" textlink="">
      <cdr:nvSpPr>
        <cdr:cNvPr id="53" name="CasellaDiTesto 1">
          <a:extLst xmlns:a="http://schemas.openxmlformats.org/drawingml/2006/main">
            <a:ext uri="{FF2B5EF4-FFF2-40B4-BE49-F238E27FC236}">
              <a16:creationId xmlns:a16="http://schemas.microsoft.com/office/drawing/2014/main" id="{A43BAECA-F7DD-40F3-8376-186229901FDA}"/>
            </a:ext>
          </a:extLst>
        </cdr:cNvPr>
        <cdr:cNvSpPr txBox="1"/>
      </cdr:nvSpPr>
      <cdr:spPr>
        <a:xfrm xmlns:a="http://schemas.openxmlformats.org/drawingml/2006/main">
          <a:off x="8363429" y="2363855"/>
          <a:ext cx="132574" cy="119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0314</cdr:x>
      <cdr:y>0.41081</cdr:y>
    </cdr:from>
    <cdr:to>
      <cdr:x>0.91595</cdr:x>
      <cdr:y>0.4317</cdr:y>
    </cdr:to>
    <cdr:sp macro="" textlink="">
      <cdr:nvSpPr>
        <cdr:cNvPr id="54" name="CasellaDiTesto 1">
          <a:extLst xmlns:a="http://schemas.openxmlformats.org/drawingml/2006/main">
            <a:ext uri="{FF2B5EF4-FFF2-40B4-BE49-F238E27FC236}">
              <a16:creationId xmlns:a16="http://schemas.microsoft.com/office/drawing/2014/main" id="{A43BAECA-F7DD-40F3-8376-186229901FDA}"/>
            </a:ext>
          </a:extLst>
        </cdr:cNvPr>
        <cdr:cNvSpPr txBox="1"/>
      </cdr:nvSpPr>
      <cdr:spPr>
        <a:xfrm xmlns:a="http://schemas.openxmlformats.org/drawingml/2006/main">
          <a:off x="9347498" y="2346439"/>
          <a:ext cx="132574" cy="119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08133</cdr:x>
      <cdr:y>0.43956</cdr:y>
    </cdr:from>
    <cdr:to>
      <cdr:x>0.09493</cdr:x>
      <cdr:y>0.45933</cdr:y>
    </cdr:to>
    <cdr:sp macro="" textlink="">
      <cdr:nvSpPr>
        <cdr:cNvPr id="2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792921" y="26527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08817</cdr:x>
      <cdr:y>0.44746</cdr:y>
    </cdr:from>
    <cdr:to>
      <cdr:x>0.10177</cdr:x>
      <cdr:y>0.46722</cdr:y>
    </cdr:to>
    <cdr:sp macro="" textlink="">
      <cdr:nvSpPr>
        <cdr:cNvPr id="3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859596" y="27004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1162</cdr:x>
      <cdr:y>0.44588</cdr:y>
    </cdr:from>
    <cdr:to>
      <cdr:x>0.12522</cdr:x>
      <cdr:y>0.46564</cdr:y>
    </cdr:to>
    <cdr:sp macro="" textlink="">
      <cdr:nvSpPr>
        <cdr:cNvPr id="4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1088196" y="26908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1944</cdr:x>
      <cdr:y>0.44588</cdr:y>
    </cdr:from>
    <cdr:to>
      <cdr:x>0.13303</cdr:x>
      <cdr:y>0.46564</cdr:y>
    </cdr:to>
    <cdr:sp macro="" textlink="">
      <cdr:nvSpPr>
        <cdr:cNvPr id="5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1164396" y="26908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4386</cdr:x>
      <cdr:y>0.43799</cdr:y>
    </cdr:from>
    <cdr:to>
      <cdr:x>0.15746</cdr:x>
      <cdr:y>0.45775</cdr:y>
    </cdr:to>
    <cdr:sp macro="" textlink="">
      <cdr:nvSpPr>
        <cdr:cNvPr id="6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1402521" y="26432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5168</cdr:x>
      <cdr:y>0.4715</cdr:y>
    </cdr:from>
    <cdr:to>
      <cdr:x>0.16527</cdr:x>
      <cdr:y>0.49126</cdr:y>
    </cdr:to>
    <cdr:sp macro="" textlink="">
      <cdr:nvSpPr>
        <cdr:cNvPr id="7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1478721" y="284549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7513</cdr:x>
      <cdr:y>0.43483</cdr:y>
    </cdr:from>
    <cdr:to>
      <cdr:x>0.18872</cdr:x>
      <cdr:y>0.45459</cdr:y>
    </cdr:to>
    <cdr:sp macro="" textlink="">
      <cdr:nvSpPr>
        <cdr:cNvPr id="8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1707321" y="26242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8295</cdr:x>
      <cdr:y>0.4222</cdr:y>
    </cdr:from>
    <cdr:to>
      <cdr:x>0.19654</cdr:x>
      <cdr:y>0.44197</cdr:y>
    </cdr:to>
    <cdr:sp macro="" textlink="">
      <cdr:nvSpPr>
        <cdr:cNvPr id="9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1783521" y="25480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3766</cdr:x>
      <cdr:y>0.52321</cdr:y>
    </cdr:from>
    <cdr:to>
      <cdr:x>0.25125</cdr:x>
      <cdr:y>0.54298</cdr:y>
    </cdr:to>
    <cdr:sp macro="" textlink="">
      <cdr:nvSpPr>
        <cdr:cNvPr id="10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2316921" y="31576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445</cdr:x>
      <cdr:y>0.52637</cdr:y>
    </cdr:from>
    <cdr:to>
      <cdr:x>0.25809</cdr:x>
      <cdr:y>0.54613</cdr:y>
    </cdr:to>
    <cdr:sp macro="" textlink="">
      <cdr:nvSpPr>
        <cdr:cNvPr id="11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2383596" y="31766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0117</cdr:x>
      <cdr:y>0.38432</cdr:y>
    </cdr:from>
    <cdr:to>
      <cdr:x>0.31476</cdr:x>
      <cdr:y>0.40409</cdr:y>
    </cdr:to>
    <cdr:sp macro="" textlink="">
      <cdr:nvSpPr>
        <cdr:cNvPr id="12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2936046" y="23194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0801</cdr:x>
      <cdr:y>0.37959</cdr:y>
    </cdr:from>
    <cdr:to>
      <cdr:x>0.3216</cdr:x>
      <cdr:y>0.39935</cdr:y>
    </cdr:to>
    <cdr:sp macro="" textlink="">
      <cdr:nvSpPr>
        <cdr:cNvPr id="13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3002721" y="22908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9496</cdr:x>
      <cdr:y>0.4715</cdr:y>
    </cdr:from>
    <cdr:to>
      <cdr:x>0.40856</cdr:x>
      <cdr:y>0.49126</cdr:y>
    </cdr:to>
    <cdr:sp macro="" textlink="">
      <cdr:nvSpPr>
        <cdr:cNvPr id="14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3850446" y="284549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018</cdr:x>
      <cdr:y>0.48138</cdr:y>
    </cdr:from>
    <cdr:to>
      <cdr:x>0.41539</cdr:x>
      <cdr:y>0.50114</cdr:y>
    </cdr:to>
    <cdr:sp macro="" textlink="">
      <cdr:nvSpPr>
        <cdr:cNvPr id="15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3917121" y="290513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2623</cdr:x>
      <cdr:y>0.14285</cdr:y>
    </cdr:from>
    <cdr:to>
      <cdr:x>0.43982</cdr:x>
      <cdr:y>0.16261</cdr:y>
    </cdr:to>
    <cdr:sp macro="" textlink="">
      <cdr:nvSpPr>
        <cdr:cNvPr id="16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4155246" y="8620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3307</cdr:x>
      <cdr:y>0.16494</cdr:y>
    </cdr:from>
    <cdr:to>
      <cdr:x>0.44666</cdr:x>
      <cdr:y>0.18471</cdr:y>
    </cdr:to>
    <cdr:sp macro="" textlink="">
      <cdr:nvSpPr>
        <cdr:cNvPr id="17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4221921" y="9954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5847</cdr:x>
      <cdr:y>0.15705</cdr:y>
    </cdr:from>
    <cdr:to>
      <cdr:x>0.47206</cdr:x>
      <cdr:y>0.17681</cdr:y>
    </cdr:to>
    <cdr:sp macro="" textlink="">
      <cdr:nvSpPr>
        <cdr:cNvPr id="18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4469571" y="9478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6433</cdr:x>
      <cdr:y>0.18704</cdr:y>
    </cdr:from>
    <cdr:to>
      <cdr:x>0.47792</cdr:x>
      <cdr:y>0.2068</cdr:y>
    </cdr:to>
    <cdr:sp macro="" textlink="">
      <cdr:nvSpPr>
        <cdr:cNvPr id="19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4526721" y="11287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2686</cdr:x>
      <cdr:y>0.54215</cdr:y>
    </cdr:from>
    <cdr:to>
      <cdr:x>0.54045</cdr:x>
      <cdr:y>0.56192</cdr:y>
    </cdr:to>
    <cdr:sp macro="" textlink="">
      <cdr:nvSpPr>
        <cdr:cNvPr id="20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5136321" y="32719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1852</cdr:x>
      <cdr:y>0.52795</cdr:y>
    </cdr:from>
    <cdr:to>
      <cdr:x>0.53211</cdr:x>
      <cdr:y>0.54771</cdr:y>
    </cdr:to>
    <cdr:sp macro="" textlink="">
      <cdr:nvSpPr>
        <cdr:cNvPr id="21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5054992" y="31861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5129</cdr:x>
      <cdr:y>0.53742</cdr:y>
    </cdr:from>
    <cdr:to>
      <cdr:x>0.56488</cdr:x>
      <cdr:y>0.55718</cdr:y>
    </cdr:to>
    <cdr:sp macro="" textlink="">
      <cdr:nvSpPr>
        <cdr:cNvPr id="22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5374446" y="32433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591</cdr:x>
      <cdr:y>0.5532</cdr:y>
    </cdr:from>
    <cdr:to>
      <cdr:x>0.5727</cdr:x>
      <cdr:y>0.57296</cdr:y>
    </cdr:to>
    <cdr:sp macro="" textlink="">
      <cdr:nvSpPr>
        <cdr:cNvPr id="23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5450646" y="33385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8353</cdr:x>
      <cdr:y>0.52795</cdr:y>
    </cdr:from>
    <cdr:to>
      <cdr:x>0.59712</cdr:x>
      <cdr:y>0.54771</cdr:y>
    </cdr:to>
    <cdr:sp macro="" textlink="">
      <cdr:nvSpPr>
        <cdr:cNvPr id="24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5688771" y="31861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8939</cdr:x>
      <cdr:y>0.54215</cdr:y>
    </cdr:from>
    <cdr:to>
      <cdr:x>0.60298</cdr:x>
      <cdr:y>0.56192</cdr:y>
    </cdr:to>
    <cdr:sp macro="" textlink="">
      <cdr:nvSpPr>
        <cdr:cNvPr id="25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5745921" y="32719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1479</cdr:x>
      <cdr:y>0.58003</cdr:y>
    </cdr:from>
    <cdr:to>
      <cdr:x>0.62839</cdr:x>
      <cdr:y>0.59979</cdr:y>
    </cdr:to>
    <cdr:sp macro="" textlink="">
      <cdr:nvSpPr>
        <cdr:cNvPr id="26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5993571" y="35005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2163</cdr:x>
      <cdr:y>0.55004</cdr:y>
    </cdr:from>
    <cdr:to>
      <cdr:x>0.63523</cdr:x>
      <cdr:y>0.56981</cdr:y>
    </cdr:to>
    <cdr:sp macro="" textlink="">
      <cdr:nvSpPr>
        <cdr:cNvPr id="27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6060246" y="33195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4508</cdr:x>
      <cdr:y>0.37959</cdr:y>
    </cdr:from>
    <cdr:to>
      <cdr:x>0.65868</cdr:x>
      <cdr:y>0.39935</cdr:y>
    </cdr:to>
    <cdr:sp macro="" textlink="">
      <cdr:nvSpPr>
        <cdr:cNvPr id="28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6288846" y="22908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5192</cdr:x>
      <cdr:y>0.36065</cdr:y>
    </cdr:from>
    <cdr:to>
      <cdr:x>0.66551</cdr:x>
      <cdr:y>0.38041</cdr:y>
    </cdr:to>
    <cdr:sp macro="" textlink="">
      <cdr:nvSpPr>
        <cdr:cNvPr id="29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6355521" y="21765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7732</cdr:x>
      <cdr:y>0.408</cdr:y>
    </cdr:from>
    <cdr:to>
      <cdr:x>0.69092</cdr:x>
      <cdr:y>0.42776</cdr:y>
    </cdr:to>
    <cdr:sp macro="" textlink="">
      <cdr:nvSpPr>
        <cdr:cNvPr id="30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6603171" y="24622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8319</cdr:x>
      <cdr:y>0.39853</cdr:y>
    </cdr:from>
    <cdr:to>
      <cdr:x>0.69678</cdr:x>
      <cdr:y>0.41829</cdr:y>
    </cdr:to>
    <cdr:sp macro="" textlink="">
      <cdr:nvSpPr>
        <cdr:cNvPr id="31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6660321" y="24051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0761</cdr:x>
      <cdr:y>0.41589</cdr:y>
    </cdr:from>
    <cdr:to>
      <cdr:x>0.72121</cdr:x>
      <cdr:y>0.43565</cdr:y>
    </cdr:to>
    <cdr:sp macro="" textlink="">
      <cdr:nvSpPr>
        <cdr:cNvPr id="32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6898446" y="25099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1543</cdr:x>
      <cdr:y>0.40169</cdr:y>
    </cdr:from>
    <cdr:to>
      <cdr:x>0.72902</cdr:x>
      <cdr:y>0.42145</cdr:y>
    </cdr:to>
    <cdr:sp macro="" textlink="">
      <cdr:nvSpPr>
        <cdr:cNvPr id="33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6974646" y="24241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3985</cdr:x>
      <cdr:y>0.41589</cdr:y>
    </cdr:from>
    <cdr:to>
      <cdr:x>0.75345</cdr:x>
      <cdr:y>0.43565</cdr:y>
    </cdr:to>
    <cdr:sp macro="" textlink="">
      <cdr:nvSpPr>
        <cdr:cNvPr id="34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7212771" y="25099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4669</cdr:x>
      <cdr:y>0.40484</cdr:y>
    </cdr:from>
    <cdr:to>
      <cdr:x>0.76029</cdr:x>
      <cdr:y>0.4246</cdr:y>
    </cdr:to>
    <cdr:sp macro="" textlink="">
      <cdr:nvSpPr>
        <cdr:cNvPr id="35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7279446" y="24432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7112</cdr:x>
      <cdr:y>0.41431</cdr:y>
    </cdr:from>
    <cdr:to>
      <cdr:x>0.78471</cdr:x>
      <cdr:y>0.43407</cdr:y>
    </cdr:to>
    <cdr:sp macro="" textlink="">
      <cdr:nvSpPr>
        <cdr:cNvPr id="36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7517571" y="25003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7796</cdr:x>
      <cdr:y>0.41431</cdr:y>
    </cdr:from>
    <cdr:to>
      <cdr:x>0.79155</cdr:x>
      <cdr:y>0.43407</cdr:y>
    </cdr:to>
    <cdr:sp macro="" textlink="">
      <cdr:nvSpPr>
        <cdr:cNvPr id="37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7584246" y="25003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80238</cdr:x>
      <cdr:y>0.52795</cdr:y>
    </cdr:from>
    <cdr:to>
      <cdr:x>0.81598</cdr:x>
      <cdr:y>0.54771</cdr:y>
    </cdr:to>
    <cdr:sp macro="" textlink="">
      <cdr:nvSpPr>
        <cdr:cNvPr id="38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7822371" y="31861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89716</cdr:x>
      <cdr:y>0.52479</cdr:y>
    </cdr:from>
    <cdr:to>
      <cdr:x>0.91075</cdr:x>
      <cdr:y>0.54455</cdr:y>
    </cdr:to>
    <cdr:sp macro="" textlink="">
      <cdr:nvSpPr>
        <cdr:cNvPr id="39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8746296" y="31671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2842</cdr:x>
      <cdr:y>0.48138</cdr:y>
    </cdr:from>
    <cdr:to>
      <cdr:x>0.94201</cdr:x>
      <cdr:y>0.50114</cdr:y>
    </cdr:to>
    <cdr:sp macro="" textlink="">
      <cdr:nvSpPr>
        <cdr:cNvPr id="40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9051096" y="290513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5871</cdr:x>
      <cdr:y>0.48138</cdr:y>
    </cdr:from>
    <cdr:to>
      <cdr:x>0.9723</cdr:x>
      <cdr:y>0.50114</cdr:y>
    </cdr:to>
    <cdr:sp macro="" textlink="">
      <cdr:nvSpPr>
        <cdr:cNvPr id="41" name="CasellaDiTesto 1">
          <a:extLst xmlns:a="http://schemas.openxmlformats.org/drawingml/2006/main">
            <a:ext uri="{FF2B5EF4-FFF2-40B4-BE49-F238E27FC236}">
              <a16:creationId xmlns:a16="http://schemas.microsoft.com/office/drawing/2014/main" id="{291070FD-70AF-47E8-8B0B-A1DD166D8B33}"/>
            </a:ext>
          </a:extLst>
        </cdr:cNvPr>
        <cdr:cNvSpPr txBox="1"/>
      </cdr:nvSpPr>
      <cdr:spPr>
        <a:xfrm xmlns:a="http://schemas.openxmlformats.org/drawingml/2006/main">
          <a:off x="9346371" y="290513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4577</cdr:x>
      <cdr:y>0.88789</cdr:y>
    </cdr:from>
    <cdr:to>
      <cdr:x>0.39135</cdr:x>
      <cdr:y>0.93997</cdr:y>
    </cdr:to>
    <cdr:sp macro="" textlink="">
      <cdr:nvSpPr>
        <cdr:cNvPr id="42" name="CasellaDiTesto 1">
          <a:extLst xmlns:a="http://schemas.openxmlformats.org/drawingml/2006/main">
            <a:ext uri="{FF2B5EF4-FFF2-40B4-BE49-F238E27FC236}">
              <a16:creationId xmlns:a16="http://schemas.microsoft.com/office/drawing/2014/main" id="{7D62CF96-A96D-4AEE-98C6-F7DA1F74053F}"/>
            </a:ext>
          </a:extLst>
        </cdr:cNvPr>
        <cdr:cNvSpPr txBox="1"/>
      </cdr:nvSpPr>
      <cdr:spPr>
        <a:xfrm xmlns:a="http://schemas.openxmlformats.org/drawingml/2006/main">
          <a:off x="2396001" y="5358423"/>
          <a:ext cx="1419225" cy="314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200" b="1" dirty="0"/>
            <a:t>* = </a:t>
          </a:r>
          <a:r>
            <a:rPr lang="it-IT" sz="1200" b="1" i="1" dirty="0"/>
            <a:t>p</a:t>
          </a:r>
          <a:r>
            <a:rPr lang="it-IT" sz="1200" b="1" dirty="0"/>
            <a:t> &lt; 0.05</a:t>
          </a:r>
        </a:p>
      </cdr:txBody>
    </cdr:sp>
  </cdr:relSizeAnchor>
  <cdr:relSizeAnchor xmlns:cdr="http://schemas.openxmlformats.org/drawingml/2006/chartDrawing">
    <cdr:from>
      <cdr:x>0.33221</cdr:x>
      <cdr:y>0.48023</cdr:y>
    </cdr:from>
    <cdr:to>
      <cdr:x>0.34581</cdr:x>
      <cdr:y>0.5</cdr:y>
    </cdr:to>
    <cdr:sp macro="" textlink="">
      <cdr:nvSpPr>
        <cdr:cNvPr id="43" name="CasellaDiTesto 1">
          <a:extLst xmlns:a="http://schemas.openxmlformats.org/drawingml/2006/main">
            <a:ext uri="{FF2B5EF4-FFF2-40B4-BE49-F238E27FC236}">
              <a16:creationId xmlns:a16="http://schemas.microsoft.com/office/drawing/2014/main" id="{A43BAECA-F7DD-40F3-8376-186229901FDA}"/>
            </a:ext>
          </a:extLst>
        </cdr:cNvPr>
        <cdr:cNvSpPr txBox="1"/>
      </cdr:nvSpPr>
      <cdr:spPr>
        <a:xfrm xmlns:a="http://schemas.openxmlformats.org/drawingml/2006/main">
          <a:off x="3238707" y="2898219"/>
          <a:ext cx="132574" cy="119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7032</cdr:x>
      <cdr:y>0.52697</cdr:y>
    </cdr:from>
    <cdr:to>
      <cdr:x>0.38392</cdr:x>
      <cdr:y>0.54674</cdr:y>
    </cdr:to>
    <cdr:sp macro="" textlink="">
      <cdr:nvSpPr>
        <cdr:cNvPr id="44" name="CasellaDiTesto 1">
          <a:extLst xmlns:a="http://schemas.openxmlformats.org/drawingml/2006/main">
            <a:ext uri="{FF2B5EF4-FFF2-40B4-BE49-F238E27FC236}">
              <a16:creationId xmlns:a16="http://schemas.microsoft.com/office/drawing/2014/main" id="{A43BAECA-F7DD-40F3-8376-186229901FDA}"/>
            </a:ext>
          </a:extLst>
        </cdr:cNvPr>
        <cdr:cNvSpPr txBox="1"/>
      </cdr:nvSpPr>
      <cdr:spPr>
        <a:xfrm xmlns:a="http://schemas.openxmlformats.org/drawingml/2006/main">
          <a:off x="3610182" y="3180284"/>
          <a:ext cx="132574" cy="119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07508</cdr:x>
      <cdr:y>0.32402</cdr:y>
    </cdr:from>
    <cdr:to>
      <cdr:x>0.08654</cdr:x>
      <cdr:y>0.34542</cdr:y>
    </cdr:to>
    <cdr:sp macro="" textlink="">
      <cdr:nvSpPr>
        <cdr:cNvPr id="2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868143" y="1805367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0015</cdr:x>
      <cdr:y>0.32402</cdr:y>
    </cdr:from>
    <cdr:to>
      <cdr:x>0.11161</cdr:x>
      <cdr:y>0.34542</cdr:y>
    </cdr:to>
    <cdr:sp macro="" textlink="">
      <cdr:nvSpPr>
        <cdr:cNvPr id="3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1158046" y="1805367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0756</cdr:x>
      <cdr:y>0.34542</cdr:y>
    </cdr:from>
    <cdr:to>
      <cdr:x>0.11902</cdr:x>
      <cdr:y>0.36683</cdr:y>
    </cdr:to>
    <cdr:sp macro="" textlink="">
      <cdr:nvSpPr>
        <cdr:cNvPr id="4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1243771" y="1924637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3227</cdr:x>
      <cdr:y>0.26128</cdr:y>
    </cdr:from>
    <cdr:to>
      <cdr:x>0.14373</cdr:x>
      <cdr:y>0.28269</cdr:y>
    </cdr:to>
    <cdr:sp macro="" textlink="">
      <cdr:nvSpPr>
        <cdr:cNvPr id="5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1529521" y="14558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3886</cdr:x>
      <cdr:y>0.22196</cdr:y>
    </cdr:from>
    <cdr:to>
      <cdr:x>0.15032</cdr:x>
      <cdr:y>0.24337</cdr:y>
    </cdr:to>
    <cdr:sp macro="" textlink="">
      <cdr:nvSpPr>
        <cdr:cNvPr id="6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1605721" y="12367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6439</cdr:x>
      <cdr:y>0.35613</cdr:y>
    </cdr:from>
    <cdr:to>
      <cdr:x>0.17585</cdr:x>
      <cdr:y>0.37753</cdr:y>
    </cdr:to>
    <cdr:sp macro="" textlink="">
      <cdr:nvSpPr>
        <cdr:cNvPr id="7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1900996" y="1984272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7098</cdr:x>
      <cdr:y>0.32402</cdr:y>
    </cdr:from>
    <cdr:to>
      <cdr:x>0.18244</cdr:x>
      <cdr:y>0.34542</cdr:y>
    </cdr:to>
    <cdr:sp macro="" textlink="">
      <cdr:nvSpPr>
        <cdr:cNvPr id="8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1977196" y="1805367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9569</cdr:x>
      <cdr:y>0.33472</cdr:y>
    </cdr:from>
    <cdr:to>
      <cdr:x>0.20716</cdr:x>
      <cdr:y>0.35613</cdr:y>
    </cdr:to>
    <cdr:sp macro="" textlink="">
      <cdr:nvSpPr>
        <cdr:cNvPr id="9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2262946" y="1865002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0311</cdr:x>
      <cdr:y>0.32402</cdr:y>
    </cdr:from>
    <cdr:to>
      <cdr:x>0.21457</cdr:x>
      <cdr:y>0.34542</cdr:y>
    </cdr:to>
    <cdr:sp macro="" textlink="">
      <cdr:nvSpPr>
        <cdr:cNvPr id="10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2348671" y="1805367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2782</cdr:x>
      <cdr:y>0.35613</cdr:y>
    </cdr:from>
    <cdr:to>
      <cdr:x>0.23928</cdr:x>
      <cdr:y>0.37753</cdr:y>
    </cdr:to>
    <cdr:sp macro="" textlink="">
      <cdr:nvSpPr>
        <cdr:cNvPr id="11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2634421" y="1984272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3441</cdr:x>
      <cdr:y>0.34542</cdr:y>
    </cdr:from>
    <cdr:to>
      <cdr:x>0.24587</cdr:x>
      <cdr:y>0.36683</cdr:y>
    </cdr:to>
    <cdr:sp macro="" textlink="">
      <cdr:nvSpPr>
        <cdr:cNvPr id="12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2710621" y="1924637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5912</cdr:x>
      <cdr:y>0.23051</cdr:y>
    </cdr:from>
    <cdr:to>
      <cdr:x>0.27058</cdr:x>
      <cdr:y>0.25192</cdr:y>
    </cdr:to>
    <cdr:sp macro="" textlink="">
      <cdr:nvSpPr>
        <cdr:cNvPr id="13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2996371" y="12843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6653</cdr:x>
      <cdr:y>0.19119</cdr:y>
    </cdr:from>
    <cdr:to>
      <cdr:x>0.27799</cdr:x>
      <cdr:y>0.2126</cdr:y>
    </cdr:to>
    <cdr:sp macro="" textlink="">
      <cdr:nvSpPr>
        <cdr:cNvPr id="14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3082096" y="10652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9207</cdr:x>
      <cdr:y>0.33472</cdr:y>
    </cdr:from>
    <cdr:to>
      <cdr:x>0.30353</cdr:x>
      <cdr:y>0.35613</cdr:y>
    </cdr:to>
    <cdr:sp macro="" textlink="">
      <cdr:nvSpPr>
        <cdr:cNvPr id="15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3377371" y="1865002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0031</cdr:x>
      <cdr:y>0.32402</cdr:y>
    </cdr:from>
    <cdr:to>
      <cdr:x>0.31177</cdr:x>
      <cdr:y>0.34542</cdr:y>
    </cdr:to>
    <cdr:sp macro="" textlink="">
      <cdr:nvSpPr>
        <cdr:cNvPr id="16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3472621" y="1805367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2337</cdr:x>
      <cdr:y>0.4083</cdr:y>
    </cdr:from>
    <cdr:to>
      <cdr:x>0.33483</cdr:x>
      <cdr:y>0.4297</cdr:y>
    </cdr:to>
    <cdr:sp macro="" textlink="">
      <cdr:nvSpPr>
        <cdr:cNvPr id="17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3739321" y="22749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3078</cdr:x>
      <cdr:y>0.41684</cdr:y>
    </cdr:from>
    <cdr:to>
      <cdr:x>0.34224</cdr:x>
      <cdr:y>0.43825</cdr:y>
    </cdr:to>
    <cdr:sp macro="" textlink="">
      <cdr:nvSpPr>
        <cdr:cNvPr id="18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3825046" y="23225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8762</cdr:x>
      <cdr:y>0.41514</cdr:y>
    </cdr:from>
    <cdr:to>
      <cdr:x>0.39908</cdr:x>
      <cdr:y>0.43654</cdr:y>
    </cdr:to>
    <cdr:sp macro="" textlink="">
      <cdr:nvSpPr>
        <cdr:cNvPr id="19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4482271" y="23130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9421</cdr:x>
      <cdr:y>0.42881</cdr:y>
    </cdr:from>
    <cdr:to>
      <cdr:x>0.40567</cdr:x>
      <cdr:y>0.45022</cdr:y>
    </cdr:to>
    <cdr:sp macro="" textlink="">
      <cdr:nvSpPr>
        <cdr:cNvPr id="20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4558471" y="23892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6208</cdr:x>
      <cdr:y>0.42026</cdr:y>
    </cdr:from>
    <cdr:to>
      <cdr:x>0.37354</cdr:x>
      <cdr:y>0.44167</cdr:y>
    </cdr:to>
    <cdr:sp macro="" textlink="">
      <cdr:nvSpPr>
        <cdr:cNvPr id="21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4186996" y="23416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1892</cdr:x>
      <cdr:y>0.16726</cdr:y>
    </cdr:from>
    <cdr:to>
      <cdr:x>0.43038</cdr:x>
      <cdr:y>0.18866</cdr:y>
    </cdr:to>
    <cdr:sp macro="" textlink="">
      <cdr:nvSpPr>
        <cdr:cNvPr id="22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4844221" y="9319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2633</cdr:x>
      <cdr:y>0.16213</cdr:y>
    </cdr:from>
    <cdr:to>
      <cdr:x>0.43779</cdr:x>
      <cdr:y>0.18354</cdr:y>
    </cdr:to>
    <cdr:sp macro="" textlink="">
      <cdr:nvSpPr>
        <cdr:cNvPr id="23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4929946" y="9033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5104</cdr:x>
      <cdr:y>0.17581</cdr:y>
    </cdr:from>
    <cdr:to>
      <cdr:x>0.4625</cdr:x>
      <cdr:y>0.19721</cdr:y>
    </cdr:to>
    <cdr:sp macro="" textlink="">
      <cdr:nvSpPr>
        <cdr:cNvPr id="24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5215696" y="9795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5928</cdr:x>
      <cdr:y>0.18093</cdr:y>
    </cdr:from>
    <cdr:to>
      <cdr:x>0.47074</cdr:x>
      <cdr:y>0.20234</cdr:y>
    </cdr:to>
    <cdr:sp macro="" textlink="">
      <cdr:nvSpPr>
        <cdr:cNvPr id="25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5310946" y="10081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8234</cdr:x>
      <cdr:y>0.61344</cdr:y>
    </cdr:from>
    <cdr:to>
      <cdr:x>0.4938</cdr:x>
      <cdr:y>0.63484</cdr:y>
    </cdr:to>
    <cdr:sp macro="" textlink="">
      <cdr:nvSpPr>
        <cdr:cNvPr id="26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5577646" y="34179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8854</cdr:x>
      <cdr:y>0.61344</cdr:y>
    </cdr:from>
    <cdr:to>
      <cdr:x>0.5</cdr:x>
      <cdr:y>0.63484</cdr:y>
    </cdr:to>
    <cdr:sp macro="" textlink="">
      <cdr:nvSpPr>
        <cdr:cNvPr id="27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5649299" y="34179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15</cdr:x>
      <cdr:y>0.41855</cdr:y>
    </cdr:from>
    <cdr:to>
      <cdr:x>0.52646</cdr:x>
      <cdr:y>0.43996</cdr:y>
    </cdr:to>
    <cdr:sp macro="" textlink="">
      <cdr:nvSpPr>
        <cdr:cNvPr id="28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5955321" y="23321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227</cdr:x>
      <cdr:y>0.4271</cdr:y>
    </cdr:from>
    <cdr:to>
      <cdr:x>0.53417</cdr:x>
      <cdr:y>0.44851</cdr:y>
    </cdr:to>
    <cdr:sp macro="" textlink="">
      <cdr:nvSpPr>
        <cdr:cNvPr id="29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6044371" y="23797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4742</cdr:x>
      <cdr:y>0.41514</cdr:y>
    </cdr:from>
    <cdr:to>
      <cdr:x>0.55888</cdr:x>
      <cdr:y>0.43654</cdr:y>
    </cdr:to>
    <cdr:sp macro="" textlink="">
      <cdr:nvSpPr>
        <cdr:cNvPr id="30" name="CasellaDiTesto 1">
          <a:extLst xmlns:a="http://schemas.openxmlformats.org/drawingml/2006/main">
            <a:ext uri="{FF2B5EF4-FFF2-40B4-BE49-F238E27FC236}">
              <a16:creationId xmlns:a16="http://schemas.microsoft.com/office/drawing/2014/main" id="{477B7EDD-AA2E-43A2-B34F-8757EC30CEFF}"/>
            </a:ext>
          </a:extLst>
        </cdr:cNvPr>
        <cdr:cNvSpPr txBox="1"/>
      </cdr:nvSpPr>
      <cdr:spPr>
        <a:xfrm xmlns:a="http://schemas.openxmlformats.org/drawingml/2006/main">
          <a:off x="6330121" y="23130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7981</cdr:x>
      <cdr:y>0.42596</cdr:y>
    </cdr:from>
    <cdr:to>
      <cdr:x>0.59128</cdr:x>
      <cdr:y>0.44737</cdr:y>
    </cdr:to>
    <cdr:sp macro="" textlink="">
      <cdr:nvSpPr>
        <cdr:cNvPr id="31" name="CasellaDiTesto 1">
          <a:extLst xmlns:a="http://schemas.openxmlformats.org/drawingml/2006/main">
            <a:ext uri="{FF2B5EF4-FFF2-40B4-BE49-F238E27FC236}">
              <a16:creationId xmlns:a16="http://schemas.microsoft.com/office/drawing/2014/main" id="{49E626B4-59C8-4F1B-9AB9-7CD20CFA1B57}"/>
            </a:ext>
          </a:extLst>
        </cdr:cNvPr>
        <cdr:cNvSpPr txBox="1"/>
      </cdr:nvSpPr>
      <cdr:spPr>
        <a:xfrm xmlns:a="http://schemas.openxmlformats.org/drawingml/2006/main">
          <a:off x="6704771" y="23733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864</cdr:x>
      <cdr:y>0.42596</cdr:y>
    </cdr:from>
    <cdr:to>
      <cdr:x>0.59786</cdr:x>
      <cdr:y>0.44737</cdr:y>
    </cdr:to>
    <cdr:sp macro="" textlink="">
      <cdr:nvSpPr>
        <cdr:cNvPr id="32" name="CasellaDiTesto 1">
          <a:extLst xmlns:a="http://schemas.openxmlformats.org/drawingml/2006/main">
            <a:ext uri="{FF2B5EF4-FFF2-40B4-BE49-F238E27FC236}">
              <a16:creationId xmlns:a16="http://schemas.microsoft.com/office/drawing/2014/main" id="{49E626B4-59C8-4F1B-9AB9-7CD20CFA1B57}"/>
            </a:ext>
          </a:extLst>
        </cdr:cNvPr>
        <cdr:cNvSpPr txBox="1"/>
      </cdr:nvSpPr>
      <cdr:spPr>
        <a:xfrm xmlns:a="http://schemas.openxmlformats.org/drawingml/2006/main">
          <a:off x="6780971" y="23733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1112</cdr:x>
      <cdr:y>0.42596</cdr:y>
    </cdr:from>
    <cdr:to>
      <cdr:x>0.62258</cdr:x>
      <cdr:y>0.44737</cdr:y>
    </cdr:to>
    <cdr:sp macro="" textlink="">
      <cdr:nvSpPr>
        <cdr:cNvPr id="33" name="CasellaDiTesto 1">
          <a:extLst xmlns:a="http://schemas.openxmlformats.org/drawingml/2006/main">
            <a:ext uri="{FF2B5EF4-FFF2-40B4-BE49-F238E27FC236}">
              <a16:creationId xmlns:a16="http://schemas.microsoft.com/office/drawing/2014/main" id="{49E626B4-59C8-4F1B-9AB9-7CD20CFA1B57}"/>
            </a:ext>
          </a:extLst>
        </cdr:cNvPr>
        <cdr:cNvSpPr txBox="1"/>
      </cdr:nvSpPr>
      <cdr:spPr>
        <a:xfrm xmlns:a="http://schemas.openxmlformats.org/drawingml/2006/main">
          <a:off x="7066721" y="23733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1853</cdr:x>
      <cdr:y>0.44306</cdr:y>
    </cdr:from>
    <cdr:to>
      <cdr:x>0.62999</cdr:x>
      <cdr:y>0.46446</cdr:y>
    </cdr:to>
    <cdr:sp macro="" textlink="">
      <cdr:nvSpPr>
        <cdr:cNvPr id="34" name="CasellaDiTesto 1">
          <a:extLst xmlns:a="http://schemas.openxmlformats.org/drawingml/2006/main">
            <a:ext uri="{FF2B5EF4-FFF2-40B4-BE49-F238E27FC236}">
              <a16:creationId xmlns:a16="http://schemas.microsoft.com/office/drawing/2014/main" id="{49E626B4-59C8-4F1B-9AB9-7CD20CFA1B57}"/>
            </a:ext>
          </a:extLst>
        </cdr:cNvPr>
        <cdr:cNvSpPr txBox="1"/>
      </cdr:nvSpPr>
      <cdr:spPr>
        <a:xfrm xmlns:a="http://schemas.openxmlformats.org/drawingml/2006/main">
          <a:off x="7152446" y="24686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4324</cdr:x>
      <cdr:y>0.35613</cdr:y>
    </cdr:from>
    <cdr:to>
      <cdr:x>0.6547</cdr:x>
      <cdr:y>0.37753</cdr:y>
    </cdr:to>
    <cdr:sp macro="" textlink="">
      <cdr:nvSpPr>
        <cdr:cNvPr id="35" name="CasellaDiTesto 1">
          <a:extLst xmlns:a="http://schemas.openxmlformats.org/drawingml/2006/main">
            <a:ext uri="{FF2B5EF4-FFF2-40B4-BE49-F238E27FC236}">
              <a16:creationId xmlns:a16="http://schemas.microsoft.com/office/drawing/2014/main" id="{49E626B4-59C8-4F1B-9AB9-7CD20CFA1B57}"/>
            </a:ext>
          </a:extLst>
        </cdr:cNvPr>
        <cdr:cNvSpPr txBox="1"/>
      </cdr:nvSpPr>
      <cdr:spPr>
        <a:xfrm xmlns:a="http://schemas.openxmlformats.org/drawingml/2006/main">
          <a:off x="7438196" y="1984272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5065</cdr:x>
      <cdr:y>0.35613</cdr:y>
    </cdr:from>
    <cdr:to>
      <cdr:x>0.66211</cdr:x>
      <cdr:y>0.37753</cdr:y>
    </cdr:to>
    <cdr:sp macro="" textlink="">
      <cdr:nvSpPr>
        <cdr:cNvPr id="36" name="CasellaDiTesto 1">
          <a:extLst xmlns:a="http://schemas.openxmlformats.org/drawingml/2006/main">
            <a:ext uri="{FF2B5EF4-FFF2-40B4-BE49-F238E27FC236}">
              <a16:creationId xmlns:a16="http://schemas.microsoft.com/office/drawing/2014/main" id="{49E626B4-59C8-4F1B-9AB9-7CD20CFA1B57}"/>
            </a:ext>
          </a:extLst>
        </cdr:cNvPr>
        <cdr:cNvSpPr txBox="1"/>
      </cdr:nvSpPr>
      <cdr:spPr>
        <a:xfrm xmlns:a="http://schemas.openxmlformats.org/drawingml/2006/main">
          <a:off x="7523921" y="1984272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7536</cdr:x>
      <cdr:y>0.31143</cdr:y>
    </cdr:from>
    <cdr:to>
      <cdr:x>0.68682</cdr:x>
      <cdr:y>0.33283</cdr:y>
    </cdr:to>
    <cdr:sp macro="" textlink="">
      <cdr:nvSpPr>
        <cdr:cNvPr id="37" name="CasellaDiTesto 1">
          <a:extLst xmlns:a="http://schemas.openxmlformats.org/drawingml/2006/main">
            <a:ext uri="{FF2B5EF4-FFF2-40B4-BE49-F238E27FC236}">
              <a16:creationId xmlns:a16="http://schemas.microsoft.com/office/drawing/2014/main" id="{49E626B4-59C8-4F1B-9AB9-7CD20CFA1B57}"/>
            </a:ext>
          </a:extLst>
        </cdr:cNvPr>
        <cdr:cNvSpPr txBox="1"/>
      </cdr:nvSpPr>
      <cdr:spPr>
        <a:xfrm xmlns:a="http://schemas.openxmlformats.org/drawingml/2006/main">
          <a:off x="7809671" y="17352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8195</cdr:x>
      <cdr:y>0.40374</cdr:y>
    </cdr:from>
    <cdr:to>
      <cdr:x>0.69341</cdr:x>
      <cdr:y>0.42514</cdr:y>
    </cdr:to>
    <cdr:sp macro="" textlink="">
      <cdr:nvSpPr>
        <cdr:cNvPr id="38" name="CasellaDiTesto 1">
          <a:extLst xmlns:a="http://schemas.openxmlformats.org/drawingml/2006/main">
            <a:ext uri="{FF2B5EF4-FFF2-40B4-BE49-F238E27FC236}">
              <a16:creationId xmlns:a16="http://schemas.microsoft.com/office/drawing/2014/main" id="{49E626B4-59C8-4F1B-9AB9-7CD20CFA1B57}"/>
            </a:ext>
          </a:extLst>
        </cdr:cNvPr>
        <cdr:cNvSpPr txBox="1"/>
      </cdr:nvSpPr>
      <cdr:spPr>
        <a:xfrm xmlns:a="http://schemas.openxmlformats.org/drawingml/2006/main">
          <a:off x="7885871" y="22495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0776</cdr:x>
      <cdr:y>0.34542</cdr:y>
    </cdr:from>
    <cdr:to>
      <cdr:x>0.71922</cdr:x>
      <cdr:y>0.36683</cdr:y>
    </cdr:to>
    <cdr:sp macro="" textlink="">
      <cdr:nvSpPr>
        <cdr:cNvPr id="39" name="CasellaDiTesto 1">
          <a:extLst xmlns:a="http://schemas.openxmlformats.org/drawingml/2006/main">
            <a:ext uri="{FF2B5EF4-FFF2-40B4-BE49-F238E27FC236}">
              <a16:creationId xmlns:a16="http://schemas.microsoft.com/office/drawing/2014/main" id="{622BBF97-8F88-43D9-B3DA-4A14F1909656}"/>
            </a:ext>
          </a:extLst>
        </cdr:cNvPr>
        <cdr:cNvSpPr txBox="1"/>
      </cdr:nvSpPr>
      <cdr:spPr>
        <a:xfrm xmlns:a="http://schemas.openxmlformats.org/drawingml/2006/main">
          <a:off x="8184321" y="1924637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1518</cdr:x>
      <cdr:y>0.33472</cdr:y>
    </cdr:from>
    <cdr:to>
      <cdr:x>0.72664</cdr:x>
      <cdr:y>0.35613</cdr:y>
    </cdr:to>
    <cdr:sp macro="" textlink="">
      <cdr:nvSpPr>
        <cdr:cNvPr id="40" name="CasellaDiTesto 1">
          <a:extLst xmlns:a="http://schemas.openxmlformats.org/drawingml/2006/main">
            <a:ext uri="{FF2B5EF4-FFF2-40B4-BE49-F238E27FC236}">
              <a16:creationId xmlns:a16="http://schemas.microsoft.com/office/drawing/2014/main" id="{622BBF97-8F88-43D9-B3DA-4A14F1909656}"/>
            </a:ext>
          </a:extLst>
        </cdr:cNvPr>
        <cdr:cNvSpPr txBox="1"/>
      </cdr:nvSpPr>
      <cdr:spPr>
        <a:xfrm xmlns:a="http://schemas.openxmlformats.org/drawingml/2006/main">
          <a:off x="8270046" y="1865002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4648</cdr:x>
      <cdr:y>0.35613</cdr:y>
    </cdr:from>
    <cdr:to>
      <cdr:x>0.75794</cdr:x>
      <cdr:y>0.37753</cdr:y>
    </cdr:to>
    <cdr:sp macro="" textlink="">
      <cdr:nvSpPr>
        <cdr:cNvPr id="41" name="CasellaDiTesto 1">
          <a:extLst xmlns:a="http://schemas.openxmlformats.org/drawingml/2006/main">
            <a:ext uri="{FF2B5EF4-FFF2-40B4-BE49-F238E27FC236}">
              <a16:creationId xmlns:a16="http://schemas.microsoft.com/office/drawing/2014/main" id="{622BBF97-8F88-43D9-B3DA-4A14F1909656}"/>
            </a:ext>
          </a:extLst>
        </cdr:cNvPr>
        <cdr:cNvSpPr txBox="1"/>
      </cdr:nvSpPr>
      <cdr:spPr>
        <a:xfrm xmlns:a="http://schemas.openxmlformats.org/drawingml/2006/main">
          <a:off x="8631996" y="1984272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81155</cdr:x>
      <cdr:y>0.41457</cdr:y>
    </cdr:from>
    <cdr:to>
      <cdr:x>0.82301</cdr:x>
      <cdr:y>0.43597</cdr:y>
    </cdr:to>
    <cdr:sp macro="" textlink="">
      <cdr:nvSpPr>
        <cdr:cNvPr id="42" name="CasellaDiTesto 1">
          <a:extLst xmlns:a="http://schemas.openxmlformats.org/drawingml/2006/main">
            <a:ext uri="{FF2B5EF4-FFF2-40B4-BE49-F238E27FC236}">
              <a16:creationId xmlns:a16="http://schemas.microsoft.com/office/drawing/2014/main" id="{622BBF97-8F88-43D9-B3DA-4A14F1909656}"/>
            </a:ext>
          </a:extLst>
        </cdr:cNvPr>
        <cdr:cNvSpPr txBox="1"/>
      </cdr:nvSpPr>
      <cdr:spPr>
        <a:xfrm xmlns:a="http://schemas.openxmlformats.org/drawingml/2006/main">
          <a:off x="9384471" y="23098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7119</cdr:x>
      <cdr:y>0.35613</cdr:y>
    </cdr:from>
    <cdr:to>
      <cdr:x>0.78265</cdr:x>
      <cdr:y>0.37753</cdr:y>
    </cdr:to>
    <cdr:sp macro="" textlink="">
      <cdr:nvSpPr>
        <cdr:cNvPr id="43" name="CasellaDiTesto 1">
          <a:extLst xmlns:a="http://schemas.openxmlformats.org/drawingml/2006/main">
            <a:ext uri="{FF2B5EF4-FFF2-40B4-BE49-F238E27FC236}">
              <a16:creationId xmlns:a16="http://schemas.microsoft.com/office/drawing/2014/main" id="{622BBF97-8F88-43D9-B3DA-4A14F1909656}"/>
            </a:ext>
          </a:extLst>
        </cdr:cNvPr>
        <cdr:cNvSpPr txBox="1"/>
      </cdr:nvSpPr>
      <cdr:spPr>
        <a:xfrm xmlns:a="http://schemas.openxmlformats.org/drawingml/2006/main">
          <a:off x="8917746" y="1984272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786</cdr:x>
      <cdr:y>0.34542</cdr:y>
    </cdr:from>
    <cdr:to>
      <cdr:x>0.79006</cdr:x>
      <cdr:y>0.36683</cdr:y>
    </cdr:to>
    <cdr:sp macro="" textlink="">
      <cdr:nvSpPr>
        <cdr:cNvPr id="44" name="CasellaDiTesto 1">
          <a:extLst xmlns:a="http://schemas.openxmlformats.org/drawingml/2006/main">
            <a:ext uri="{FF2B5EF4-FFF2-40B4-BE49-F238E27FC236}">
              <a16:creationId xmlns:a16="http://schemas.microsoft.com/office/drawing/2014/main" id="{622BBF97-8F88-43D9-B3DA-4A14F1909656}"/>
            </a:ext>
          </a:extLst>
        </cdr:cNvPr>
        <cdr:cNvSpPr txBox="1"/>
      </cdr:nvSpPr>
      <cdr:spPr>
        <a:xfrm xmlns:a="http://schemas.openxmlformats.org/drawingml/2006/main">
          <a:off x="9003471" y="1924637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86674</cdr:x>
      <cdr:y>0.36683</cdr:y>
    </cdr:from>
    <cdr:to>
      <cdr:x>0.8782</cdr:x>
      <cdr:y>0.38823</cdr:y>
    </cdr:to>
    <cdr:sp macro="" textlink="">
      <cdr:nvSpPr>
        <cdr:cNvPr id="45" name="CasellaDiTesto 1">
          <a:extLst xmlns:a="http://schemas.openxmlformats.org/drawingml/2006/main">
            <a:ext uri="{FF2B5EF4-FFF2-40B4-BE49-F238E27FC236}">
              <a16:creationId xmlns:a16="http://schemas.microsoft.com/office/drawing/2014/main" id="{622BBF97-8F88-43D9-B3DA-4A14F1909656}"/>
            </a:ext>
          </a:extLst>
        </cdr:cNvPr>
        <cdr:cNvSpPr txBox="1"/>
      </cdr:nvSpPr>
      <cdr:spPr>
        <a:xfrm xmlns:a="http://schemas.openxmlformats.org/drawingml/2006/main">
          <a:off x="10022646" y="2043907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87415</cdr:x>
      <cdr:y>0.34542</cdr:y>
    </cdr:from>
    <cdr:to>
      <cdr:x>0.88561</cdr:x>
      <cdr:y>0.36683</cdr:y>
    </cdr:to>
    <cdr:sp macro="" textlink="">
      <cdr:nvSpPr>
        <cdr:cNvPr id="46" name="CasellaDiTesto 1">
          <a:extLst xmlns:a="http://schemas.openxmlformats.org/drawingml/2006/main">
            <a:ext uri="{FF2B5EF4-FFF2-40B4-BE49-F238E27FC236}">
              <a16:creationId xmlns:a16="http://schemas.microsoft.com/office/drawing/2014/main" id="{622BBF97-8F88-43D9-B3DA-4A14F1909656}"/>
            </a:ext>
          </a:extLst>
        </cdr:cNvPr>
        <cdr:cNvSpPr txBox="1"/>
      </cdr:nvSpPr>
      <cdr:spPr>
        <a:xfrm xmlns:a="http://schemas.openxmlformats.org/drawingml/2006/main">
          <a:off x="10108371" y="1924637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89969</cdr:x>
      <cdr:y>0.35613</cdr:y>
    </cdr:from>
    <cdr:to>
      <cdr:x>0.91115</cdr:x>
      <cdr:y>0.37753</cdr:y>
    </cdr:to>
    <cdr:sp macro="" textlink="">
      <cdr:nvSpPr>
        <cdr:cNvPr id="47" name="CasellaDiTesto 1">
          <a:extLst xmlns:a="http://schemas.openxmlformats.org/drawingml/2006/main">
            <a:ext uri="{FF2B5EF4-FFF2-40B4-BE49-F238E27FC236}">
              <a16:creationId xmlns:a16="http://schemas.microsoft.com/office/drawing/2014/main" id="{622BBF97-8F88-43D9-B3DA-4A14F1909656}"/>
            </a:ext>
          </a:extLst>
        </cdr:cNvPr>
        <cdr:cNvSpPr txBox="1"/>
      </cdr:nvSpPr>
      <cdr:spPr>
        <a:xfrm xmlns:a="http://schemas.openxmlformats.org/drawingml/2006/main">
          <a:off x="10403646" y="1984272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3181</cdr:x>
      <cdr:y>0.34542</cdr:y>
    </cdr:from>
    <cdr:to>
      <cdr:x>0.94327</cdr:x>
      <cdr:y>0.36683</cdr:y>
    </cdr:to>
    <cdr:sp macro="" textlink="">
      <cdr:nvSpPr>
        <cdr:cNvPr id="48" name="CasellaDiTesto 1">
          <a:extLst xmlns:a="http://schemas.openxmlformats.org/drawingml/2006/main">
            <a:ext uri="{FF2B5EF4-FFF2-40B4-BE49-F238E27FC236}">
              <a16:creationId xmlns:a16="http://schemas.microsoft.com/office/drawing/2014/main" id="{622BBF97-8F88-43D9-B3DA-4A14F1909656}"/>
            </a:ext>
          </a:extLst>
        </cdr:cNvPr>
        <cdr:cNvSpPr txBox="1"/>
      </cdr:nvSpPr>
      <cdr:spPr>
        <a:xfrm xmlns:a="http://schemas.openxmlformats.org/drawingml/2006/main">
          <a:off x="10775121" y="1924637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384</cdr:x>
      <cdr:y>0.36683</cdr:y>
    </cdr:from>
    <cdr:to>
      <cdr:x>0.94986</cdr:x>
      <cdr:y>0.38823</cdr:y>
    </cdr:to>
    <cdr:sp macro="" textlink="">
      <cdr:nvSpPr>
        <cdr:cNvPr id="49" name="CasellaDiTesto 1">
          <a:extLst xmlns:a="http://schemas.openxmlformats.org/drawingml/2006/main">
            <a:ext uri="{FF2B5EF4-FFF2-40B4-BE49-F238E27FC236}">
              <a16:creationId xmlns:a16="http://schemas.microsoft.com/office/drawing/2014/main" id="{622BBF97-8F88-43D9-B3DA-4A14F1909656}"/>
            </a:ext>
          </a:extLst>
        </cdr:cNvPr>
        <cdr:cNvSpPr txBox="1"/>
      </cdr:nvSpPr>
      <cdr:spPr>
        <a:xfrm xmlns:a="http://schemas.openxmlformats.org/drawingml/2006/main">
          <a:off x="10851321" y="2043907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697</cdr:x>
      <cdr:y>0.35613</cdr:y>
    </cdr:from>
    <cdr:to>
      <cdr:x>0.98116</cdr:x>
      <cdr:y>0.37753</cdr:y>
    </cdr:to>
    <cdr:sp macro="" textlink="">
      <cdr:nvSpPr>
        <cdr:cNvPr id="50" name="CasellaDiTesto 1">
          <a:extLst xmlns:a="http://schemas.openxmlformats.org/drawingml/2006/main">
            <a:ext uri="{FF2B5EF4-FFF2-40B4-BE49-F238E27FC236}">
              <a16:creationId xmlns:a16="http://schemas.microsoft.com/office/drawing/2014/main" id="{622BBF97-8F88-43D9-B3DA-4A14F1909656}"/>
            </a:ext>
          </a:extLst>
        </cdr:cNvPr>
        <cdr:cNvSpPr txBox="1"/>
      </cdr:nvSpPr>
      <cdr:spPr>
        <a:xfrm xmlns:a="http://schemas.openxmlformats.org/drawingml/2006/main">
          <a:off x="11213271" y="1984272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3274</cdr:x>
      <cdr:y>0.88375</cdr:y>
    </cdr:from>
    <cdr:to>
      <cdr:x>0.35547</cdr:x>
      <cdr:y>0.94017</cdr:y>
    </cdr:to>
    <cdr:sp macro="" textlink="">
      <cdr:nvSpPr>
        <cdr:cNvPr id="51" name="CasellaDiTesto 1">
          <a:extLst xmlns:a="http://schemas.openxmlformats.org/drawingml/2006/main">
            <a:ext uri="{FF2B5EF4-FFF2-40B4-BE49-F238E27FC236}">
              <a16:creationId xmlns:a16="http://schemas.microsoft.com/office/drawing/2014/main" id="{7D62CF96-A96D-4AEE-98C6-F7DA1F74053F}"/>
            </a:ext>
          </a:extLst>
        </cdr:cNvPr>
        <cdr:cNvSpPr txBox="1"/>
      </cdr:nvSpPr>
      <cdr:spPr>
        <a:xfrm xmlns:a="http://schemas.openxmlformats.org/drawingml/2006/main">
          <a:off x="2691276" y="4924126"/>
          <a:ext cx="1419225" cy="314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200" b="1" dirty="0"/>
            <a:t>* = </a:t>
          </a:r>
          <a:r>
            <a:rPr lang="it-IT" sz="1200" b="1" i="1" dirty="0"/>
            <a:t>p</a:t>
          </a:r>
          <a:r>
            <a:rPr lang="it-IT" sz="1200" b="1" dirty="0"/>
            <a:t> &lt; 0.05</a:t>
          </a:r>
        </a:p>
      </cdr:txBody>
    </cdr:sp>
  </cdr:relSizeAnchor>
  <cdr:relSizeAnchor xmlns:cdr="http://schemas.openxmlformats.org/drawingml/2006/chartDrawing">
    <cdr:from>
      <cdr:x>0.35503</cdr:x>
      <cdr:y>0.42034</cdr:y>
    </cdr:from>
    <cdr:to>
      <cdr:x>0.3665</cdr:x>
      <cdr:y>0.44176</cdr:y>
    </cdr:to>
    <cdr:sp macro="" textlink="">
      <cdr:nvSpPr>
        <cdr:cNvPr id="52" name="CasellaDiTesto 1">
          <a:extLst xmlns:a="http://schemas.openxmlformats.org/drawingml/2006/main">
            <a:ext uri="{FF2B5EF4-FFF2-40B4-BE49-F238E27FC236}">
              <a16:creationId xmlns:a16="http://schemas.microsoft.com/office/drawing/2014/main" id="{A43BAECA-F7DD-40F3-8376-186229901FDA}"/>
            </a:ext>
          </a:extLst>
        </cdr:cNvPr>
        <cdr:cNvSpPr txBox="1"/>
      </cdr:nvSpPr>
      <cdr:spPr>
        <a:xfrm xmlns:a="http://schemas.openxmlformats.org/drawingml/2006/main">
          <a:off x="4105482" y="2342084"/>
          <a:ext cx="132574" cy="119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0546</cdr:x>
      <cdr:y>0.35612</cdr:y>
    </cdr:from>
    <cdr:to>
      <cdr:x>0.91692</cdr:x>
      <cdr:y>0.37753</cdr:y>
    </cdr:to>
    <cdr:sp macro="" textlink="">
      <cdr:nvSpPr>
        <cdr:cNvPr id="53" name="CasellaDiTesto 1">
          <a:extLst xmlns:a="http://schemas.openxmlformats.org/drawingml/2006/main">
            <a:ext uri="{FF2B5EF4-FFF2-40B4-BE49-F238E27FC236}">
              <a16:creationId xmlns:a16="http://schemas.microsoft.com/office/drawing/2014/main" id="{A43BAECA-F7DD-40F3-8376-186229901FDA}"/>
            </a:ext>
          </a:extLst>
        </cdr:cNvPr>
        <cdr:cNvSpPr txBox="1"/>
      </cdr:nvSpPr>
      <cdr:spPr>
        <a:xfrm xmlns:a="http://schemas.openxmlformats.org/drawingml/2006/main">
          <a:off x="10470397" y="1984257"/>
          <a:ext cx="132574" cy="119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07138</cdr:x>
      <cdr:y>0.31469</cdr:y>
    </cdr:from>
    <cdr:to>
      <cdr:x>0.0835</cdr:x>
      <cdr:y>0.33418</cdr:y>
    </cdr:to>
    <cdr:sp macro="" textlink="">
      <cdr:nvSpPr>
        <cdr:cNvPr id="2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780221" y="19257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07835</cdr:x>
      <cdr:y>0.31936</cdr:y>
    </cdr:from>
    <cdr:to>
      <cdr:x>0.09047</cdr:x>
      <cdr:y>0.33885</cdr:y>
    </cdr:to>
    <cdr:sp macro="" textlink="">
      <cdr:nvSpPr>
        <cdr:cNvPr id="3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856421" y="19542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0275</cdr:x>
      <cdr:y>0.31936</cdr:y>
    </cdr:from>
    <cdr:to>
      <cdr:x>0.11487</cdr:x>
      <cdr:y>0.33885</cdr:y>
    </cdr:to>
    <cdr:sp macro="" textlink="">
      <cdr:nvSpPr>
        <cdr:cNvPr id="4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1123121" y="19542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1059</cdr:x>
      <cdr:y>0.32714</cdr:y>
    </cdr:from>
    <cdr:to>
      <cdr:x>0.12272</cdr:x>
      <cdr:y>0.34663</cdr:y>
    </cdr:to>
    <cdr:sp macro="" textlink="">
      <cdr:nvSpPr>
        <cdr:cNvPr id="5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1208846" y="20019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6636</cdr:x>
      <cdr:y>0.31624</cdr:y>
    </cdr:from>
    <cdr:to>
      <cdr:x>0.17849</cdr:x>
      <cdr:y>0.33573</cdr:y>
    </cdr:to>
    <cdr:sp macro="" textlink="">
      <cdr:nvSpPr>
        <cdr:cNvPr id="6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1818446" y="19352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17421</cdr:x>
      <cdr:y>0.32091</cdr:y>
    </cdr:from>
    <cdr:to>
      <cdr:x>0.18633</cdr:x>
      <cdr:y>0.3404</cdr:y>
    </cdr:to>
    <cdr:sp macro="" textlink="">
      <cdr:nvSpPr>
        <cdr:cNvPr id="7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1904171" y="19638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2973</cdr:x>
      <cdr:y>0.38317</cdr:y>
    </cdr:from>
    <cdr:to>
      <cdr:x>0.24186</cdr:x>
      <cdr:y>0.40266</cdr:y>
    </cdr:to>
    <cdr:sp macro="" textlink="">
      <cdr:nvSpPr>
        <cdr:cNvPr id="8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2511058" y="2344788"/>
          <a:ext cx="132588" cy="11926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3782</cdr:x>
      <cdr:y>0.38473</cdr:y>
    </cdr:from>
    <cdr:to>
      <cdr:x>0.24994</cdr:x>
      <cdr:y>0.40422</cdr:y>
    </cdr:to>
    <cdr:sp macro="" textlink="">
      <cdr:nvSpPr>
        <cdr:cNvPr id="9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2599496" y="23543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6135</cdr:x>
      <cdr:y>0.33025</cdr:y>
    </cdr:from>
    <cdr:to>
      <cdr:x>0.27347</cdr:x>
      <cdr:y>0.34974</cdr:y>
    </cdr:to>
    <cdr:sp macro="" textlink="">
      <cdr:nvSpPr>
        <cdr:cNvPr id="10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2856671" y="20209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9359</cdr:x>
      <cdr:y>0.33337</cdr:y>
    </cdr:from>
    <cdr:to>
      <cdr:x>0.30571</cdr:x>
      <cdr:y>0.35286</cdr:y>
    </cdr:to>
    <cdr:sp macro="" textlink="">
      <cdr:nvSpPr>
        <cdr:cNvPr id="11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3209096" y="20400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0056</cdr:x>
      <cdr:y>0.33337</cdr:y>
    </cdr:from>
    <cdr:to>
      <cdr:x>0.31268</cdr:x>
      <cdr:y>0.35286</cdr:y>
    </cdr:to>
    <cdr:sp macro="" textlink="">
      <cdr:nvSpPr>
        <cdr:cNvPr id="12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3285296" y="20400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6504</cdr:x>
      <cdr:y>0.38317</cdr:y>
    </cdr:from>
    <cdr:to>
      <cdr:x>0.37717</cdr:x>
      <cdr:y>0.40266</cdr:y>
    </cdr:to>
    <cdr:sp macro="" textlink="">
      <cdr:nvSpPr>
        <cdr:cNvPr id="13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3990146" y="23448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38954</cdr:x>
      <cdr:y>0.5</cdr:y>
    </cdr:from>
    <cdr:to>
      <cdr:x>0.40167</cdr:x>
      <cdr:y>0.51949</cdr:y>
    </cdr:to>
    <cdr:sp macro="" textlink="">
      <cdr:nvSpPr>
        <cdr:cNvPr id="14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4257934" y="3059723"/>
          <a:ext cx="132588" cy="11926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it-IT" sz="1100" dirty="0"/>
        </a:p>
      </cdr:txBody>
    </cdr:sp>
  </cdr:relSizeAnchor>
  <cdr:relSizeAnchor xmlns:cdr="http://schemas.openxmlformats.org/drawingml/2006/chartDrawing">
    <cdr:from>
      <cdr:x>0.42081</cdr:x>
      <cdr:y>0.16371</cdr:y>
    </cdr:from>
    <cdr:to>
      <cdr:x>0.43294</cdr:x>
      <cdr:y>0.1832</cdr:y>
    </cdr:to>
    <cdr:sp macro="" textlink="">
      <cdr:nvSpPr>
        <cdr:cNvPr id="15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4599746" y="10017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2779</cdr:x>
      <cdr:y>0.15437</cdr:y>
    </cdr:from>
    <cdr:to>
      <cdr:x>0.43991</cdr:x>
      <cdr:y>0.17386</cdr:y>
    </cdr:to>
    <cdr:sp macro="" textlink="">
      <cdr:nvSpPr>
        <cdr:cNvPr id="16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4675946" y="9446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5306</cdr:x>
      <cdr:y>0.17149</cdr:y>
    </cdr:from>
    <cdr:to>
      <cdr:x>0.46518</cdr:x>
      <cdr:y>0.19098</cdr:y>
    </cdr:to>
    <cdr:sp macro="" textlink="">
      <cdr:nvSpPr>
        <cdr:cNvPr id="17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4952171" y="10494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46003</cdr:x>
      <cdr:y>0.16371</cdr:y>
    </cdr:from>
    <cdr:to>
      <cdr:x>0.47215</cdr:x>
      <cdr:y>0.1832</cdr:y>
    </cdr:to>
    <cdr:sp macro="" textlink="">
      <cdr:nvSpPr>
        <cdr:cNvPr id="18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5028371" y="100178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5588</cdr:x>
      <cdr:y>0.38006</cdr:y>
    </cdr:from>
    <cdr:to>
      <cdr:x>0.56801</cdr:x>
      <cdr:y>0.39955</cdr:y>
    </cdr:to>
    <cdr:sp macro="" textlink="">
      <cdr:nvSpPr>
        <cdr:cNvPr id="19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6076121" y="23257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2451</cdr:x>
      <cdr:y>0.39563</cdr:y>
    </cdr:from>
    <cdr:to>
      <cdr:x>0.53664</cdr:x>
      <cdr:y>0.41512</cdr:y>
    </cdr:to>
    <cdr:sp macro="" textlink="">
      <cdr:nvSpPr>
        <cdr:cNvPr id="20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5733221" y="24210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7941</cdr:x>
      <cdr:y>0.38317</cdr:y>
    </cdr:from>
    <cdr:to>
      <cdr:x>0.59153</cdr:x>
      <cdr:y>0.40266</cdr:y>
    </cdr:to>
    <cdr:sp macro="" textlink="">
      <cdr:nvSpPr>
        <cdr:cNvPr id="21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6333296" y="23448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58725</cdr:x>
      <cdr:y>0.39251</cdr:y>
    </cdr:from>
    <cdr:to>
      <cdr:x>0.59938</cdr:x>
      <cdr:y>0.412</cdr:y>
    </cdr:to>
    <cdr:sp macro="" textlink="">
      <cdr:nvSpPr>
        <cdr:cNvPr id="22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6419021" y="24019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1862</cdr:x>
      <cdr:y>0.39096</cdr:y>
    </cdr:from>
    <cdr:to>
      <cdr:x>0.63075</cdr:x>
      <cdr:y>0.41045</cdr:y>
    </cdr:to>
    <cdr:sp macro="" textlink="">
      <cdr:nvSpPr>
        <cdr:cNvPr id="23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6761921" y="23924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4302</cdr:x>
      <cdr:y>0.31624</cdr:y>
    </cdr:from>
    <cdr:to>
      <cdr:x>0.65515</cdr:x>
      <cdr:y>0.33573</cdr:y>
    </cdr:to>
    <cdr:sp macro="" textlink="">
      <cdr:nvSpPr>
        <cdr:cNvPr id="24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7028621" y="19352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4999</cdr:x>
      <cdr:y>0.31624</cdr:y>
    </cdr:from>
    <cdr:to>
      <cdr:x>0.66212</cdr:x>
      <cdr:y>0.33573</cdr:y>
    </cdr:to>
    <cdr:sp macro="" textlink="">
      <cdr:nvSpPr>
        <cdr:cNvPr id="25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7104821" y="19352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7526</cdr:x>
      <cdr:y>0.33492</cdr:y>
    </cdr:from>
    <cdr:to>
      <cdr:x>0.68739</cdr:x>
      <cdr:y>0.35441</cdr:y>
    </cdr:to>
    <cdr:sp macro="" textlink="">
      <cdr:nvSpPr>
        <cdr:cNvPr id="26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7381046" y="20495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68311</cdr:x>
      <cdr:y>0.33492</cdr:y>
    </cdr:from>
    <cdr:to>
      <cdr:x>0.69523</cdr:x>
      <cdr:y>0.35441</cdr:y>
    </cdr:to>
    <cdr:sp macro="" textlink="">
      <cdr:nvSpPr>
        <cdr:cNvPr id="27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7466771" y="20495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0751</cdr:x>
      <cdr:y>0.33492</cdr:y>
    </cdr:from>
    <cdr:to>
      <cdr:x>0.71963</cdr:x>
      <cdr:y>0.35441</cdr:y>
    </cdr:to>
    <cdr:sp macro="" textlink="">
      <cdr:nvSpPr>
        <cdr:cNvPr id="28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7733471" y="20495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1622</cdr:x>
      <cdr:y>0.33492</cdr:y>
    </cdr:from>
    <cdr:to>
      <cdr:x>0.72834</cdr:x>
      <cdr:y>0.35441</cdr:y>
    </cdr:to>
    <cdr:sp macro="" textlink="">
      <cdr:nvSpPr>
        <cdr:cNvPr id="29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7828721" y="20495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3888</cdr:x>
      <cdr:y>0.33492</cdr:y>
    </cdr:from>
    <cdr:to>
      <cdr:x>0.751</cdr:x>
      <cdr:y>0.35441</cdr:y>
    </cdr:to>
    <cdr:sp macro="" textlink="">
      <cdr:nvSpPr>
        <cdr:cNvPr id="30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8076371" y="20495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4585</cdr:x>
      <cdr:y>0.6291</cdr:y>
    </cdr:from>
    <cdr:to>
      <cdr:x>0.75797</cdr:x>
      <cdr:y>0.64859</cdr:y>
    </cdr:to>
    <cdr:sp macro="" textlink="">
      <cdr:nvSpPr>
        <cdr:cNvPr id="31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8152571" y="38497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7112</cdr:x>
      <cdr:y>0.3287</cdr:y>
    </cdr:from>
    <cdr:to>
      <cdr:x>0.78324</cdr:x>
      <cdr:y>0.34819</cdr:y>
    </cdr:to>
    <cdr:sp macro="" textlink="">
      <cdr:nvSpPr>
        <cdr:cNvPr id="32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8428796" y="20114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77809</cdr:x>
      <cdr:y>0.33492</cdr:y>
    </cdr:from>
    <cdr:to>
      <cdr:x>0.79021</cdr:x>
      <cdr:y>0.35441</cdr:y>
    </cdr:to>
    <cdr:sp macro="" textlink="">
      <cdr:nvSpPr>
        <cdr:cNvPr id="33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8504996" y="20495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80336</cdr:x>
      <cdr:y>0.38629</cdr:y>
    </cdr:from>
    <cdr:to>
      <cdr:x>0.81549</cdr:x>
      <cdr:y>0.40578</cdr:y>
    </cdr:to>
    <cdr:sp macro="" textlink="">
      <cdr:nvSpPr>
        <cdr:cNvPr id="34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8781221" y="23638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86697</cdr:x>
      <cdr:y>0.38629</cdr:y>
    </cdr:from>
    <cdr:to>
      <cdr:x>0.8791</cdr:x>
      <cdr:y>0.40578</cdr:y>
    </cdr:to>
    <cdr:sp macro="" textlink="">
      <cdr:nvSpPr>
        <cdr:cNvPr id="35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9476546" y="23638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89834</cdr:x>
      <cdr:y>0.41119</cdr:y>
    </cdr:from>
    <cdr:to>
      <cdr:x>0.91047</cdr:x>
      <cdr:y>0.43068</cdr:y>
    </cdr:to>
    <cdr:sp macro="" textlink="">
      <cdr:nvSpPr>
        <cdr:cNvPr id="36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9819446" y="25162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0619</cdr:x>
      <cdr:y>0.39563</cdr:y>
    </cdr:from>
    <cdr:to>
      <cdr:x>0.91831</cdr:x>
      <cdr:y>0.41512</cdr:y>
    </cdr:to>
    <cdr:sp macro="" textlink="">
      <cdr:nvSpPr>
        <cdr:cNvPr id="37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9905171" y="24210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3059</cdr:x>
      <cdr:y>0.39874</cdr:y>
    </cdr:from>
    <cdr:to>
      <cdr:x>0.94271</cdr:x>
      <cdr:y>0.41823</cdr:y>
    </cdr:to>
    <cdr:sp macro="" textlink="">
      <cdr:nvSpPr>
        <cdr:cNvPr id="38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10171871" y="244006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3843</cdr:x>
      <cdr:y>0.3894</cdr:y>
    </cdr:from>
    <cdr:to>
      <cdr:x>0.95055</cdr:x>
      <cdr:y>0.40889</cdr:y>
    </cdr:to>
    <cdr:sp macro="" textlink="">
      <cdr:nvSpPr>
        <cdr:cNvPr id="39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10257596" y="2382911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6196</cdr:x>
      <cdr:y>0.38473</cdr:y>
    </cdr:from>
    <cdr:to>
      <cdr:x>0.97408</cdr:x>
      <cdr:y>0.40422</cdr:y>
    </cdr:to>
    <cdr:sp macro="" textlink="">
      <cdr:nvSpPr>
        <cdr:cNvPr id="40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10514771" y="23543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9698</cdr:x>
      <cdr:y>0.38473</cdr:y>
    </cdr:from>
    <cdr:to>
      <cdr:x>0.98192</cdr:x>
      <cdr:y>0.40422</cdr:y>
    </cdr:to>
    <cdr:sp macro="" textlink="">
      <cdr:nvSpPr>
        <cdr:cNvPr id="41" name="CasellaDiTesto 1">
          <a:extLst xmlns:a="http://schemas.openxmlformats.org/drawingml/2006/main">
            <a:ext uri="{FF2B5EF4-FFF2-40B4-BE49-F238E27FC236}">
              <a16:creationId xmlns:a16="http://schemas.microsoft.com/office/drawing/2014/main" id="{CFFB9DAC-A2D7-4CB8-8AF2-9839A5C798AE}"/>
            </a:ext>
          </a:extLst>
        </cdr:cNvPr>
        <cdr:cNvSpPr txBox="1"/>
      </cdr:nvSpPr>
      <cdr:spPr>
        <a:xfrm xmlns:a="http://schemas.openxmlformats.org/drawingml/2006/main">
          <a:off x="10600496" y="2354336"/>
          <a:ext cx="132522" cy="119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  <cdr:relSizeAnchor xmlns:cdr="http://schemas.openxmlformats.org/drawingml/2006/chartDrawing">
    <cdr:from>
      <cdr:x>0.23244</cdr:x>
      <cdr:y>0.94864</cdr:y>
    </cdr:from>
    <cdr:to>
      <cdr:x>0.36228</cdr:x>
      <cdr:y>1</cdr:y>
    </cdr:to>
    <cdr:sp macro="" textlink="">
      <cdr:nvSpPr>
        <cdr:cNvPr id="42" name="CasellaDiTesto 41">
          <a:extLst xmlns:a="http://schemas.openxmlformats.org/drawingml/2006/main">
            <a:ext uri="{FF2B5EF4-FFF2-40B4-BE49-F238E27FC236}">
              <a16:creationId xmlns:a16="http://schemas.microsoft.com/office/drawing/2014/main" id="{D93EA94B-8328-4160-8214-D460B4D38984}"/>
            </a:ext>
          </a:extLst>
        </cdr:cNvPr>
        <cdr:cNvSpPr txBox="1"/>
      </cdr:nvSpPr>
      <cdr:spPr>
        <a:xfrm xmlns:a="http://schemas.openxmlformats.org/drawingml/2006/main">
          <a:off x="2540725" y="5805151"/>
          <a:ext cx="1419228" cy="3142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it-IT" sz="1200" b="1" dirty="0"/>
            <a:t>* = </a:t>
          </a:r>
          <a:r>
            <a:rPr lang="it-IT" sz="1200" b="1" i="1" dirty="0"/>
            <a:t>p</a:t>
          </a:r>
          <a:r>
            <a:rPr lang="it-IT" sz="1200" b="1" dirty="0"/>
            <a:t> &lt; 0.05</a:t>
          </a:r>
        </a:p>
      </cdr:txBody>
    </cdr:sp>
  </cdr:relSizeAnchor>
  <cdr:relSizeAnchor xmlns:cdr="http://schemas.openxmlformats.org/drawingml/2006/chartDrawing">
    <cdr:from>
      <cdr:x>0.13497</cdr:x>
      <cdr:y>0.38678</cdr:y>
    </cdr:from>
    <cdr:to>
      <cdr:x>0.14709</cdr:x>
      <cdr:y>0.40628</cdr:y>
    </cdr:to>
    <cdr:sp macro="" textlink="">
      <cdr:nvSpPr>
        <cdr:cNvPr id="43" name="CasellaDiTesto 1">
          <a:extLst xmlns:a="http://schemas.openxmlformats.org/drawingml/2006/main">
            <a:ext uri="{FF2B5EF4-FFF2-40B4-BE49-F238E27FC236}">
              <a16:creationId xmlns:a16="http://schemas.microsoft.com/office/drawing/2014/main" id="{A43BAECA-F7DD-40F3-8376-186229901FDA}"/>
            </a:ext>
          </a:extLst>
        </cdr:cNvPr>
        <cdr:cNvSpPr txBox="1"/>
      </cdr:nvSpPr>
      <cdr:spPr>
        <a:xfrm xmlns:a="http://schemas.openxmlformats.org/drawingml/2006/main">
          <a:off x="1475253" y="2366893"/>
          <a:ext cx="132574" cy="119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100" dirty="0"/>
            <a:t>*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647A633-98AC-4B2A-B489-425F4328226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C14453F2-E008-4C09-8CD1-E961D6A8AA9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6258904-531F-4B5C-A63F-6360E482BC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7D707-A589-4CE0-881D-469B91D67D07}" type="datetimeFigureOut">
              <a:rPr lang="it-IT" smtClean="0"/>
              <a:t>25/04/2022</a:t>
            </a:fld>
            <a:endParaRPr lang="it-IT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83689EE-E5B8-4131-8404-B73500DB52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9C80091-A543-49DB-89C9-A9F6AC3EC1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DC8EE-B675-4A18-A553-47BBBB30A9C4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852690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44DF23F-29D2-4D8C-AA63-6C76DFBF92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B3C38D3-6246-4781-A0EC-F9CFEA9BC6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B69AF54-F1F7-449A-B94A-4E122C2658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7D707-A589-4CE0-881D-469B91D67D07}" type="datetimeFigureOut">
              <a:rPr lang="it-IT" smtClean="0"/>
              <a:t>25/04/2022</a:t>
            </a:fld>
            <a:endParaRPr lang="it-IT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B1E30FF-943A-4758-AA44-4822C4169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FC2A331-50D0-497A-BCB3-67F88DE045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DC8EE-B675-4A18-A553-47BBBB30A9C4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4198346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14C48620-0A5B-4876-8364-8138D9B03A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F789692-25EB-46BA-BEF9-1D3051B8096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F505BF4-BE5E-4DE2-9979-C1301C3E7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7D707-A589-4CE0-881D-469B91D67D07}" type="datetimeFigureOut">
              <a:rPr lang="it-IT" smtClean="0"/>
              <a:t>25/04/2022</a:t>
            </a:fld>
            <a:endParaRPr lang="it-IT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8DFE10D-0686-4744-8810-92353E3267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46B55D2-E124-4ED5-947E-957ACD9511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DC8EE-B675-4A18-A553-47BBBB30A9C4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2252553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F1DAC36-2B47-4A3A-B089-35550E0E9B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555CF85-3BE6-484B-8FB7-C55CAEEC480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2F7A020-F196-4CA4-998F-B3DEE0C516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7D707-A589-4CE0-881D-469B91D67D07}" type="datetimeFigureOut">
              <a:rPr lang="it-IT" smtClean="0"/>
              <a:t>25/04/2022</a:t>
            </a:fld>
            <a:endParaRPr lang="it-IT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F22D480-B587-44C3-8488-FEB5435C6F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C3D5330-78BB-4F2E-A343-13142EC3C4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DC8EE-B675-4A18-A553-47BBBB30A9C4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1577190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633080F-EB07-46F0-A76A-D6ACCBC1B3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9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AB58B7E-AA3C-46D1-B512-CCA8E529E5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8AFE444-DD8D-4895-BED9-9748D0C02D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7D707-A589-4CE0-881D-469B91D67D07}" type="datetimeFigureOut">
              <a:rPr lang="it-IT" smtClean="0"/>
              <a:t>25/04/2022</a:t>
            </a:fld>
            <a:endParaRPr lang="it-IT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1C914F5-1FE0-4C7E-95E6-B366F6F25D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3F74ED2-E85F-4E6E-AD3B-AF4F4DB17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DC8EE-B675-4A18-A553-47BBBB30A9C4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439028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8EDCB40-BE35-4DF1-9DDC-EFEBD980D4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6315EE0-45F6-436B-8819-0D5BDE0944C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24325BE-C4C3-480D-B04A-6CA17A618B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EA233C0-6DE1-4CAD-A6D3-6A9C816CD4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7D707-A589-4CE0-881D-469B91D67D07}" type="datetimeFigureOut">
              <a:rPr lang="it-IT" smtClean="0"/>
              <a:t>25/04/2022</a:t>
            </a:fld>
            <a:endParaRPr lang="it-IT" dirty="0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B38951E-9A01-47CD-B391-9409A4E78A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5B7F32E-D420-488F-951B-1A5B2C7F47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DC8EE-B675-4A18-A553-47BBBB30A9C4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9517411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CD04210-7D5A-4A95-83DE-6C94C479FB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6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4209145-DB38-458D-9DD0-6D723C4F18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0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D726C5D9-19A0-4C53-8357-EFFACE75A5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0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CE589581-FE1A-48F1-A20D-ED8DF0B179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EDAB184A-898F-477D-9DB5-63B1CA17E1C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43352C77-BB3A-4C9C-BAA7-C550F64871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7D707-A589-4CE0-881D-469B91D67D07}" type="datetimeFigureOut">
              <a:rPr lang="it-IT" smtClean="0"/>
              <a:t>25/04/2022</a:t>
            </a:fld>
            <a:endParaRPr lang="it-IT" dirty="0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ACECBB90-66A1-4E25-B021-62DE87BE8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DF0B0612-65BC-4715-9B8F-969C24D8B3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DC8EE-B675-4A18-A553-47BBBB30A9C4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570624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1E8D062-7012-41A7-8AF7-29E59D2D80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7C9664A4-1C32-4E76-B0CA-A9CD40CCD4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7D707-A589-4CE0-881D-469B91D67D07}" type="datetimeFigureOut">
              <a:rPr lang="it-IT" smtClean="0"/>
              <a:t>25/04/2022</a:t>
            </a:fld>
            <a:endParaRPr lang="it-IT" dirty="0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85F7F02F-D927-48FF-9EBD-D6BCBB8D54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A39FEAA5-9094-4A7C-BDBA-347E599BDC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DC8EE-B675-4A18-A553-47BBBB30A9C4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976656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F12DF3DF-B036-4CE2-9506-00D8ABFFFD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7D707-A589-4CE0-881D-469B91D67D07}" type="datetimeFigureOut">
              <a:rPr lang="it-IT" smtClean="0"/>
              <a:t>25/04/2022</a:t>
            </a:fld>
            <a:endParaRPr lang="it-IT" dirty="0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048BB164-F337-47BA-8F3E-3C3ADCBB3C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39F9AD0A-3DE1-4D41-89B1-C66585485A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DC8EE-B675-4A18-A553-47BBBB30A9C4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9856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B4DAE10-C65F-4CBA-A0D2-B09D118D95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7F3C71E-DC08-4AD0-B9DD-D169119490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6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096979A-DF1B-494E-88BB-0CD4EFD1C4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28E5039-71B8-4DA2-BE95-75645EC700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7D707-A589-4CE0-881D-469B91D67D07}" type="datetimeFigureOut">
              <a:rPr lang="it-IT" smtClean="0"/>
              <a:t>25/04/2022</a:t>
            </a:fld>
            <a:endParaRPr lang="it-IT" dirty="0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8F1A466-37B9-4F2C-A9C2-AB1652D8CD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FF6A5FF-8294-4645-822D-C1BD9705E6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DC8EE-B675-4A18-A553-47BBBB30A9C4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0196744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3422660-368B-449C-AF4F-A4AFB758BA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907A0AF2-B2E4-467E-9E8D-69AEC720CA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6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 dirty="0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73084100-FB02-4193-8BF3-438B1B82E6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5D2CD74-3398-4909-893E-65B9D7D4EA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7D707-A589-4CE0-881D-469B91D67D07}" type="datetimeFigureOut">
              <a:rPr lang="it-IT" smtClean="0"/>
              <a:t>25/04/2022</a:t>
            </a:fld>
            <a:endParaRPr lang="it-IT" dirty="0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0F766FE-E8D5-48BC-A79F-8FE64FD0CA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7BC348D-D912-4964-B9AB-D0CA6E5DE5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DC8EE-B675-4A18-A553-47BBBB30A9C4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947258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3D2CAAEB-EF0E-4CD6-804A-ABF601DD32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5BDD05A-3BC6-4F1A-A875-DD7B117EA1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FC573D7-8765-4976-ACDF-BCF599CB49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77D707-A589-4CE0-881D-469B91D67D07}" type="datetimeFigureOut">
              <a:rPr lang="it-IT" smtClean="0"/>
              <a:t>25/04/2022</a:t>
            </a:fld>
            <a:endParaRPr lang="it-IT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5431EE1-762E-4559-ACDC-1FC5460FC5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5C8F943-67DC-4B1E-BC50-B97DE13497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CDC8EE-B675-4A18-A553-47BBBB30A9C4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926102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ico 3">
            <a:extLst>
              <a:ext uri="{FF2B5EF4-FFF2-40B4-BE49-F238E27FC236}">
                <a16:creationId xmlns:a16="http://schemas.microsoft.com/office/drawing/2014/main" id="{CD812F75-B034-4FB9-B9D5-1CD35687C3B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13671842"/>
              </p:ext>
            </p:extLst>
          </p:nvPr>
        </p:nvGraphicFramePr>
        <p:xfrm>
          <a:off x="468923" y="305972"/>
          <a:ext cx="11254153" cy="62460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CasellaDiTesto 1">
            <a:extLst>
              <a:ext uri="{FF2B5EF4-FFF2-40B4-BE49-F238E27FC236}">
                <a16:creationId xmlns:a16="http://schemas.microsoft.com/office/drawing/2014/main" id="{7EA37C81-96B5-4673-A29A-ABA1F5F33A10}"/>
              </a:ext>
            </a:extLst>
          </p:cNvPr>
          <p:cNvSpPr txBox="1"/>
          <p:nvPr/>
        </p:nvSpPr>
        <p:spPr>
          <a:xfrm>
            <a:off x="10982007" y="3176228"/>
            <a:ext cx="132522" cy="119270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endParaRPr lang="it-IT" dirty="0"/>
          </a:p>
        </p:txBody>
      </p:sp>
      <p:sp>
        <p:nvSpPr>
          <p:cNvPr id="7" name="CasellaDiTesto 1">
            <a:extLst>
              <a:ext uri="{FF2B5EF4-FFF2-40B4-BE49-F238E27FC236}">
                <a16:creationId xmlns:a16="http://schemas.microsoft.com/office/drawing/2014/main" id="{7D62CF96-A96D-4AEE-98C6-F7DA1F74053F}"/>
              </a:ext>
            </a:extLst>
          </p:cNvPr>
          <p:cNvSpPr txBox="1"/>
          <p:nvPr/>
        </p:nvSpPr>
        <p:spPr>
          <a:xfrm>
            <a:off x="2717375" y="6394864"/>
            <a:ext cx="1419225" cy="314325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it-IT" sz="1200" b="1" dirty="0"/>
              <a:t>* = </a:t>
            </a:r>
            <a:r>
              <a:rPr lang="it-IT" sz="1200" b="1" i="1" dirty="0"/>
              <a:t>p</a:t>
            </a:r>
            <a:r>
              <a:rPr lang="it-IT" sz="1200" b="1" dirty="0"/>
              <a:t> &lt; 0.05</a:t>
            </a:r>
          </a:p>
        </p:txBody>
      </p:sp>
    </p:spTree>
    <p:extLst>
      <p:ext uri="{BB962C8B-B14F-4D97-AF65-F5344CB8AC3E}">
        <p14:creationId xmlns:p14="http://schemas.microsoft.com/office/powerpoint/2010/main" val="40915117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17766FC5-EBCA-437D-8F84-8FE373CB3CC0}"/>
              </a:ext>
            </a:extLst>
          </p:cNvPr>
          <p:cNvGrpSpPr/>
          <p:nvPr/>
        </p:nvGrpSpPr>
        <p:grpSpPr>
          <a:xfrm>
            <a:off x="1308296" y="309490"/>
            <a:ext cx="9931791" cy="6288259"/>
            <a:chOff x="1308295" y="309489"/>
            <a:chExt cx="9931791" cy="6288259"/>
          </a:xfrm>
        </p:grpSpPr>
        <p:graphicFrame>
          <p:nvGraphicFramePr>
            <p:cNvPr id="4" name="Grafico 3">
              <a:extLst>
                <a:ext uri="{FF2B5EF4-FFF2-40B4-BE49-F238E27FC236}">
                  <a16:creationId xmlns:a16="http://schemas.microsoft.com/office/drawing/2014/main" id="{84671292-D755-4D8A-8D8E-641D12EB5FC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99627395"/>
                </p:ext>
              </p:extLst>
            </p:nvPr>
          </p:nvGraphicFramePr>
          <p:xfrm>
            <a:off x="1308295" y="309489"/>
            <a:ext cx="9931791" cy="628825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" name="CasellaDiTesto 1">
              <a:extLst>
                <a:ext uri="{FF2B5EF4-FFF2-40B4-BE49-F238E27FC236}">
                  <a16:creationId xmlns:a16="http://schemas.microsoft.com/office/drawing/2014/main" id="{7EA37C81-96B5-4673-A29A-ABA1F5F33A10}"/>
                </a:ext>
              </a:extLst>
            </p:cNvPr>
            <p:cNvSpPr txBox="1"/>
            <p:nvPr/>
          </p:nvSpPr>
          <p:spPr>
            <a:xfrm>
              <a:off x="2067339" y="1645340"/>
              <a:ext cx="132522" cy="11927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dirty="0"/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061905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ico 3">
            <a:extLst>
              <a:ext uri="{FF2B5EF4-FFF2-40B4-BE49-F238E27FC236}">
                <a16:creationId xmlns:a16="http://schemas.microsoft.com/office/drawing/2014/main" id="{3FFC620B-AE7F-4527-9848-95109DC4F29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71465731"/>
              </p:ext>
            </p:extLst>
          </p:nvPr>
        </p:nvGraphicFramePr>
        <p:xfrm>
          <a:off x="921027" y="821635"/>
          <a:ext cx="10349947" cy="57116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0328138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ico 3">
            <a:extLst>
              <a:ext uri="{FF2B5EF4-FFF2-40B4-BE49-F238E27FC236}">
                <a16:creationId xmlns:a16="http://schemas.microsoft.com/office/drawing/2014/main" id="{BB7BF936-737B-45B3-884C-A5626D3C86A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8614560"/>
              </p:ext>
            </p:extLst>
          </p:nvPr>
        </p:nvGraphicFramePr>
        <p:xfrm>
          <a:off x="1221545" y="822962"/>
          <a:ext cx="9748911" cy="60350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8590005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Segnaposto contenuto 3">
            <a:extLst>
              <a:ext uri="{FF2B5EF4-FFF2-40B4-BE49-F238E27FC236}">
                <a16:creationId xmlns:a16="http://schemas.microsoft.com/office/drawing/2014/main" id="{47A412E7-3016-446A-B0C1-C74748450516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13966234"/>
              </p:ext>
            </p:extLst>
          </p:nvPr>
        </p:nvGraphicFramePr>
        <p:xfrm>
          <a:off x="140679" y="425553"/>
          <a:ext cx="11563642" cy="55718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CasellaDiTesto 1">
            <a:extLst>
              <a:ext uri="{FF2B5EF4-FFF2-40B4-BE49-F238E27FC236}">
                <a16:creationId xmlns:a16="http://schemas.microsoft.com/office/drawing/2014/main" id="{477B7EDD-AA2E-43A2-B34F-8757EC30CEFF}"/>
              </a:ext>
            </a:extLst>
          </p:cNvPr>
          <p:cNvSpPr txBox="1"/>
          <p:nvPr/>
        </p:nvSpPr>
        <p:spPr>
          <a:xfrm>
            <a:off x="924339" y="2359715"/>
            <a:ext cx="132522" cy="119270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it-IT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7482591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ico 3">
            <a:extLst>
              <a:ext uri="{FF2B5EF4-FFF2-40B4-BE49-F238E27FC236}">
                <a16:creationId xmlns:a16="http://schemas.microsoft.com/office/drawing/2014/main" id="{5B426D1C-C526-49CE-880A-886374C26D3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81341170"/>
              </p:ext>
            </p:extLst>
          </p:nvPr>
        </p:nvGraphicFramePr>
        <p:xfrm>
          <a:off x="436099" y="369277"/>
          <a:ext cx="10930596" cy="61194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18260163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83</TotalTime>
  <Words>344</Words>
  <Application>Microsoft Office PowerPoint</Application>
  <PresentationFormat>Widescreen</PresentationFormat>
  <Paragraphs>276</Paragraphs>
  <Slides>6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ilvia Gianoglio</dc:creator>
  <cp:lastModifiedBy>Silvia Gianoglio</cp:lastModifiedBy>
  <cp:revision>52</cp:revision>
  <dcterms:created xsi:type="dcterms:W3CDTF">2019-07-26T10:48:35Z</dcterms:created>
  <dcterms:modified xsi:type="dcterms:W3CDTF">2022-04-24T23:11:54Z</dcterms:modified>
</cp:coreProperties>
</file>